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2" autoAdjust="0"/>
    <p:restoredTop sz="94660"/>
  </p:normalViewPr>
  <p:slideViewPr>
    <p:cSldViewPr snapToGrid="0" showGuides="1">
      <p:cViewPr varScale="1">
        <p:scale>
          <a:sx n="68" d="100"/>
          <a:sy n="68" d="100"/>
        </p:scale>
        <p:origin x="388" y="4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60040-4301-45D1-AD18-65CB7B62A47B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26E8F-465C-4F7F-86CD-F4A6AD79F10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65176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60040-4301-45D1-AD18-65CB7B62A47B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26E8F-465C-4F7F-86CD-F4A6AD79F10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0568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60040-4301-45D1-AD18-65CB7B62A47B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26E8F-465C-4F7F-86CD-F4A6AD79F10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49998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60040-4301-45D1-AD18-65CB7B62A47B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26E8F-465C-4F7F-86CD-F4A6AD79F10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72786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60040-4301-45D1-AD18-65CB7B62A47B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26E8F-465C-4F7F-86CD-F4A6AD79F10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2019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60040-4301-45D1-AD18-65CB7B62A47B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26E8F-465C-4F7F-86CD-F4A6AD79F10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14536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60040-4301-45D1-AD18-65CB7B62A47B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26E8F-465C-4F7F-86CD-F4A6AD79F10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1511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60040-4301-45D1-AD18-65CB7B62A47B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26E8F-465C-4F7F-86CD-F4A6AD79F10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09091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60040-4301-45D1-AD18-65CB7B62A47B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26E8F-465C-4F7F-86CD-F4A6AD79F10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74089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60040-4301-45D1-AD18-65CB7B62A47B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26E8F-465C-4F7F-86CD-F4A6AD79F10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5627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60040-4301-45D1-AD18-65CB7B62A47B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26E8F-465C-4F7F-86CD-F4A6AD79F10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74966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960040-4301-45D1-AD18-65CB7B62A47B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226E8F-465C-4F7F-86CD-F4A6AD79F10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89416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4"/>
          <p:cNvSpPr>
            <a:spLocks noChangeArrowheads="1"/>
          </p:cNvSpPr>
          <p:nvPr/>
        </p:nvSpPr>
        <p:spPr bwMode="auto">
          <a:xfrm>
            <a:off x="3524251" y="32951"/>
            <a:ext cx="138564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68580" tIns="34290" rIns="68580" bIns="3429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350"/>
          </a:p>
        </p:txBody>
      </p:sp>
      <p:sp>
        <p:nvSpPr>
          <p:cNvPr id="4" name="Rectangle 5"/>
          <p:cNvSpPr>
            <a:spLocks noChangeArrowheads="1"/>
          </p:cNvSpPr>
          <p:nvPr/>
        </p:nvSpPr>
        <p:spPr bwMode="auto">
          <a:xfrm>
            <a:off x="3524251" y="204401"/>
            <a:ext cx="138564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68580" tIns="34290" rIns="68580" bIns="3429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350"/>
          </a:p>
        </p:txBody>
      </p:sp>
      <p:sp>
        <p:nvSpPr>
          <p:cNvPr id="9" name="Rectángulo 8"/>
          <p:cNvSpPr/>
          <p:nvPr/>
        </p:nvSpPr>
        <p:spPr>
          <a:xfrm>
            <a:off x="4155485" y="1471224"/>
            <a:ext cx="695325" cy="1471613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12" name="Rectángulo 11"/>
          <p:cNvSpPr/>
          <p:nvPr/>
        </p:nvSpPr>
        <p:spPr>
          <a:xfrm>
            <a:off x="4850810" y="1471224"/>
            <a:ext cx="695325" cy="1471613"/>
          </a:xfrm>
          <a:prstGeom prst="rect">
            <a:avLst/>
          </a:prstGeom>
          <a:solidFill>
            <a:srgbClr val="FFCCCC"/>
          </a:solidFill>
          <a:ln>
            <a:solidFill>
              <a:srgbClr val="FF99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13" name="Rectángulo 12"/>
          <p:cNvSpPr/>
          <p:nvPr/>
        </p:nvSpPr>
        <p:spPr>
          <a:xfrm>
            <a:off x="5552484" y="1471224"/>
            <a:ext cx="695325" cy="1471613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chemeClr val="accent4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cxnSp>
        <p:nvCxnSpPr>
          <p:cNvPr id="16" name="Conector recto 15"/>
          <p:cNvCxnSpPr/>
          <p:nvPr/>
        </p:nvCxnSpPr>
        <p:spPr>
          <a:xfrm flipV="1">
            <a:off x="4410703" y="1779643"/>
            <a:ext cx="228600" cy="908241"/>
          </a:xfrm>
          <a:prstGeom prst="line">
            <a:avLst/>
          </a:prstGeom>
          <a:ln w="28575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ector recto 18"/>
          <p:cNvCxnSpPr/>
          <p:nvPr/>
        </p:nvCxnSpPr>
        <p:spPr>
          <a:xfrm>
            <a:off x="4636734" y="1789720"/>
            <a:ext cx="256938" cy="2021"/>
          </a:xfrm>
          <a:prstGeom prst="line">
            <a:avLst/>
          </a:prstGeom>
          <a:ln w="28575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Conector recto 19"/>
          <p:cNvCxnSpPr/>
          <p:nvPr/>
        </p:nvCxnSpPr>
        <p:spPr>
          <a:xfrm flipH="1" flipV="1">
            <a:off x="4884912" y="1784956"/>
            <a:ext cx="158779" cy="413978"/>
          </a:xfrm>
          <a:prstGeom prst="line">
            <a:avLst/>
          </a:prstGeom>
          <a:ln w="28575">
            <a:solidFill>
              <a:srgbClr val="CC006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Conector recto de flecha 17"/>
          <p:cNvCxnSpPr/>
          <p:nvPr/>
        </p:nvCxnSpPr>
        <p:spPr>
          <a:xfrm flipV="1">
            <a:off x="4397393" y="1602035"/>
            <a:ext cx="0" cy="1085849"/>
          </a:xfrm>
          <a:prstGeom prst="straightConnector1">
            <a:avLst/>
          </a:prstGeom>
          <a:ln w="3810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ector recto de flecha 25"/>
          <p:cNvCxnSpPr/>
          <p:nvPr/>
        </p:nvCxnSpPr>
        <p:spPr>
          <a:xfrm>
            <a:off x="4391044" y="2687884"/>
            <a:ext cx="1729766" cy="0"/>
          </a:xfrm>
          <a:prstGeom prst="straightConnector1">
            <a:avLst/>
          </a:prstGeom>
          <a:ln w="3810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Conector recto 38"/>
          <p:cNvCxnSpPr/>
          <p:nvPr/>
        </p:nvCxnSpPr>
        <p:spPr>
          <a:xfrm flipH="1">
            <a:off x="5038901" y="2189409"/>
            <a:ext cx="499500" cy="1770"/>
          </a:xfrm>
          <a:prstGeom prst="line">
            <a:avLst/>
          </a:prstGeom>
          <a:ln w="28575">
            <a:solidFill>
              <a:srgbClr val="CC006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Conector recto 43"/>
          <p:cNvCxnSpPr/>
          <p:nvPr/>
        </p:nvCxnSpPr>
        <p:spPr>
          <a:xfrm flipV="1">
            <a:off x="5544751" y="1991946"/>
            <a:ext cx="77584" cy="206989"/>
          </a:xfrm>
          <a:prstGeom prst="line">
            <a:avLst/>
          </a:prstGeom>
          <a:ln w="28575">
            <a:solidFill>
              <a:srgbClr val="FFCC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Conector recto 45"/>
          <p:cNvCxnSpPr/>
          <p:nvPr/>
        </p:nvCxnSpPr>
        <p:spPr>
          <a:xfrm flipV="1">
            <a:off x="5619159" y="1991946"/>
            <a:ext cx="460376" cy="2383"/>
          </a:xfrm>
          <a:prstGeom prst="line">
            <a:avLst/>
          </a:prstGeom>
          <a:ln w="28575">
            <a:solidFill>
              <a:srgbClr val="FFCC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CuadroTexto 47"/>
          <p:cNvSpPr txBox="1"/>
          <p:nvPr/>
        </p:nvSpPr>
        <p:spPr>
          <a:xfrm>
            <a:off x="4717688" y="2678531"/>
            <a:ext cx="96018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O" sz="1050" dirty="0">
                <a:latin typeface="Arial" panose="020B0604020202020204" pitchFamily="34" charset="0"/>
                <a:cs typeface="Arial" panose="020B0604020202020204" pitchFamily="34" charset="0"/>
              </a:rPr>
              <a:t>Time (min)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CuadroTexto 50"/>
          <p:cNvSpPr txBox="1"/>
          <p:nvPr/>
        </p:nvSpPr>
        <p:spPr>
          <a:xfrm rot="16200000">
            <a:off x="3625566" y="2080072"/>
            <a:ext cx="122173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O" sz="1050" dirty="0" err="1">
                <a:latin typeface="Arial" panose="020B0604020202020204" pitchFamily="34" charset="0"/>
                <a:cs typeface="Arial" panose="020B0604020202020204" pitchFamily="34" charset="0"/>
              </a:rPr>
              <a:t>Temperature</a:t>
            </a:r>
            <a:r>
              <a:rPr lang="es-CO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CO" sz="105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s-CO" sz="1050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CuadroTexto 51"/>
          <p:cNvSpPr txBox="1"/>
          <p:nvPr/>
        </p:nvSpPr>
        <p:spPr>
          <a:xfrm>
            <a:off x="4499028" y="1799148"/>
            <a:ext cx="54679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O" sz="750" dirty="0">
                <a:latin typeface="Arial" panose="020B0604020202020204" pitchFamily="34" charset="0"/>
                <a:cs typeface="Arial" panose="020B0604020202020204" pitchFamily="34" charset="0"/>
              </a:rPr>
              <a:t>94 </a:t>
            </a:r>
            <a:r>
              <a:rPr lang="es-CO" sz="75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s-CO" sz="750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CuadroTexto 52"/>
          <p:cNvSpPr txBox="1"/>
          <p:nvPr/>
        </p:nvSpPr>
        <p:spPr>
          <a:xfrm>
            <a:off x="5000718" y="2017345"/>
            <a:ext cx="590572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O" sz="788" dirty="0">
                <a:latin typeface="Arial" panose="020B0604020202020204" pitchFamily="34" charset="0"/>
                <a:cs typeface="Arial" panose="020B0604020202020204" pitchFamily="34" charset="0"/>
              </a:rPr>
              <a:t>50-60 </a:t>
            </a:r>
            <a:r>
              <a:rPr lang="es-CO" sz="788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s-CO" sz="788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78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CuadroTexto 53"/>
          <p:cNvSpPr txBox="1"/>
          <p:nvPr/>
        </p:nvSpPr>
        <p:spPr>
          <a:xfrm>
            <a:off x="4423809" y="1604474"/>
            <a:ext cx="744561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O" sz="750" dirty="0" err="1">
                <a:latin typeface="Arial" panose="020B0604020202020204" pitchFamily="34" charset="0"/>
                <a:cs typeface="Arial" panose="020B0604020202020204" pitchFamily="34" charset="0"/>
              </a:rPr>
              <a:t>Denaturation</a:t>
            </a:r>
            <a:endParaRPr 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CuadroTexto 54"/>
          <p:cNvSpPr txBox="1"/>
          <p:nvPr/>
        </p:nvSpPr>
        <p:spPr>
          <a:xfrm>
            <a:off x="4946999" y="2181795"/>
            <a:ext cx="714452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O" sz="750" dirty="0" err="1">
                <a:latin typeface="Arial" panose="020B0604020202020204" pitchFamily="34" charset="0"/>
                <a:cs typeface="Arial" panose="020B0604020202020204" pitchFamily="34" charset="0"/>
              </a:rPr>
              <a:t>Annealing</a:t>
            </a:r>
            <a:endParaRPr 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CuadroTexto 55"/>
          <p:cNvSpPr txBox="1"/>
          <p:nvPr/>
        </p:nvSpPr>
        <p:spPr>
          <a:xfrm>
            <a:off x="5533357" y="1977869"/>
            <a:ext cx="714452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O" sz="750" dirty="0" err="1">
                <a:latin typeface="Arial" panose="020B0604020202020204" pitchFamily="34" charset="0"/>
                <a:cs typeface="Arial" panose="020B0604020202020204" pitchFamily="34" charset="0"/>
              </a:rPr>
              <a:t>Extension</a:t>
            </a:r>
            <a:endParaRPr 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CuadroTexto 56"/>
          <p:cNvSpPr txBox="1"/>
          <p:nvPr/>
        </p:nvSpPr>
        <p:spPr>
          <a:xfrm>
            <a:off x="5583543" y="1821137"/>
            <a:ext cx="54679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O" sz="750" dirty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r>
              <a:rPr lang="es-CO" sz="75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s-CO" sz="750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ángulo 20"/>
          <p:cNvSpPr/>
          <p:nvPr/>
        </p:nvSpPr>
        <p:spPr>
          <a:xfrm>
            <a:off x="4043363" y="3271838"/>
            <a:ext cx="4070350" cy="2146300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350"/>
          </a:p>
        </p:txBody>
      </p:sp>
      <p:sp>
        <p:nvSpPr>
          <p:cNvPr id="359" name="Rectángulo 358"/>
          <p:cNvSpPr/>
          <p:nvPr/>
        </p:nvSpPr>
        <p:spPr>
          <a:xfrm>
            <a:off x="5329512" y="3368770"/>
            <a:ext cx="853059" cy="1836000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360" name="Rectángulo 359"/>
          <p:cNvSpPr/>
          <p:nvPr/>
        </p:nvSpPr>
        <p:spPr>
          <a:xfrm>
            <a:off x="6193983" y="3367270"/>
            <a:ext cx="887609" cy="1836000"/>
          </a:xfrm>
          <a:prstGeom prst="rect">
            <a:avLst/>
          </a:prstGeom>
          <a:solidFill>
            <a:srgbClr val="FFCCCC"/>
          </a:solidFill>
          <a:ln>
            <a:solidFill>
              <a:srgbClr val="FF99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361" name="Rectángulo 360"/>
          <p:cNvSpPr/>
          <p:nvPr/>
        </p:nvSpPr>
        <p:spPr>
          <a:xfrm>
            <a:off x="7093080" y="3367270"/>
            <a:ext cx="891000" cy="1836000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chemeClr val="accent4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2" name="Cuadro de texto 10"/>
          <p:cNvSpPr txBox="1">
            <a:spLocks noChangeArrowheads="1"/>
          </p:cNvSpPr>
          <p:nvPr/>
        </p:nvSpPr>
        <p:spPr bwMode="auto">
          <a:xfrm>
            <a:off x="5654228" y="5047804"/>
            <a:ext cx="2209086" cy="1702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CO" altLang="en-US" sz="675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94 °C                        50-60 °C                          72 °C</a:t>
            </a:r>
            <a:endParaRPr lang="es-CO" altLang="en-US" sz="1500" dirty="0">
              <a:latin typeface="Arial" panose="020B0604020202020204" pitchFamily="34" charset="0"/>
            </a:endParaRPr>
          </a:p>
        </p:txBody>
      </p:sp>
      <p:sp>
        <p:nvSpPr>
          <p:cNvPr id="50" name="Rectángulo 49"/>
          <p:cNvSpPr/>
          <p:nvPr/>
        </p:nvSpPr>
        <p:spPr>
          <a:xfrm>
            <a:off x="4609137" y="4141147"/>
            <a:ext cx="434983" cy="80864"/>
          </a:xfrm>
          <a:prstGeom prst="rect">
            <a:avLst/>
          </a:prstGeom>
          <a:solidFill>
            <a:srgbClr val="800080"/>
          </a:solidFill>
          <a:ln>
            <a:solidFill>
              <a:srgbClr val="800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cxnSp>
        <p:nvCxnSpPr>
          <p:cNvPr id="59" name="Conector recto 58"/>
          <p:cNvCxnSpPr/>
          <p:nvPr/>
        </p:nvCxnSpPr>
        <p:spPr>
          <a:xfrm flipV="1">
            <a:off x="4603658" y="4243414"/>
            <a:ext cx="445500" cy="3810"/>
          </a:xfrm>
          <a:prstGeom prst="line">
            <a:avLst/>
          </a:prstGeom>
          <a:ln w="57150">
            <a:solidFill>
              <a:srgbClr val="00CC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Rectángulo 61"/>
          <p:cNvSpPr/>
          <p:nvPr/>
        </p:nvSpPr>
        <p:spPr>
          <a:xfrm rot="10800000">
            <a:off x="4608193" y="4312937"/>
            <a:ext cx="434983" cy="80864"/>
          </a:xfrm>
          <a:prstGeom prst="rect">
            <a:avLst/>
          </a:prstGeom>
          <a:solidFill>
            <a:srgbClr val="800080"/>
          </a:solidFill>
          <a:ln>
            <a:solidFill>
              <a:srgbClr val="800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cxnSp>
        <p:nvCxnSpPr>
          <p:cNvPr id="63" name="Conector recto 62"/>
          <p:cNvCxnSpPr/>
          <p:nvPr/>
        </p:nvCxnSpPr>
        <p:spPr>
          <a:xfrm rot="10800000" flipV="1">
            <a:off x="4605889" y="4286617"/>
            <a:ext cx="445500" cy="3810"/>
          </a:xfrm>
          <a:prstGeom prst="line">
            <a:avLst/>
          </a:prstGeom>
          <a:ln w="57150">
            <a:solidFill>
              <a:srgbClr val="00CC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Rectángulo 66"/>
          <p:cNvSpPr/>
          <p:nvPr/>
        </p:nvSpPr>
        <p:spPr>
          <a:xfrm>
            <a:off x="5595222" y="3904746"/>
            <a:ext cx="434983" cy="80864"/>
          </a:xfrm>
          <a:prstGeom prst="rect">
            <a:avLst/>
          </a:prstGeom>
          <a:solidFill>
            <a:srgbClr val="800080"/>
          </a:solidFill>
          <a:ln>
            <a:solidFill>
              <a:srgbClr val="800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cxnSp>
        <p:nvCxnSpPr>
          <p:cNvPr id="68" name="Conector recto 67"/>
          <p:cNvCxnSpPr/>
          <p:nvPr/>
        </p:nvCxnSpPr>
        <p:spPr>
          <a:xfrm flipV="1">
            <a:off x="5590110" y="4006594"/>
            <a:ext cx="445500" cy="3810"/>
          </a:xfrm>
          <a:prstGeom prst="line">
            <a:avLst/>
          </a:prstGeom>
          <a:ln w="57150">
            <a:solidFill>
              <a:srgbClr val="00CC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Rectángulo 68"/>
          <p:cNvSpPr/>
          <p:nvPr/>
        </p:nvSpPr>
        <p:spPr>
          <a:xfrm rot="10800000">
            <a:off x="5600627" y="4597224"/>
            <a:ext cx="434983" cy="80864"/>
          </a:xfrm>
          <a:prstGeom prst="rect">
            <a:avLst/>
          </a:prstGeom>
          <a:solidFill>
            <a:srgbClr val="800080"/>
          </a:solidFill>
          <a:ln>
            <a:solidFill>
              <a:srgbClr val="800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cxnSp>
        <p:nvCxnSpPr>
          <p:cNvPr id="70" name="Conector recto 69"/>
          <p:cNvCxnSpPr/>
          <p:nvPr/>
        </p:nvCxnSpPr>
        <p:spPr>
          <a:xfrm rot="10800000" flipV="1">
            <a:off x="5595148" y="4570903"/>
            <a:ext cx="445500" cy="3810"/>
          </a:xfrm>
          <a:prstGeom prst="line">
            <a:avLst/>
          </a:prstGeom>
          <a:ln w="57150">
            <a:solidFill>
              <a:srgbClr val="00CC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Rectángulo 74"/>
          <p:cNvSpPr/>
          <p:nvPr/>
        </p:nvSpPr>
        <p:spPr>
          <a:xfrm>
            <a:off x="6379195" y="3618439"/>
            <a:ext cx="434983" cy="80864"/>
          </a:xfrm>
          <a:prstGeom prst="rect">
            <a:avLst/>
          </a:prstGeom>
          <a:solidFill>
            <a:srgbClr val="800080"/>
          </a:solidFill>
          <a:ln>
            <a:solidFill>
              <a:srgbClr val="800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cxnSp>
        <p:nvCxnSpPr>
          <p:cNvPr id="76" name="Conector recto 75"/>
          <p:cNvCxnSpPr/>
          <p:nvPr/>
        </p:nvCxnSpPr>
        <p:spPr>
          <a:xfrm flipV="1">
            <a:off x="6376298" y="3718910"/>
            <a:ext cx="445500" cy="3810"/>
          </a:xfrm>
          <a:prstGeom prst="line">
            <a:avLst/>
          </a:prstGeom>
          <a:ln w="57150">
            <a:solidFill>
              <a:srgbClr val="00CC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Rectángulo 76"/>
          <p:cNvSpPr/>
          <p:nvPr/>
        </p:nvSpPr>
        <p:spPr>
          <a:xfrm rot="10800000">
            <a:off x="6409941" y="4869302"/>
            <a:ext cx="434983" cy="80864"/>
          </a:xfrm>
          <a:prstGeom prst="rect">
            <a:avLst/>
          </a:prstGeom>
          <a:solidFill>
            <a:srgbClr val="800080"/>
          </a:solidFill>
          <a:ln>
            <a:solidFill>
              <a:srgbClr val="800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cxnSp>
        <p:nvCxnSpPr>
          <p:cNvPr id="78" name="Conector recto 77"/>
          <p:cNvCxnSpPr/>
          <p:nvPr/>
        </p:nvCxnSpPr>
        <p:spPr>
          <a:xfrm rot="10800000" flipV="1">
            <a:off x="6404462" y="4842982"/>
            <a:ext cx="445500" cy="3810"/>
          </a:xfrm>
          <a:prstGeom prst="line">
            <a:avLst/>
          </a:prstGeom>
          <a:ln w="57150">
            <a:solidFill>
              <a:srgbClr val="00CC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2" name="Grupo 91"/>
          <p:cNvGrpSpPr/>
          <p:nvPr/>
        </p:nvGrpSpPr>
        <p:grpSpPr>
          <a:xfrm rot="1140000">
            <a:off x="4948116" y="3826138"/>
            <a:ext cx="189000" cy="130469"/>
            <a:chOff x="4079020" y="6879809"/>
            <a:chExt cx="252000" cy="173958"/>
          </a:xfrm>
        </p:grpSpPr>
        <p:sp>
          <p:nvSpPr>
            <p:cNvPr id="64" name="Forma libre 63"/>
            <p:cNvSpPr/>
            <p:nvPr/>
          </p:nvSpPr>
          <p:spPr>
            <a:xfrm rot="21480000" flipV="1">
              <a:off x="4080439" y="6908435"/>
              <a:ext cx="249698" cy="145332"/>
            </a:xfrm>
            <a:custGeom>
              <a:avLst/>
              <a:gdLst>
                <a:gd name="connsiteX0" fmla="*/ 101600 w 485775"/>
                <a:gd name="connsiteY0" fmla="*/ 79375 h 177800"/>
                <a:gd name="connsiteX1" fmla="*/ 485775 w 485775"/>
                <a:gd name="connsiteY1" fmla="*/ 76200 h 177800"/>
                <a:gd name="connsiteX2" fmla="*/ 482600 w 485775"/>
                <a:gd name="connsiteY2" fmla="*/ 174625 h 177800"/>
                <a:gd name="connsiteX3" fmla="*/ 0 w 485775"/>
                <a:gd name="connsiteY3" fmla="*/ 177800 h 177800"/>
                <a:gd name="connsiteX4" fmla="*/ 82550 w 485775"/>
                <a:gd name="connsiteY4" fmla="*/ 0 h 177800"/>
                <a:gd name="connsiteX5" fmla="*/ 101600 w 485775"/>
                <a:gd name="connsiteY5" fmla="*/ 79375 h 177800"/>
                <a:gd name="connsiteX0" fmla="*/ 196850 w 581025"/>
                <a:gd name="connsiteY0" fmla="*/ 79375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96850 w 581025"/>
                <a:gd name="connsiteY5" fmla="*/ 79375 h 187325"/>
                <a:gd name="connsiteX0" fmla="*/ 177800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77800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263089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63089 w 581025"/>
                <a:gd name="connsiteY5" fmla="*/ 82550 h 187325"/>
                <a:gd name="connsiteX0" fmla="*/ 289741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89741 w 581025"/>
                <a:gd name="connsiteY5" fmla="*/ 82550 h 187325"/>
                <a:gd name="connsiteX0" fmla="*/ 289741 w 581025"/>
                <a:gd name="connsiteY0" fmla="*/ 91494 h 196269"/>
                <a:gd name="connsiteX1" fmla="*/ 581025 w 581025"/>
                <a:gd name="connsiteY1" fmla="*/ 85144 h 196269"/>
                <a:gd name="connsiteX2" fmla="*/ 577850 w 581025"/>
                <a:gd name="connsiteY2" fmla="*/ 183569 h 196269"/>
                <a:gd name="connsiteX3" fmla="*/ 0 w 581025"/>
                <a:gd name="connsiteY3" fmla="*/ 196269 h 196269"/>
                <a:gd name="connsiteX4" fmla="*/ 295072 w 581025"/>
                <a:gd name="connsiteY4" fmla="*/ 0 h 196269"/>
                <a:gd name="connsiteX5" fmla="*/ 289741 w 581025"/>
                <a:gd name="connsiteY5" fmla="*/ 91494 h 1962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81025" h="196269">
                  <a:moveTo>
                    <a:pt x="289741" y="91494"/>
                  </a:moveTo>
                  <a:lnTo>
                    <a:pt x="581025" y="85144"/>
                  </a:lnTo>
                  <a:lnTo>
                    <a:pt x="577850" y="183569"/>
                  </a:lnTo>
                  <a:lnTo>
                    <a:pt x="0" y="196269"/>
                  </a:lnTo>
                  <a:lnTo>
                    <a:pt x="295072" y="0"/>
                  </a:lnTo>
                  <a:lnTo>
                    <a:pt x="289741" y="91494"/>
                  </a:lnTo>
                  <a:close/>
                </a:path>
              </a:pathLst>
            </a:custGeom>
            <a:solidFill>
              <a:srgbClr val="92D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87" name="Conector recto 86"/>
            <p:cNvCxnSpPr/>
            <p:nvPr/>
          </p:nvCxnSpPr>
          <p:spPr>
            <a:xfrm rot="-60000">
              <a:off x="4079020" y="6879809"/>
              <a:ext cx="252000" cy="8255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5" name="Grupo 94"/>
          <p:cNvGrpSpPr/>
          <p:nvPr/>
        </p:nvGrpSpPr>
        <p:grpSpPr>
          <a:xfrm rot="20400000" flipH="1">
            <a:off x="4288915" y="4760319"/>
            <a:ext cx="189000" cy="130469"/>
            <a:chOff x="4079020" y="6879809"/>
            <a:chExt cx="252000" cy="173958"/>
          </a:xfrm>
        </p:grpSpPr>
        <p:sp>
          <p:nvSpPr>
            <p:cNvPr id="96" name="Forma libre 95"/>
            <p:cNvSpPr/>
            <p:nvPr/>
          </p:nvSpPr>
          <p:spPr>
            <a:xfrm rot="21480000" flipV="1">
              <a:off x="4080439" y="6908435"/>
              <a:ext cx="249698" cy="145332"/>
            </a:xfrm>
            <a:custGeom>
              <a:avLst/>
              <a:gdLst>
                <a:gd name="connsiteX0" fmla="*/ 101600 w 485775"/>
                <a:gd name="connsiteY0" fmla="*/ 79375 h 177800"/>
                <a:gd name="connsiteX1" fmla="*/ 485775 w 485775"/>
                <a:gd name="connsiteY1" fmla="*/ 76200 h 177800"/>
                <a:gd name="connsiteX2" fmla="*/ 482600 w 485775"/>
                <a:gd name="connsiteY2" fmla="*/ 174625 h 177800"/>
                <a:gd name="connsiteX3" fmla="*/ 0 w 485775"/>
                <a:gd name="connsiteY3" fmla="*/ 177800 h 177800"/>
                <a:gd name="connsiteX4" fmla="*/ 82550 w 485775"/>
                <a:gd name="connsiteY4" fmla="*/ 0 h 177800"/>
                <a:gd name="connsiteX5" fmla="*/ 101600 w 485775"/>
                <a:gd name="connsiteY5" fmla="*/ 79375 h 177800"/>
                <a:gd name="connsiteX0" fmla="*/ 196850 w 581025"/>
                <a:gd name="connsiteY0" fmla="*/ 79375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96850 w 581025"/>
                <a:gd name="connsiteY5" fmla="*/ 79375 h 187325"/>
                <a:gd name="connsiteX0" fmla="*/ 177800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77800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263089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63089 w 581025"/>
                <a:gd name="connsiteY5" fmla="*/ 82550 h 187325"/>
                <a:gd name="connsiteX0" fmla="*/ 289741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89741 w 581025"/>
                <a:gd name="connsiteY5" fmla="*/ 82550 h 187325"/>
                <a:gd name="connsiteX0" fmla="*/ 289741 w 581025"/>
                <a:gd name="connsiteY0" fmla="*/ 91494 h 196269"/>
                <a:gd name="connsiteX1" fmla="*/ 581025 w 581025"/>
                <a:gd name="connsiteY1" fmla="*/ 85144 h 196269"/>
                <a:gd name="connsiteX2" fmla="*/ 577850 w 581025"/>
                <a:gd name="connsiteY2" fmla="*/ 183569 h 196269"/>
                <a:gd name="connsiteX3" fmla="*/ 0 w 581025"/>
                <a:gd name="connsiteY3" fmla="*/ 196269 h 196269"/>
                <a:gd name="connsiteX4" fmla="*/ 295072 w 581025"/>
                <a:gd name="connsiteY4" fmla="*/ 0 h 196269"/>
                <a:gd name="connsiteX5" fmla="*/ 289741 w 581025"/>
                <a:gd name="connsiteY5" fmla="*/ 91494 h 1962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81025" h="196269">
                  <a:moveTo>
                    <a:pt x="289741" y="91494"/>
                  </a:moveTo>
                  <a:lnTo>
                    <a:pt x="581025" y="85144"/>
                  </a:lnTo>
                  <a:lnTo>
                    <a:pt x="577850" y="183569"/>
                  </a:lnTo>
                  <a:lnTo>
                    <a:pt x="0" y="196269"/>
                  </a:lnTo>
                  <a:lnTo>
                    <a:pt x="295072" y="0"/>
                  </a:lnTo>
                  <a:lnTo>
                    <a:pt x="289741" y="91494"/>
                  </a:lnTo>
                  <a:close/>
                </a:path>
              </a:pathLst>
            </a:custGeom>
            <a:solidFill>
              <a:srgbClr val="92D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97" name="Conector recto 96"/>
            <p:cNvCxnSpPr/>
            <p:nvPr/>
          </p:nvCxnSpPr>
          <p:spPr>
            <a:xfrm rot="-60000">
              <a:off x="4079020" y="6879809"/>
              <a:ext cx="252000" cy="8255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3" name="Grupo 92"/>
          <p:cNvGrpSpPr/>
          <p:nvPr/>
        </p:nvGrpSpPr>
        <p:grpSpPr>
          <a:xfrm rot="1320000">
            <a:off x="6449447" y="4008062"/>
            <a:ext cx="62100" cy="106542"/>
            <a:chOff x="4953375" y="7221921"/>
            <a:chExt cx="82800" cy="142056"/>
          </a:xfrm>
        </p:grpSpPr>
        <p:sp>
          <p:nvSpPr>
            <p:cNvPr id="98" name="Rectángulo 97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100" name="Conector recto 99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2" name="Grupo 101"/>
          <p:cNvGrpSpPr/>
          <p:nvPr/>
        </p:nvGrpSpPr>
        <p:grpSpPr>
          <a:xfrm rot="1560000">
            <a:off x="4791104" y="4488605"/>
            <a:ext cx="62100" cy="106542"/>
            <a:chOff x="4953375" y="7221921"/>
            <a:chExt cx="82800" cy="142056"/>
          </a:xfrm>
        </p:grpSpPr>
        <p:sp>
          <p:nvSpPr>
            <p:cNvPr id="103" name="Rectángulo 102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104" name="Conector recto 103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5" name="Grupo 104"/>
          <p:cNvGrpSpPr/>
          <p:nvPr/>
        </p:nvGrpSpPr>
        <p:grpSpPr>
          <a:xfrm rot="1320000">
            <a:off x="6649450" y="4181922"/>
            <a:ext cx="62100" cy="106542"/>
            <a:chOff x="4953375" y="7221921"/>
            <a:chExt cx="82800" cy="142056"/>
          </a:xfrm>
        </p:grpSpPr>
        <p:sp>
          <p:nvSpPr>
            <p:cNvPr id="106" name="Rectángulo 105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107" name="Conector recto 106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8" name="Grupo 107"/>
          <p:cNvGrpSpPr/>
          <p:nvPr/>
        </p:nvGrpSpPr>
        <p:grpSpPr>
          <a:xfrm rot="17040000">
            <a:off x="6372105" y="4218080"/>
            <a:ext cx="62100" cy="106542"/>
            <a:chOff x="4953375" y="7221921"/>
            <a:chExt cx="82800" cy="142056"/>
          </a:xfrm>
        </p:grpSpPr>
        <p:sp>
          <p:nvSpPr>
            <p:cNvPr id="109" name="Rectángulo 108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110" name="Conector recto 109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4" name="Grupo 113"/>
          <p:cNvGrpSpPr/>
          <p:nvPr/>
        </p:nvGrpSpPr>
        <p:grpSpPr>
          <a:xfrm rot="1560000" flipV="1">
            <a:off x="5183947" y="4155721"/>
            <a:ext cx="62100" cy="106542"/>
            <a:chOff x="4953375" y="7221921"/>
            <a:chExt cx="82800" cy="142056"/>
          </a:xfrm>
        </p:grpSpPr>
        <p:sp>
          <p:nvSpPr>
            <p:cNvPr id="115" name="Rectángulo 114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116" name="Conector recto 115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0" name="Grupo 119"/>
          <p:cNvGrpSpPr/>
          <p:nvPr/>
        </p:nvGrpSpPr>
        <p:grpSpPr>
          <a:xfrm rot="1560000" flipV="1">
            <a:off x="4691840" y="3906268"/>
            <a:ext cx="62100" cy="106542"/>
            <a:chOff x="4953375" y="7221921"/>
            <a:chExt cx="82800" cy="142056"/>
          </a:xfrm>
        </p:grpSpPr>
        <p:sp>
          <p:nvSpPr>
            <p:cNvPr id="121" name="Rectángulo 120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122" name="Conector recto 121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26" name="Imagen 12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77" t="16601" r="40948" b="25066"/>
          <a:stretch/>
        </p:blipFill>
        <p:spPr>
          <a:xfrm>
            <a:off x="4513040" y="4088875"/>
            <a:ext cx="91418" cy="88266"/>
          </a:xfrm>
          <a:prstGeom prst="rect">
            <a:avLst/>
          </a:prstGeom>
        </p:spPr>
      </p:pic>
      <p:pic>
        <p:nvPicPr>
          <p:cNvPr id="127" name="Imagen 12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31" t="16963" r="41175" b="24703"/>
          <a:stretch/>
        </p:blipFill>
        <p:spPr>
          <a:xfrm>
            <a:off x="5048060" y="4090138"/>
            <a:ext cx="90629" cy="88265"/>
          </a:xfrm>
          <a:prstGeom prst="rect">
            <a:avLst/>
          </a:prstGeom>
        </p:spPr>
      </p:pic>
      <p:pic>
        <p:nvPicPr>
          <p:cNvPr id="134" name="Imagen 13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77" t="16601" r="40948" b="25066"/>
          <a:stretch/>
        </p:blipFill>
        <p:spPr>
          <a:xfrm rot="10800000">
            <a:off x="5047720" y="4364688"/>
            <a:ext cx="91418" cy="88266"/>
          </a:xfrm>
          <a:prstGeom prst="rect">
            <a:avLst/>
          </a:prstGeom>
        </p:spPr>
      </p:pic>
      <p:pic>
        <p:nvPicPr>
          <p:cNvPr id="135" name="Imagen 13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31" t="16963" r="41175" b="24703"/>
          <a:stretch/>
        </p:blipFill>
        <p:spPr>
          <a:xfrm rot="10800000">
            <a:off x="4514765" y="4362322"/>
            <a:ext cx="90629" cy="88265"/>
          </a:xfrm>
          <a:prstGeom prst="rect">
            <a:avLst/>
          </a:prstGeom>
        </p:spPr>
      </p:pic>
      <p:grpSp>
        <p:nvGrpSpPr>
          <p:cNvPr id="139" name="Grupo 138"/>
          <p:cNvGrpSpPr/>
          <p:nvPr/>
        </p:nvGrpSpPr>
        <p:grpSpPr>
          <a:xfrm rot="20040000" flipH="1">
            <a:off x="4349254" y="4499588"/>
            <a:ext cx="62100" cy="106542"/>
            <a:chOff x="4953375" y="7221921"/>
            <a:chExt cx="82800" cy="142056"/>
          </a:xfrm>
        </p:grpSpPr>
        <p:sp>
          <p:nvSpPr>
            <p:cNvPr id="140" name="Rectángulo 139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141" name="Conector recto 140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2" name="Grupo 141"/>
          <p:cNvGrpSpPr/>
          <p:nvPr/>
        </p:nvGrpSpPr>
        <p:grpSpPr>
          <a:xfrm rot="20040000" flipH="1" flipV="1">
            <a:off x="4489041" y="3817159"/>
            <a:ext cx="62100" cy="106542"/>
            <a:chOff x="4953375" y="7221921"/>
            <a:chExt cx="82800" cy="142056"/>
          </a:xfrm>
        </p:grpSpPr>
        <p:sp>
          <p:nvSpPr>
            <p:cNvPr id="143" name="Rectángulo 142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144" name="Conector recto 143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5" name="Grupo 144"/>
          <p:cNvGrpSpPr/>
          <p:nvPr/>
        </p:nvGrpSpPr>
        <p:grpSpPr>
          <a:xfrm rot="20040000" flipH="1" flipV="1">
            <a:off x="4916348" y="4753443"/>
            <a:ext cx="62100" cy="106542"/>
            <a:chOff x="4953375" y="7221921"/>
            <a:chExt cx="82800" cy="142056"/>
          </a:xfrm>
        </p:grpSpPr>
        <p:sp>
          <p:nvSpPr>
            <p:cNvPr id="146" name="Rectángulo 145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147" name="Conector recto 146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6" name="Grupo 175"/>
          <p:cNvGrpSpPr/>
          <p:nvPr/>
        </p:nvGrpSpPr>
        <p:grpSpPr>
          <a:xfrm>
            <a:off x="6632798" y="3756588"/>
            <a:ext cx="189000" cy="130469"/>
            <a:chOff x="4079020" y="6879809"/>
            <a:chExt cx="252000" cy="173958"/>
          </a:xfrm>
        </p:grpSpPr>
        <p:sp>
          <p:nvSpPr>
            <p:cNvPr id="177" name="Forma libre 176"/>
            <p:cNvSpPr/>
            <p:nvPr/>
          </p:nvSpPr>
          <p:spPr>
            <a:xfrm rot="21480000" flipV="1">
              <a:off x="4080439" y="6908435"/>
              <a:ext cx="249698" cy="145332"/>
            </a:xfrm>
            <a:custGeom>
              <a:avLst/>
              <a:gdLst>
                <a:gd name="connsiteX0" fmla="*/ 101600 w 485775"/>
                <a:gd name="connsiteY0" fmla="*/ 79375 h 177800"/>
                <a:gd name="connsiteX1" fmla="*/ 485775 w 485775"/>
                <a:gd name="connsiteY1" fmla="*/ 76200 h 177800"/>
                <a:gd name="connsiteX2" fmla="*/ 482600 w 485775"/>
                <a:gd name="connsiteY2" fmla="*/ 174625 h 177800"/>
                <a:gd name="connsiteX3" fmla="*/ 0 w 485775"/>
                <a:gd name="connsiteY3" fmla="*/ 177800 h 177800"/>
                <a:gd name="connsiteX4" fmla="*/ 82550 w 485775"/>
                <a:gd name="connsiteY4" fmla="*/ 0 h 177800"/>
                <a:gd name="connsiteX5" fmla="*/ 101600 w 485775"/>
                <a:gd name="connsiteY5" fmla="*/ 79375 h 177800"/>
                <a:gd name="connsiteX0" fmla="*/ 196850 w 581025"/>
                <a:gd name="connsiteY0" fmla="*/ 79375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96850 w 581025"/>
                <a:gd name="connsiteY5" fmla="*/ 79375 h 187325"/>
                <a:gd name="connsiteX0" fmla="*/ 177800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77800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263089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63089 w 581025"/>
                <a:gd name="connsiteY5" fmla="*/ 82550 h 187325"/>
                <a:gd name="connsiteX0" fmla="*/ 289741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89741 w 581025"/>
                <a:gd name="connsiteY5" fmla="*/ 82550 h 187325"/>
                <a:gd name="connsiteX0" fmla="*/ 289741 w 581025"/>
                <a:gd name="connsiteY0" fmla="*/ 91494 h 196269"/>
                <a:gd name="connsiteX1" fmla="*/ 581025 w 581025"/>
                <a:gd name="connsiteY1" fmla="*/ 85144 h 196269"/>
                <a:gd name="connsiteX2" fmla="*/ 577850 w 581025"/>
                <a:gd name="connsiteY2" fmla="*/ 183569 h 196269"/>
                <a:gd name="connsiteX3" fmla="*/ 0 w 581025"/>
                <a:gd name="connsiteY3" fmla="*/ 196269 h 196269"/>
                <a:gd name="connsiteX4" fmla="*/ 295072 w 581025"/>
                <a:gd name="connsiteY4" fmla="*/ 0 h 196269"/>
                <a:gd name="connsiteX5" fmla="*/ 289741 w 581025"/>
                <a:gd name="connsiteY5" fmla="*/ 91494 h 1962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81025" h="196269">
                  <a:moveTo>
                    <a:pt x="289741" y="91494"/>
                  </a:moveTo>
                  <a:lnTo>
                    <a:pt x="581025" y="85144"/>
                  </a:lnTo>
                  <a:lnTo>
                    <a:pt x="577850" y="183569"/>
                  </a:lnTo>
                  <a:lnTo>
                    <a:pt x="0" y="196269"/>
                  </a:lnTo>
                  <a:lnTo>
                    <a:pt x="295072" y="0"/>
                  </a:lnTo>
                  <a:lnTo>
                    <a:pt x="289741" y="91494"/>
                  </a:lnTo>
                  <a:close/>
                </a:path>
              </a:pathLst>
            </a:custGeom>
            <a:solidFill>
              <a:srgbClr val="92D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178" name="Conector recto 177"/>
            <p:cNvCxnSpPr/>
            <p:nvPr/>
          </p:nvCxnSpPr>
          <p:spPr>
            <a:xfrm rot="-60000">
              <a:off x="4079020" y="6879809"/>
              <a:ext cx="252000" cy="8255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79" name="Imagen 178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77" t="16601" r="40948" b="25066"/>
          <a:stretch/>
        </p:blipFill>
        <p:spPr>
          <a:xfrm>
            <a:off x="6291857" y="3544000"/>
            <a:ext cx="91418" cy="88266"/>
          </a:xfrm>
          <a:prstGeom prst="rect">
            <a:avLst/>
          </a:prstGeom>
        </p:spPr>
      </p:pic>
      <p:pic>
        <p:nvPicPr>
          <p:cNvPr id="180" name="Imagen 179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31" t="16963" r="41175" b="24703"/>
          <a:stretch/>
        </p:blipFill>
        <p:spPr>
          <a:xfrm>
            <a:off x="6814042" y="3541500"/>
            <a:ext cx="90629" cy="88265"/>
          </a:xfrm>
          <a:prstGeom prst="rect">
            <a:avLst/>
          </a:prstGeom>
        </p:spPr>
      </p:pic>
      <p:grpSp>
        <p:nvGrpSpPr>
          <p:cNvPr id="181" name="Grupo 180"/>
          <p:cNvGrpSpPr/>
          <p:nvPr/>
        </p:nvGrpSpPr>
        <p:grpSpPr>
          <a:xfrm flipH="1" flipV="1">
            <a:off x="6404338" y="4679631"/>
            <a:ext cx="189000" cy="130469"/>
            <a:chOff x="4079020" y="6879809"/>
            <a:chExt cx="252000" cy="173958"/>
          </a:xfrm>
        </p:grpSpPr>
        <p:sp>
          <p:nvSpPr>
            <p:cNvPr id="182" name="Forma libre 181"/>
            <p:cNvSpPr/>
            <p:nvPr/>
          </p:nvSpPr>
          <p:spPr>
            <a:xfrm rot="21480000" flipV="1">
              <a:off x="4080439" y="6908435"/>
              <a:ext cx="249698" cy="145332"/>
            </a:xfrm>
            <a:custGeom>
              <a:avLst/>
              <a:gdLst>
                <a:gd name="connsiteX0" fmla="*/ 101600 w 485775"/>
                <a:gd name="connsiteY0" fmla="*/ 79375 h 177800"/>
                <a:gd name="connsiteX1" fmla="*/ 485775 w 485775"/>
                <a:gd name="connsiteY1" fmla="*/ 76200 h 177800"/>
                <a:gd name="connsiteX2" fmla="*/ 482600 w 485775"/>
                <a:gd name="connsiteY2" fmla="*/ 174625 h 177800"/>
                <a:gd name="connsiteX3" fmla="*/ 0 w 485775"/>
                <a:gd name="connsiteY3" fmla="*/ 177800 h 177800"/>
                <a:gd name="connsiteX4" fmla="*/ 82550 w 485775"/>
                <a:gd name="connsiteY4" fmla="*/ 0 h 177800"/>
                <a:gd name="connsiteX5" fmla="*/ 101600 w 485775"/>
                <a:gd name="connsiteY5" fmla="*/ 79375 h 177800"/>
                <a:gd name="connsiteX0" fmla="*/ 196850 w 581025"/>
                <a:gd name="connsiteY0" fmla="*/ 79375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96850 w 581025"/>
                <a:gd name="connsiteY5" fmla="*/ 79375 h 187325"/>
                <a:gd name="connsiteX0" fmla="*/ 177800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77800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263089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63089 w 581025"/>
                <a:gd name="connsiteY5" fmla="*/ 82550 h 187325"/>
                <a:gd name="connsiteX0" fmla="*/ 289741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89741 w 581025"/>
                <a:gd name="connsiteY5" fmla="*/ 82550 h 187325"/>
                <a:gd name="connsiteX0" fmla="*/ 289741 w 581025"/>
                <a:gd name="connsiteY0" fmla="*/ 91494 h 196269"/>
                <a:gd name="connsiteX1" fmla="*/ 581025 w 581025"/>
                <a:gd name="connsiteY1" fmla="*/ 85144 h 196269"/>
                <a:gd name="connsiteX2" fmla="*/ 577850 w 581025"/>
                <a:gd name="connsiteY2" fmla="*/ 183569 h 196269"/>
                <a:gd name="connsiteX3" fmla="*/ 0 w 581025"/>
                <a:gd name="connsiteY3" fmla="*/ 196269 h 196269"/>
                <a:gd name="connsiteX4" fmla="*/ 295072 w 581025"/>
                <a:gd name="connsiteY4" fmla="*/ 0 h 196269"/>
                <a:gd name="connsiteX5" fmla="*/ 289741 w 581025"/>
                <a:gd name="connsiteY5" fmla="*/ 91494 h 1962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81025" h="196269">
                  <a:moveTo>
                    <a:pt x="289741" y="91494"/>
                  </a:moveTo>
                  <a:lnTo>
                    <a:pt x="581025" y="85144"/>
                  </a:lnTo>
                  <a:lnTo>
                    <a:pt x="577850" y="183569"/>
                  </a:lnTo>
                  <a:lnTo>
                    <a:pt x="0" y="196269"/>
                  </a:lnTo>
                  <a:lnTo>
                    <a:pt x="295072" y="0"/>
                  </a:lnTo>
                  <a:lnTo>
                    <a:pt x="289741" y="91494"/>
                  </a:lnTo>
                  <a:close/>
                </a:path>
              </a:pathLst>
            </a:custGeom>
            <a:solidFill>
              <a:srgbClr val="92D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183" name="Conector recto 182"/>
            <p:cNvCxnSpPr/>
            <p:nvPr/>
          </p:nvCxnSpPr>
          <p:spPr>
            <a:xfrm rot="-60000">
              <a:off x="4079020" y="6879809"/>
              <a:ext cx="252000" cy="8255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4" name="Grupo 183"/>
          <p:cNvGrpSpPr/>
          <p:nvPr/>
        </p:nvGrpSpPr>
        <p:grpSpPr>
          <a:xfrm rot="20280000" flipH="1">
            <a:off x="6649713" y="3987614"/>
            <a:ext cx="62100" cy="106542"/>
            <a:chOff x="4953375" y="7221921"/>
            <a:chExt cx="82800" cy="142056"/>
          </a:xfrm>
        </p:grpSpPr>
        <p:sp>
          <p:nvSpPr>
            <p:cNvPr id="185" name="Rectángulo 184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186" name="Conector recto 185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7" name="Grupo 186"/>
          <p:cNvGrpSpPr/>
          <p:nvPr/>
        </p:nvGrpSpPr>
        <p:grpSpPr>
          <a:xfrm rot="20280000" flipH="1">
            <a:off x="6763750" y="4296222"/>
            <a:ext cx="62100" cy="106542"/>
            <a:chOff x="4953375" y="7221921"/>
            <a:chExt cx="82800" cy="142056"/>
          </a:xfrm>
        </p:grpSpPr>
        <p:sp>
          <p:nvSpPr>
            <p:cNvPr id="188" name="Rectángulo 187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189" name="Conector recto 188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0" name="Grupo 189"/>
          <p:cNvGrpSpPr/>
          <p:nvPr/>
        </p:nvGrpSpPr>
        <p:grpSpPr>
          <a:xfrm rot="20280000" flipH="1">
            <a:off x="6532206" y="4378621"/>
            <a:ext cx="62100" cy="106542"/>
            <a:chOff x="4953375" y="7221921"/>
            <a:chExt cx="82800" cy="142056"/>
          </a:xfrm>
        </p:grpSpPr>
        <p:sp>
          <p:nvSpPr>
            <p:cNvPr id="191" name="Rectángulo 190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192" name="Conector recto 191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6" name="Grupo 195"/>
          <p:cNvGrpSpPr/>
          <p:nvPr/>
        </p:nvGrpSpPr>
        <p:grpSpPr>
          <a:xfrm rot="20280000" flipH="1" flipV="1">
            <a:off x="6505656" y="3794562"/>
            <a:ext cx="62100" cy="106542"/>
            <a:chOff x="4953375" y="7221921"/>
            <a:chExt cx="82800" cy="142056"/>
          </a:xfrm>
        </p:grpSpPr>
        <p:sp>
          <p:nvSpPr>
            <p:cNvPr id="197" name="Rectángulo 196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198" name="Conector recto 197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3" name="Grupo 202"/>
          <p:cNvGrpSpPr/>
          <p:nvPr/>
        </p:nvGrpSpPr>
        <p:grpSpPr>
          <a:xfrm rot="1560000">
            <a:off x="6369161" y="4501954"/>
            <a:ext cx="62100" cy="106542"/>
            <a:chOff x="4953375" y="7221921"/>
            <a:chExt cx="82800" cy="142056"/>
          </a:xfrm>
        </p:grpSpPr>
        <p:sp>
          <p:nvSpPr>
            <p:cNvPr id="204" name="Rectángulo 203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205" name="Conector recto 204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06" name="Imagen 20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77" t="16601" r="40948" b="25066"/>
          <a:stretch/>
        </p:blipFill>
        <p:spPr>
          <a:xfrm rot="10800000">
            <a:off x="6846787" y="4932109"/>
            <a:ext cx="91418" cy="88266"/>
          </a:xfrm>
          <a:prstGeom prst="rect">
            <a:avLst/>
          </a:prstGeom>
        </p:spPr>
      </p:pic>
      <p:pic>
        <p:nvPicPr>
          <p:cNvPr id="207" name="Imagen 20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31" t="16963" r="41175" b="24703"/>
          <a:stretch/>
        </p:blipFill>
        <p:spPr>
          <a:xfrm rot="10800000">
            <a:off x="6317007" y="4936093"/>
            <a:ext cx="90629" cy="88265"/>
          </a:xfrm>
          <a:prstGeom prst="rect">
            <a:avLst/>
          </a:prstGeom>
        </p:spPr>
      </p:pic>
      <p:sp>
        <p:nvSpPr>
          <p:cNvPr id="209" name="Circular 131"/>
          <p:cNvSpPr/>
          <p:nvPr/>
        </p:nvSpPr>
        <p:spPr>
          <a:xfrm rot="9187987">
            <a:off x="4789487" y="3935370"/>
            <a:ext cx="193512" cy="163870"/>
          </a:xfrm>
          <a:custGeom>
            <a:avLst/>
            <a:gdLst>
              <a:gd name="connsiteX0" fmla="*/ 606921 w 606921"/>
              <a:gd name="connsiteY0" fmla="*/ 194734 h 389467"/>
              <a:gd name="connsiteX1" fmla="*/ 339796 w 606921"/>
              <a:gd name="connsiteY1" fmla="*/ 388067 h 389467"/>
              <a:gd name="connsiteX2" fmla="*/ 44073 w 606921"/>
              <a:gd name="connsiteY2" fmla="*/ 295805 h 389467"/>
              <a:gd name="connsiteX3" fmla="*/ 190773 w 606921"/>
              <a:gd name="connsiteY3" fmla="*/ 13924 h 389467"/>
              <a:gd name="connsiteX4" fmla="*/ 477220 w 606921"/>
              <a:gd name="connsiteY4" fmla="*/ 35083 h 389467"/>
              <a:gd name="connsiteX5" fmla="*/ 303461 w 606921"/>
              <a:gd name="connsiteY5" fmla="*/ 194734 h 389467"/>
              <a:gd name="connsiteX6" fmla="*/ 606921 w 606921"/>
              <a:gd name="connsiteY6" fmla="*/ 194734 h 389467"/>
              <a:gd name="connsiteX0" fmla="*/ 563462 w 563462"/>
              <a:gd name="connsiteY0" fmla="*/ 194735 h 404997"/>
              <a:gd name="connsiteX1" fmla="*/ 296337 w 563462"/>
              <a:gd name="connsiteY1" fmla="*/ 388068 h 404997"/>
              <a:gd name="connsiteX2" fmla="*/ 103087 w 563462"/>
              <a:gd name="connsiteY2" fmla="*/ 384706 h 404997"/>
              <a:gd name="connsiteX3" fmla="*/ 614 w 563462"/>
              <a:gd name="connsiteY3" fmla="*/ 295806 h 404997"/>
              <a:gd name="connsiteX4" fmla="*/ 147314 w 563462"/>
              <a:gd name="connsiteY4" fmla="*/ 13925 h 404997"/>
              <a:gd name="connsiteX5" fmla="*/ 433761 w 563462"/>
              <a:gd name="connsiteY5" fmla="*/ 35084 h 404997"/>
              <a:gd name="connsiteX6" fmla="*/ 260002 w 563462"/>
              <a:gd name="connsiteY6" fmla="*/ 194735 h 404997"/>
              <a:gd name="connsiteX7" fmla="*/ 563462 w 563462"/>
              <a:gd name="connsiteY7" fmla="*/ 194735 h 404997"/>
              <a:gd name="connsiteX0" fmla="*/ 519012 w 519012"/>
              <a:gd name="connsiteY0" fmla="*/ 189972 h 405342"/>
              <a:gd name="connsiteX1" fmla="*/ 296337 w 519012"/>
              <a:gd name="connsiteY1" fmla="*/ 388068 h 405342"/>
              <a:gd name="connsiteX2" fmla="*/ 103087 w 519012"/>
              <a:gd name="connsiteY2" fmla="*/ 384706 h 405342"/>
              <a:gd name="connsiteX3" fmla="*/ 614 w 519012"/>
              <a:gd name="connsiteY3" fmla="*/ 295806 h 405342"/>
              <a:gd name="connsiteX4" fmla="*/ 147314 w 519012"/>
              <a:gd name="connsiteY4" fmla="*/ 13925 h 405342"/>
              <a:gd name="connsiteX5" fmla="*/ 433761 w 519012"/>
              <a:gd name="connsiteY5" fmla="*/ 35084 h 405342"/>
              <a:gd name="connsiteX6" fmla="*/ 260002 w 519012"/>
              <a:gd name="connsiteY6" fmla="*/ 194735 h 405342"/>
              <a:gd name="connsiteX7" fmla="*/ 519012 w 519012"/>
              <a:gd name="connsiteY7" fmla="*/ 189972 h 405342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830 w 519830"/>
              <a:gd name="connsiteY0" fmla="*/ 186190 h 401560"/>
              <a:gd name="connsiteX1" fmla="*/ 297155 w 519830"/>
              <a:gd name="connsiteY1" fmla="*/ 384286 h 401560"/>
              <a:gd name="connsiteX2" fmla="*/ 103905 w 519830"/>
              <a:gd name="connsiteY2" fmla="*/ 380924 h 401560"/>
              <a:gd name="connsiteX3" fmla="*/ 1432 w 519830"/>
              <a:gd name="connsiteY3" fmla="*/ 292024 h 401560"/>
              <a:gd name="connsiteX4" fmla="*/ 57867 w 519830"/>
              <a:gd name="connsiteY4" fmla="*/ 125335 h 401560"/>
              <a:gd name="connsiteX5" fmla="*/ 148132 w 519830"/>
              <a:gd name="connsiteY5" fmla="*/ 10143 h 401560"/>
              <a:gd name="connsiteX6" fmla="*/ 434579 w 519830"/>
              <a:gd name="connsiteY6" fmla="*/ 31302 h 401560"/>
              <a:gd name="connsiteX7" fmla="*/ 260820 w 519830"/>
              <a:gd name="connsiteY7" fmla="*/ 190953 h 401560"/>
              <a:gd name="connsiteX8" fmla="*/ 519830 w 519830"/>
              <a:gd name="connsiteY8" fmla="*/ 186190 h 401560"/>
              <a:gd name="connsiteX0" fmla="*/ 519240 w 519240"/>
              <a:gd name="connsiteY0" fmla="*/ 186647 h 402017"/>
              <a:gd name="connsiteX1" fmla="*/ 296565 w 519240"/>
              <a:gd name="connsiteY1" fmla="*/ 384743 h 402017"/>
              <a:gd name="connsiteX2" fmla="*/ 103315 w 519240"/>
              <a:gd name="connsiteY2" fmla="*/ 381381 h 402017"/>
              <a:gd name="connsiteX3" fmla="*/ 842 w 519240"/>
              <a:gd name="connsiteY3" fmla="*/ 292481 h 402017"/>
              <a:gd name="connsiteX4" fmla="*/ 65215 w 519240"/>
              <a:gd name="connsiteY4" fmla="*/ 132142 h 402017"/>
              <a:gd name="connsiteX5" fmla="*/ 147542 w 519240"/>
              <a:gd name="connsiteY5" fmla="*/ 10600 h 402017"/>
              <a:gd name="connsiteX6" fmla="*/ 433989 w 519240"/>
              <a:gd name="connsiteY6" fmla="*/ 31759 h 402017"/>
              <a:gd name="connsiteX7" fmla="*/ 260230 w 519240"/>
              <a:gd name="connsiteY7" fmla="*/ 191410 h 402017"/>
              <a:gd name="connsiteX8" fmla="*/ 519240 w 519240"/>
              <a:gd name="connsiteY8" fmla="*/ 186647 h 40201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9318 w 519318"/>
              <a:gd name="connsiteY0" fmla="*/ 186877 h 402247"/>
              <a:gd name="connsiteX1" fmla="*/ 296643 w 519318"/>
              <a:gd name="connsiteY1" fmla="*/ 384973 h 402247"/>
              <a:gd name="connsiteX2" fmla="*/ 103393 w 519318"/>
              <a:gd name="connsiteY2" fmla="*/ 381611 h 402247"/>
              <a:gd name="connsiteX3" fmla="*/ 920 w 519318"/>
              <a:gd name="connsiteY3" fmla="*/ 292711 h 402247"/>
              <a:gd name="connsiteX4" fmla="*/ 82756 w 519318"/>
              <a:gd name="connsiteY4" fmla="*/ 135547 h 402247"/>
              <a:gd name="connsiteX5" fmla="*/ 147620 w 519318"/>
              <a:gd name="connsiteY5" fmla="*/ 10830 h 402247"/>
              <a:gd name="connsiteX6" fmla="*/ 434067 w 519318"/>
              <a:gd name="connsiteY6" fmla="*/ 31989 h 402247"/>
              <a:gd name="connsiteX7" fmla="*/ 260308 w 519318"/>
              <a:gd name="connsiteY7" fmla="*/ 191640 h 402247"/>
              <a:gd name="connsiteX8" fmla="*/ 519318 w 519318"/>
              <a:gd name="connsiteY8" fmla="*/ 186877 h 40224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519318" h="402247">
                <a:moveTo>
                  <a:pt x="519318" y="186877"/>
                </a:moveTo>
                <a:cubicBezTo>
                  <a:pt x="519318" y="285407"/>
                  <a:pt x="365964" y="352517"/>
                  <a:pt x="296643" y="384973"/>
                </a:cubicBezTo>
                <a:cubicBezTo>
                  <a:pt x="227322" y="417429"/>
                  <a:pt x="152680" y="396988"/>
                  <a:pt x="103393" y="381611"/>
                </a:cubicBezTo>
                <a:cubicBezTo>
                  <a:pt x="54106" y="366234"/>
                  <a:pt x="4360" y="333722"/>
                  <a:pt x="920" y="292711"/>
                </a:cubicBezTo>
                <a:cubicBezTo>
                  <a:pt x="-2520" y="251700"/>
                  <a:pt x="-432" y="206339"/>
                  <a:pt x="82756" y="135547"/>
                </a:cubicBezTo>
                <a:cubicBezTo>
                  <a:pt x="54818" y="40942"/>
                  <a:pt x="89068" y="28090"/>
                  <a:pt x="147620" y="10830"/>
                </a:cubicBezTo>
                <a:cubicBezTo>
                  <a:pt x="206172" y="-6430"/>
                  <a:pt x="350237" y="-5582"/>
                  <a:pt x="434067" y="31989"/>
                </a:cubicBezTo>
                <a:lnTo>
                  <a:pt x="260308" y="191640"/>
                </a:lnTo>
                <a:lnTo>
                  <a:pt x="519318" y="186877"/>
                </a:lnTo>
                <a:close/>
              </a:path>
            </a:pathLst>
          </a:cu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>
              <a:solidFill>
                <a:schemeClr val="tx1"/>
              </a:solidFill>
            </a:endParaRPr>
          </a:p>
        </p:txBody>
      </p:sp>
      <p:sp>
        <p:nvSpPr>
          <p:cNvPr id="210" name="Circular 131"/>
          <p:cNvSpPr/>
          <p:nvPr/>
        </p:nvSpPr>
        <p:spPr>
          <a:xfrm rot="2227260">
            <a:off x="4517512" y="4563048"/>
            <a:ext cx="175841" cy="136200"/>
          </a:xfrm>
          <a:custGeom>
            <a:avLst/>
            <a:gdLst>
              <a:gd name="connsiteX0" fmla="*/ 606921 w 606921"/>
              <a:gd name="connsiteY0" fmla="*/ 194734 h 389467"/>
              <a:gd name="connsiteX1" fmla="*/ 339796 w 606921"/>
              <a:gd name="connsiteY1" fmla="*/ 388067 h 389467"/>
              <a:gd name="connsiteX2" fmla="*/ 44073 w 606921"/>
              <a:gd name="connsiteY2" fmla="*/ 295805 h 389467"/>
              <a:gd name="connsiteX3" fmla="*/ 190773 w 606921"/>
              <a:gd name="connsiteY3" fmla="*/ 13924 h 389467"/>
              <a:gd name="connsiteX4" fmla="*/ 477220 w 606921"/>
              <a:gd name="connsiteY4" fmla="*/ 35083 h 389467"/>
              <a:gd name="connsiteX5" fmla="*/ 303461 w 606921"/>
              <a:gd name="connsiteY5" fmla="*/ 194734 h 389467"/>
              <a:gd name="connsiteX6" fmla="*/ 606921 w 606921"/>
              <a:gd name="connsiteY6" fmla="*/ 194734 h 389467"/>
              <a:gd name="connsiteX0" fmla="*/ 563462 w 563462"/>
              <a:gd name="connsiteY0" fmla="*/ 194735 h 404997"/>
              <a:gd name="connsiteX1" fmla="*/ 296337 w 563462"/>
              <a:gd name="connsiteY1" fmla="*/ 388068 h 404997"/>
              <a:gd name="connsiteX2" fmla="*/ 103087 w 563462"/>
              <a:gd name="connsiteY2" fmla="*/ 384706 h 404997"/>
              <a:gd name="connsiteX3" fmla="*/ 614 w 563462"/>
              <a:gd name="connsiteY3" fmla="*/ 295806 h 404997"/>
              <a:gd name="connsiteX4" fmla="*/ 147314 w 563462"/>
              <a:gd name="connsiteY4" fmla="*/ 13925 h 404997"/>
              <a:gd name="connsiteX5" fmla="*/ 433761 w 563462"/>
              <a:gd name="connsiteY5" fmla="*/ 35084 h 404997"/>
              <a:gd name="connsiteX6" fmla="*/ 260002 w 563462"/>
              <a:gd name="connsiteY6" fmla="*/ 194735 h 404997"/>
              <a:gd name="connsiteX7" fmla="*/ 563462 w 563462"/>
              <a:gd name="connsiteY7" fmla="*/ 194735 h 404997"/>
              <a:gd name="connsiteX0" fmla="*/ 519012 w 519012"/>
              <a:gd name="connsiteY0" fmla="*/ 189972 h 405342"/>
              <a:gd name="connsiteX1" fmla="*/ 296337 w 519012"/>
              <a:gd name="connsiteY1" fmla="*/ 388068 h 405342"/>
              <a:gd name="connsiteX2" fmla="*/ 103087 w 519012"/>
              <a:gd name="connsiteY2" fmla="*/ 384706 h 405342"/>
              <a:gd name="connsiteX3" fmla="*/ 614 w 519012"/>
              <a:gd name="connsiteY3" fmla="*/ 295806 h 405342"/>
              <a:gd name="connsiteX4" fmla="*/ 147314 w 519012"/>
              <a:gd name="connsiteY4" fmla="*/ 13925 h 405342"/>
              <a:gd name="connsiteX5" fmla="*/ 433761 w 519012"/>
              <a:gd name="connsiteY5" fmla="*/ 35084 h 405342"/>
              <a:gd name="connsiteX6" fmla="*/ 260002 w 519012"/>
              <a:gd name="connsiteY6" fmla="*/ 194735 h 405342"/>
              <a:gd name="connsiteX7" fmla="*/ 519012 w 519012"/>
              <a:gd name="connsiteY7" fmla="*/ 189972 h 405342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830 w 519830"/>
              <a:gd name="connsiteY0" fmla="*/ 186190 h 401560"/>
              <a:gd name="connsiteX1" fmla="*/ 297155 w 519830"/>
              <a:gd name="connsiteY1" fmla="*/ 384286 h 401560"/>
              <a:gd name="connsiteX2" fmla="*/ 103905 w 519830"/>
              <a:gd name="connsiteY2" fmla="*/ 380924 h 401560"/>
              <a:gd name="connsiteX3" fmla="*/ 1432 w 519830"/>
              <a:gd name="connsiteY3" fmla="*/ 292024 h 401560"/>
              <a:gd name="connsiteX4" fmla="*/ 57867 w 519830"/>
              <a:gd name="connsiteY4" fmla="*/ 125335 h 401560"/>
              <a:gd name="connsiteX5" fmla="*/ 148132 w 519830"/>
              <a:gd name="connsiteY5" fmla="*/ 10143 h 401560"/>
              <a:gd name="connsiteX6" fmla="*/ 434579 w 519830"/>
              <a:gd name="connsiteY6" fmla="*/ 31302 h 401560"/>
              <a:gd name="connsiteX7" fmla="*/ 260820 w 519830"/>
              <a:gd name="connsiteY7" fmla="*/ 190953 h 401560"/>
              <a:gd name="connsiteX8" fmla="*/ 519830 w 519830"/>
              <a:gd name="connsiteY8" fmla="*/ 186190 h 401560"/>
              <a:gd name="connsiteX0" fmla="*/ 519240 w 519240"/>
              <a:gd name="connsiteY0" fmla="*/ 186647 h 402017"/>
              <a:gd name="connsiteX1" fmla="*/ 296565 w 519240"/>
              <a:gd name="connsiteY1" fmla="*/ 384743 h 402017"/>
              <a:gd name="connsiteX2" fmla="*/ 103315 w 519240"/>
              <a:gd name="connsiteY2" fmla="*/ 381381 h 402017"/>
              <a:gd name="connsiteX3" fmla="*/ 842 w 519240"/>
              <a:gd name="connsiteY3" fmla="*/ 292481 h 402017"/>
              <a:gd name="connsiteX4" fmla="*/ 65215 w 519240"/>
              <a:gd name="connsiteY4" fmla="*/ 132142 h 402017"/>
              <a:gd name="connsiteX5" fmla="*/ 147542 w 519240"/>
              <a:gd name="connsiteY5" fmla="*/ 10600 h 402017"/>
              <a:gd name="connsiteX6" fmla="*/ 433989 w 519240"/>
              <a:gd name="connsiteY6" fmla="*/ 31759 h 402017"/>
              <a:gd name="connsiteX7" fmla="*/ 260230 w 519240"/>
              <a:gd name="connsiteY7" fmla="*/ 191410 h 402017"/>
              <a:gd name="connsiteX8" fmla="*/ 519240 w 519240"/>
              <a:gd name="connsiteY8" fmla="*/ 186647 h 40201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9318 w 519318"/>
              <a:gd name="connsiteY0" fmla="*/ 186877 h 402247"/>
              <a:gd name="connsiteX1" fmla="*/ 296643 w 519318"/>
              <a:gd name="connsiteY1" fmla="*/ 384973 h 402247"/>
              <a:gd name="connsiteX2" fmla="*/ 103393 w 519318"/>
              <a:gd name="connsiteY2" fmla="*/ 381611 h 402247"/>
              <a:gd name="connsiteX3" fmla="*/ 920 w 519318"/>
              <a:gd name="connsiteY3" fmla="*/ 292711 h 402247"/>
              <a:gd name="connsiteX4" fmla="*/ 82756 w 519318"/>
              <a:gd name="connsiteY4" fmla="*/ 135547 h 402247"/>
              <a:gd name="connsiteX5" fmla="*/ 147620 w 519318"/>
              <a:gd name="connsiteY5" fmla="*/ 10830 h 402247"/>
              <a:gd name="connsiteX6" fmla="*/ 434067 w 519318"/>
              <a:gd name="connsiteY6" fmla="*/ 31989 h 402247"/>
              <a:gd name="connsiteX7" fmla="*/ 260308 w 519318"/>
              <a:gd name="connsiteY7" fmla="*/ 191640 h 402247"/>
              <a:gd name="connsiteX8" fmla="*/ 519318 w 519318"/>
              <a:gd name="connsiteY8" fmla="*/ 186877 h 40224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519318" h="402247">
                <a:moveTo>
                  <a:pt x="519318" y="186877"/>
                </a:moveTo>
                <a:cubicBezTo>
                  <a:pt x="519318" y="285407"/>
                  <a:pt x="365964" y="352517"/>
                  <a:pt x="296643" y="384973"/>
                </a:cubicBezTo>
                <a:cubicBezTo>
                  <a:pt x="227322" y="417429"/>
                  <a:pt x="152680" y="396988"/>
                  <a:pt x="103393" y="381611"/>
                </a:cubicBezTo>
                <a:cubicBezTo>
                  <a:pt x="54106" y="366234"/>
                  <a:pt x="4360" y="333722"/>
                  <a:pt x="920" y="292711"/>
                </a:cubicBezTo>
                <a:cubicBezTo>
                  <a:pt x="-2520" y="251700"/>
                  <a:pt x="-432" y="206339"/>
                  <a:pt x="82756" y="135547"/>
                </a:cubicBezTo>
                <a:cubicBezTo>
                  <a:pt x="54818" y="40942"/>
                  <a:pt x="89068" y="28090"/>
                  <a:pt x="147620" y="10830"/>
                </a:cubicBezTo>
                <a:cubicBezTo>
                  <a:pt x="206172" y="-6430"/>
                  <a:pt x="350237" y="-5582"/>
                  <a:pt x="434067" y="31989"/>
                </a:cubicBezTo>
                <a:lnTo>
                  <a:pt x="260308" y="191640"/>
                </a:lnTo>
                <a:lnTo>
                  <a:pt x="519318" y="186877"/>
                </a:lnTo>
                <a:close/>
              </a:path>
            </a:pathLst>
          </a:cu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>
              <a:solidFill>
                <a:schemeClr val="tx1"/>
              </a:solidFill>
            </a:endParaRPr>
          </a:p>
        </p:txBody>
      </p:sp>
      <p:grpSp>
        <p:nvGrpSpPr>
          <p:cNvPr id="213" name="Grupo 212"/>
          <p:cNvGrpSpPr/>
          <p:nvPr/>
        </p:nvGrpSpPr>
        <p:grpSpPr>
          <a:xfrm rot="4560000" flipV="1">
            <a:off x="6714484" y="4496060"/>
            <a:ext cx="62100" cy="106542"/>
            <a:chOff x="4953375" y="7221921"/>
            <a:chExt cx="82800" cy="142056"/>
          </a:xfrm>
        </p:grpSpPr>
        <p:sp>
          <p:nvSpPr>
            <p:cNvPr id="214" name="Rectángulo 213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215" name="Conector recto 214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16" name="Circular 131"/>
          <p:cNvSpPr/>
          <p:nvPr/>
        </p:nvSpPr>
        <p:spPr>
          <a:xfrm rot="12412013" flipH="1">
            <a:off x="6245128" y="3813751"/>
            <a:ext cx="175841" cy="136200"/>
          </a:xfrm>
          <a:custGeom>
            <a:avLst/>
            <a:gdLst>
              <a:gd name="connsiteX0" fmla="*/ 606921 w 606921"/>
              <a:gd name="connsiteY0" fmla="*/ 194734 h 389467"/>
              <a:gd name="connsiteX1" fmla="*/ 339796 w 606921"/>
              <a:gd name="connsiteY1" fmla="*/ 388067 h 389467"/>
              <a:gd name="connsiteX2" fmla="*/ 44073 w 606921"/>
              <a:gd name="connsiteY2" fmla="*/ 295805 h 389467"/>
              <a:gd name="connsiteX3" fmla="*/ 190773 w 606921"/>
              <a:gd name="connsiteY3" fmla="*/ 13924 h 389467"/>
              <a:gd name="connsiteX4" fmla="*/ 477220 w 606921"/>
              <a:gd name="connsiteY4" fmla="*/ 35083 h 389467"/>
              <a:gd name="connsiteX5" fmla="*/ 303461 w 606921"/>
              <a:gd name="connsiteY5" fmla="*/ 194734 h 389467"/>
              <a:gd name="connsiteX6" fmla="*/ 606921 w 606921"/>
              <a:gd name="connsiteY6" fmla="*/ 194734 h 389467"/>
              <a:gd name="connsiteX0" fmla="*/ 563462 w 563462"/>
              <a:gd name="connsiteY0" fmla="*/ 194735 h 404997"/>
              <a:gd name="connsiteX1" fmla="*/ 296337 w 563462"/>
              <a:gd name="connsiteY1" fmla="*/ 388068 h 404997"/>
              <a:gd name="connsiteX2" fmla="*/ 103087 w 563462"/>
              <a:gd name="connsiteY2" fmla="*/ 384706 h 404997"/>
              <a:gd name="connsiteX3" fmla="*/ 614 w 563462"/>
              <a:gd name="connsiteY3" fmla="*/ 295806 h 404997"/>
              <a:gd name="connsiteX4" fmla="*/ 147314 w 563462"/>
              <a:gd name="connsiteY4" fmla="*/ 13925 h 404997"/>
              <a:gd name="connsiteX5" fmla="*/ 433761 w 563462"/>
              <a:gd name="connsiteY5" fmla="*/ 35084 h 404997"/>
              <a:gd name="connsiteX6" fmla="*/ 260002 w 563462"/>
              <a:gd name="connsiteY6" fmla="*/ 194735 h 404997"/>
              <a:gd name="connsiteX7" fmla="*/ 563462 w 563462"/>
              <a:gd name="connsiteY7" fmla="*/ 194735 h 404997"/>
              <a:gd name="connsiteX0" fmla="*/ 519012 w 519012"/>
              <a:gd name="connsiteY0" fmla="*/ 189972 h 405342"/>
              <a:gd name="connsiteX1" fmla="*/ 296337 w 519012"/>
              <a:gd name="connsiteY1" fmla="*/ 388068 h 405342"/>
              <a:gd name="connsiteX2" fmla="*/ 103087 w 519012"/>
              <a:gd name="connsiteY2" fmla="*/ 384706 h 405342"/>
              <a:gd name="connsiteX3" fmla="*/ 614 w 519012"/>
              <a:gd name="connsiteY3" fmla="*/ 295806 h 405342"/>
              <a:gd name="connsiteX4" fmla="*/ 147314 w 519012"/>
              <a:gd name="connsiteY4" fmla="*/ 13925 h 405342"/>
              <a:gd name="connsiteX5" fmla="*/ 433761 w 519012"/>
              <a:gd name="connsiteY5" fmla="*/ 35084 h 405342"/>
              <a:gd name="connsiteX6" fmla="*/ 260002 w 519012"/>
              <a:gd name="connsiteY6" fmla="*/ 194735 h 405342"/>
              <a:gd name="connsiteX7" fmla="*/ 519012 w 519012"/>
              <a:gd name="connsiteY7" fmla="*/ 189972 h 405342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830 w 519830"/>
              <a:gd name="connsiteY0" fmla="*/ 186190 h 401560"/>
              <a:gd name="connsiteX1" fmla="*/ 297155 w 519830"/>
              <a:gd name="connsiteY1" fmla="*/ 384286 h 401560"/>
              <a:gd name="connsiteX2" fmla="*/ 103905 w 519830"/>
              <a:gd name="connsiteY2" fmla="*/ 380924 h 401560"/>
              <a:gd name="connsiteX3" fmla="*/ 1432 w 519830"/>
              <a:gd name="connsiteY3" fmla="*/ 292024 h 401560"/>
              <a:gd name="connsiteX4" fmla="*/ 57867 w 519830"/>
              <a:gd name="connsiteY4" fmla="*/ 125335 h 401560"/>
              <a:gd name="connsiteX5" fmla="*/ 148132 w 519830"/>
              <a:gd name="connsiteY5" fmla="*/ 10143 h 401560"/>
              <a:gd name="connsiteX6" fmla="*/ 434579 w 519830"/>
              <a:gd name="connsiteY6" fmla="*/ 31302 h 401560"/>
              <a:gd name="connsiteX7" fmla="*/ 260820 w 519830"/>
              <a:gd name="connsiteY7" fmla="*/ 190953 h 401560"/>
              <a:gd name="connsiteX8" fmla="*/ 519830 w 519830"/>
              <a:gd name="connsiteY8" fmla="*/ 186190 h 401560"/>
              <a:gd name="connsiteX0" fmla="*/ 519240 w 519240"/>
              <a:gd name="connsiteY0" fmla="*/ 186647 h 402017"/>
              <a:gd name="connsiteX1" fmla="*/ 296565 w 519240"/>
              <a:gd name="connsiteY1" fmla="*/ 384743 h 402017"/>
              <a:gd name="connsiteX2" fmla="*/ 103315 w 519240"/>
              <a:gd name="connsiteY2" fmla="*/ 381381 h 402017"/>
              <a:gd name="connsiteX3" fmla="*/ 842 w 519240"/>
              <a:gd name="connsiteY3" fmla="*/ 292481 h 402017"/>
              <a:gd name="connsiteX4" fmla="*/ 65215 w 519240"/>
              <a:gd name="connsiteY4" fmla="*/ 132142 h 402017"/>
              <a:gd name="connsiteX5" fmla="*/ 147542 w 519240"/>
              <a:gd name="connsiteY5" fmla="*/ 10600 h 402017"/>
              <a:gd name="connsiteX6" fmla="*/ 433989 w 519240"/>
              <a:gd name="connsiteY6" fmla="*/ 31759 h 402017"/>
              <a:gd name="connsiteX7" fmla="*/ 260230 w 519240"/>
              <a:gd name="connsiteY7" fmla="*/ 191410 h 402017"/>
              <a:gd name="connsiteX8" fmla="*/ 519240 w 519240"/>
              <a:gd name="connsiteY8" fmla="*/ 186647 h 40201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9318 w 519318"/>
              <a:gd name="connsiteY0" fmla="*/ 186877 h 402247"/>
              <a:gd name="connsiteX1" fmla="*/ 296643 w 519318"/>
              <a:gd name="connsiteY1" fmla="*/ 384973 h 402247"/>
              <a:gd name="connsiteX2" fmla="*/ 103393 w 519318"/>
              <a:gd name="connsiteY2" fmla="*/ 381611 h 402247"/>
              <a:gd name="connsiteX3" fmla="*/ 920 w 519318"/>
              <a:gd name="connsiteY3" fmla="*/ 292711 h 402247"/>
              <a:gd name="connsiteX4" fmla="*/ 82756 w 519318"/>
              <a:gd name="connsiteY4" fmla="*/ 135547 h 402247"/>
              <a:gd name="connsiteX5" fmla="*/ 147620 w 519318"/>
              <a:gd name="connsiteY5" fmla="*/ 10830 h 402247"/>
              <a:gd name="connsiteX6" fmla="*/ 434067 w 519318"/>
              <a:gd name="connsiteY6" fmla="*/ 31989 h 402247"/>
              <a:gd name="connsiteX7" fmla="*/ 260308 w 519318"/>
              <a:gd name="connsiteY7" fmla="*/ 191640 h 402247"/>
              <a:gd name="connsiteX8" fmla="*/ 519318 w 519318"/>
              <a:gd name="connsiteY8" fmla="*/ 186877 h 40224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519318" h="402247">
                <a:moveTo>
                  <a:pt x="519318" y="186877"/>
                </a:moveTo>
                <a:cubicBezTo>
                  <a:pt x="519318" y="285407"/>
                  <a:pt x="365964" y="352517"/>
                  <a:pt x="296643" y="384973"/>
                </a:cubicBezTo>
                <a:cubicBezTo>
                  <a:pt x="227322" y="417429"/>
                  <a:pt x="152680" y="396988"/>
                  <a:pt x="103393" y="381611"/>
                </a:cubicBezTo>
                <a:cubicBezTo>
                  <a:pt x="54106" y="366234"/>
                  <a:pt x="4360" y="333722"/>
                  <a:pt x="920" y="292711"/>
                </a:cubicBezTo>
                <a:cubicBezTo>
                  <a:pt x="-2520" y="251700"/>
                  <a:pt x="-432" y="206339"/>
                  <a:pt x="82756" y="135547"/>
                </a:cubicBezTo>
                <a:cubicBezTo>
                  <a:pt x="54818" y="40942"/>
                  <a:pt x="89068" y="28090"/>
                  <a:pt x="147620" y="10830"/>
                </a:cubicBezTo>
                <a:cubicBezTo>
                  <a:pt x="206172" y="-6430"/>
                  <a:pt x="350237" y="-5582"/>
                  <a:pt x="434067" y="31989"/>
                </a:cubicBezTo>
                <a:lnTo>
                  <a:pt x="260308" y="191640"/>
                </a:lnTo>
                <a:lnTo>
                  <a:pt x="519318" y="186877"/>
                </a:lnTo>
                <a:close/>
              </a:path>
            </a:pathLst>
          </a:cu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>
              <a:solidFill>
                <a:schemeClr val="tx1"/>
              </a:solidFill>
            </a:endParaRPr>
          </a:p>
        </p:txBody>
      </p:sp>
      <p:sp>
        <p:nvSpPr>
          <p:cNvPr id="217" name="Circular 131"/>
          <p:cNvSpPr/>
          <p:nvPr/>
        </p:nvSpPr>
        <p:spPr>
          <a:xfrm rot="19372740" flipH="1">
            <a:off x="6777039" y="4645673"/>
            <a:ext cx="175841" cy="136200"/>
          </a:xfrm>
          <a:custGeom>
            <a:avLst/>
            <a:gdLst>
              <a:gd name="connsiteX0" fmla="*/ 606921 w 606921"/>
              <a:gd name="connsiteY0" fmla="*/ 194734 h 389467"/>
              <a:gd name="connsiteX1" fmla="*/ 339796 w 606921"/>
              <a:gd name="connsiteY1" fmla="*/ 388067 h 389467"/>
              <a:gd name="connsiteX2" fmla="*/ 44073 w 606921"/>
              <a:gd name="connsiteY2" fmla="*/ 295805 h 389467"/>
              <a:gd name="connsiteX3" fmla="*/ 190773 w 606921"/>
              <a:gd name="connsiteY3" fmla="*/ 13924 h 389467"/>
              <a:gd name="connsiteX4" fmla="*/ 477220 w 606921"/>
              <a:gd name="connsiteY4" fmla="*/ 35083 h 389467"/>
              <a:gd name="connsiteX5" fmla="*/ 303461 w 606921"/>
              <a:gd name="connsiteY5" fmla="*/ 194734 h 389467"/>
              <a:gd name="connsiteX6" fmla="*/ 606921 w 606921"/>
              <a:gd name="connsiteY6" fmla="*/ 194734 h 389467"/>
              <a:gd name="connsiteX0" fmla="*/ 563462 w 563462"/>
              <a:gd name="connsiteY0" fmla="*/ 194735 h 404997"/>
              <a:gd name="connsiteX1" fmla="*/ 296337 w 563462"/>
              <a:gd name="connsiteY1" fmla="*/ 388068 h 404997"/>
              <a:gd name="connsiteX2" fmla="*/ 103087 w 563462"/>
              <a:gd name="connsiteY2" fmla="*/ 384706 h 404997"/>
              <a:gd name="connsiteX3" fmla="*/ 614 w 563462"/>
              <a:gd name="connsiteY3" fmla="*/ 295806 h 404997"/>
              <a:gd name="connsiteX4" fmla="*/ 147314 w 563462"/>
              <a:gd name="connsiteY4" fmla="*/ 13925 h 404997"/>
              <a:gd name="connsiteX5" fmla="*/ 433761 w 563462"/>
              <a:gd name="connsiteY5" fmla="*/ 35084 h 404997"/>
              <a:gd name="connsiteX6" fmla="*/ 260002 w 563462"/>
              <a:gd name="connsiteY6" fmla="*/ 194735 h 404997"/>
              <a:gd name="connsiteX7" fmla="*/ 563462 w 563462"/>
              <a:gd name="connsiteY7" fmla="*/ 194735 h 404997"/>
              <a:gd name="connsiteX0" fmla="*/ 519012 w 519012"/>
              <a:gd name="connsiteY0" fmla="*/ 189972 h 405342"/>
              <a:gd name="connsiteX1" fmla="*/ 296337 w 519012"/>
              <a:gd name="connsiteY1" fmla="*/ 388068 h 405342"/>
              <a:gd name="connsiteX2" fmla="*/ 103087 w 519012"/>
              <a:gd name="connsiteY2" fmla="*/ 384706 h 405342"/>
              <a:gd name="connsiteX3" fmla="*/ 614 w 519012"/>
              <a:gd name="connsiteY3" fmla="*/ 295806 h 405342"/>
              <a:gd name="connsiteX4" fmla="*/ 147314 w 519012"/>
              <a:gd name="connsiteY4" fmla="*/ 13925 h 405342"/>
              <a:gd name="connsiteX5" fmla="*/ 433761 w 519012"/>
              <a:gd name="connsiteY5" fmla="*/ 35084 h 405342"/>
              <a:gd name="connsiteX6" fmla="*/ 260002 w 519012"/>
              <a:gd name="connsiteY6" fmla="*/ 194735 h 405342"/>
              <a:gd name="connsiteX7" fmla="*/ 519012 w 519012"/>
              <a:gd name="connsiteY7" fmla="*/ 189972 h 405342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830 w 519830"/>
              <a:gd name="connsiteY0" fmla="*/ 186190 h 401560"/>
              <a:gd name="connsiteX1" fmla="*/ 297155 w 519830"/>
              <a:gd name="connsiteY1" fmla="*/ 384286 h 401560"/>
              <a:gd name="connsiteX2" fmla="*/ 103905 w 519830"/>
              <a:gd name="connsiteY2" fmla="*/ 380924 h 401560"/>
              <a:gd name="connsiteX3" fmla="*/ 1432 w 519830"/>
              <a:gd name="connsiteY3" fmla="*/ 292024 h 401560"/>
              <a:gd name="connsiteX4" fmla="*/ 57867 w 519830"/>
              <a:gd name="connsiteY4" fmla="*/ 125335 h 401560"/>
              <a:gd name="connsiteX5" fmla="*/ 148132 w 519830"/>
              <a:gd name="connsiteY5" fmla="*/ 10143 h 401560"/>
              <a:gd name="connsiteX6" fmla="*/ 434579 w 519830"/>
              <a:gd name="connsiteY6" fmla="*/ 31302 h 401560"/>
              <a:gd name="connsiteX7" fmla="*/ 260820 w 519830"/>
              <a:gd name="connsiteY7" fmla="*/ 190953 h 401560"/>
              <a:gd name="connsiteX8" fmla="*/ 519830 w 519830"/>
              <a:gd name="connsiteY8" fmla="*/ 186190 h 401560"/>
              <a:gd name="connsiteX0" fmla="*/ 519240 w 519240"/>
              <a:gd name="connsiteY0" fmla="*/ 186647 h 402017"/>
              <a:gd name="connsiteX1" fmla="*/ 296565 w 519240"/>
              <a:gd name="connsiteY1" fmla="*/ 384743 h 402017"/>
              <a:gd name="connsiteX2" fmla="*/ 103315 w 519240"/>
              <a:gd name="connsiteY2" fmla="*/ 381381 h 402017"/>
              <a:gd name="connsiteX3" fmla="*/ 842 w 519240"/>
              <a:gd name="connsiteY3" fmla="*/ 292481 h 402017"/>
              <a:gd name="connsiteX4" fmla="*/ 65215 w 519240"/>
              <a:gd name="connsiteY4" fmla="*/ 132142 h 402017"/>
              <a:gd name="connsiteX5" fmla="*/ 147542 w 519240"/>
              <a:gd name="connsiteY5" fmla="*/ 10600 h 402017"/>
              <a:gd name="connsiteX6" fmla="*/ 433989 w 519240"/>
              <a:gd name="connsiteY6" fmla="*/ 31759 h 402017"/>
              <a:gd name="connsiteX7" fmla="*/ 260230 w 519240"/>
              <a:gd name="connsiteY7" fmla="*/ 191410 h 402017"/>
              <a:gd name="connsiteX8" fmla="*/ 519240 w 519240"/>
              <a:gd name="connsiteY8" fmla="*/ 186647 h 40201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9318 w 519318"/>
              <a:gd name="connsiteY0" fmla="*/ 186877 h 402247"/>
              <a:gd name="connsiteX1" fmla="*/ 296643 w 519318"/>
              <a:gd name="connsiteY1" fmla="*/ 384973 h 402247"/>
              <a:gd name="connsiteX2" fmla="*/ 103393 w 519318"/>
              <a:gd name="connsiteY2" fmla="*/ 381611 h 402247"/>
              <a:gd name="connsiteX3" fmla="*/ 920 w 519318"/>
              <a:gd name="connsiteY3" fmla="*/ 292711 h 402247"/>
              <a:gd name="connsiteX4" fmla="*/ 82756 w 519318"/>
              <a:gd name="connsiteY4" fmla="*/ 135547 h 402247"/>
              <a:gd name="connsiteX5" fmla="*/ 147620 w 519318"/>
              <a:gd name="connsiteY5" fmla="*/ 10830 h 402247"/>
              <a:gd name="connsiteX6" fmla="*/ 434067 w 519318"/>
              <a:gd name="connsiteY6" fmla="*/ 31989 h 402247"/>
              <a:gd name="connsiteX7" fmla="*/ 260308 w 519318"/>
              <a:gd name="connsiteY7" fmla="*/ 191640 h 402247"/>
              <a:gd name="connsiteX8" fmla="*/ 519318 w 519318"/>
              <a:gd name="connsiteY8" fmla="*/ 186877 h 40224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519318" h="402247">
                <a:moveTo>
                  <a:pt x="519318" y="186877"/>
                </a:moveTo>
                <a:cubicBezTo>
                  <a:pt x="519318" y="285407"/>
                  <a:pt x="365964" y="352517"/>
                  <a:pt x="296643" y="384973"/>
                </a:cubicBezTo>
                <a:cubicBezTo>
                  <a:pt x="227322" y="417429"/>
                  <a:pt x="152680" y="396988"/>
                  <a:pt x="103393" y="381611"/>
                </a:cubicBezTo>
                <a:cubicBezTo>
                  <a:pt x="54106" y="366234"/>
                  <a:pt x="4360" y="333722"/>
                  <a:pt x="920" y="292711"/>
                </a:cubicBezTo>
                <a:cubicBezTo>
                  <a:pt x="-2520" y="251700"/>
                  <a:pt x="-432" y="206339"/>
                  <a:pt x="82756" y="135547"/>
                </a:cubicBezTo>
                <a:cubicBezTo>
                  <a:pt x="54818" y="40942"/>
                  <a:pt x="89068" y="28090"/>
                  <a:pt x="147620" y="10830"/>
                </a:cubicBezTo>
                <a:cubicBezTo>
                  <a:pt x="206172" y="-6430"/>
                  <a:pt x="350237" y="-5582"/>
                  <a:pt x="434067" y="31989"/>
                </a:cubicBezTo>
                <a:lnTo>
                  <a:pt x="260308" y="191640"/>
                </a:lnTo>
                <a:lnTo>
                  <a:pt x="519318" y="186877"/>
                </a:lnTo>
                <a:close/>
              </a:path>
            </a:pathLst>
          </a:cu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>
              <a:solidFill>
                <a:schemeClr val="tx1"/>
              </a:solidFill>
            </a:endParaRPr>
          </a:p>
        </p:txBody>
      </p:sp>
      <p:sp>
        <p:nvSpPr>
          <p:cNvPr id="218" name="Rectángulo 217"/>
          <p:cNvSpPr/>
          <p:nvPr/>
        </p:nvSpPr>
        <p:spPr>
          <a:xfrm>
            <a:off x="7280298" y="3618439"/>
            <a:ext cx="434983" cy="80864"/>
          </a:xfrm>
          <a:prstGeom prst="rect">
            <a:avLst/>
          </a:prstGeom>
          <a:solidFill>
            <a:srgbClr val="800080"/>
          </a:solidFill>
          <a:ln>
            <a:solidFill>
              <a:srgbClr val="800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cxnSp>
        <p:nvCxnSpPr>
          <p:cNvPr id="219" name="Conector recto 218"/>
          <p:cNvCxnSpPr/>
          <p:nvPr/>
        </p:nvCxnSpPr>
        <p:spPr>
          <a:xfrm flipV="1">
            <a:off x="7277401" y="3718910"/>
            <a:ext cx="445500" cy="3810"/>
          </a:xfrm>
          <a:prstGeom prst="line">
            <a:avLst/>
          </a:prstGeom>
          <a:ln w="57150">
            <a:solidFill>
              <a:srgbClr val="00CC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0" name="Rectángulo 219"/>
          <p:cNvSpPr/>
          <p:nvPr/>
        </p:nvSpPr>
        <p:spPr>
          <a:xfrm rot="10800000">
            <a:off x="7311043" y="4869302"/>
            <a:ext cx="434983" cy="80864"/>
          </a:xfrm>
          <a:prstGeom prst="rect">
            <a:avLst/>
          </a:prstGeom>
          <a:solidFill>
            <a:srgbClr val="800080"/>
          </a:solidFill>
          <a:ln>
            <a:solidFill>
              <a:srgbClr val="800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cxnSp>
        <p:nvCxnSpPr>
          <p:cNvPr id="221" name="Conector recto 220"/>
          <p:cNvCxnSpPr/>
          <p:nvPr/>
        </p:nvCxnSpPr>
        <p:spPr>
          <a:xfrm rot="10800000" flipV="1">
            <a:off x="7305565" y="4842982"/>
            <a:ext cx="445500" cy="3810"/>
          </a:xfrm>
          <a:prstGeom prst="line">
            <a:avLst/>
          </a:prstGeom>
          <a:ln w="57150">
            <a:solidFill>
              <a:srgbClr val="00CC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31" name="Grupo 230"/>
          <p:cNvGrpSpPr/>
          <p:nvPr/>
        </p:nvGrpSpPr>
        <p:grpSpPr>
          <a:xfrm>
            <a:off x="7533901" y="3756588"/>
            <a:ext cx="189000" cy="130469"/>
            <a:chOff x="4079020" y="6879809"/>
            <a:chExt cx="252000" cy="173958"/>
          </a:xfrm>
        </p:grpSpPr>
        <p:sp>
          <p:nvSpPr>
            <p:cNvPr id="232" name="Forma libre 231"/>
            <p:cNvSpPr/>
            <p:nvPr/>
          </p:nvSpPr>
          <p:spPr>
            <a:xfrm rot="21480000" flipV="1">
              <a:off x="4080439" y="6908435"/>
              <a:ext cx="249698" cy="145332"/>
            </a:xfrm>
            <a:custGeom>
              <a:avLst/>
              <a:gdLst>
                <a:gd name="connsiteX0" fmla="*/ 101600 w 485775"/>
                <a:gd name="connsiteY0" fmla="*/ 79375 h 177800"/>
                <a:gd name="connsiteX1" fmla="*/ 485775 w 485775"/>
                <a:gd name="connsiteY1" fmla="*/ 76200 h 177800"/>
                <a:gd name="connsiteX2" fmla="*/ 482600 w 485775"/>
                <a:gd name="connsiteY2" fmla="*/ 174625 h 177800"/>
                <a:gd name="connsiteX3" fmla="*/ 0 w 485775"/>
                <a:gd name="connsiteY3" fmla="*/ 177800 h 177800"/>
                <a:gd name="connsiteX4" fmla="*/ 82550 w 485775"/>
                <a:gd name="connsiteY4" fmla="*/ 0 h 177800"/>
                <a:gd name="connsiteX5" fmla="*/ 101600 w 485775"/>
                <a:gd name="connsiteY5" fmla="*/ 79375 h 177800"/>
                <a:gd name="connsiteX0" fmla="*/ 196850 w 581025"/>
                <a:gd name="connsiteY0" fmla="*/ 79375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96850 w 581025"/>
                <a:gd name="connsiteY5" fmla="*/ 79375 h 187325"/>
                <a:gd name="connsiteX0" fmla="*/ 177800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77800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263089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63089 w 581025"/>
                <a:gd name="connsiteY5" fmla="*/ 82550 h 187325"/>
                <a:gd name="connsiteX0" fmla="*/ 289741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89741 w 581025"/>
                <a:gd name="connsiteY5" fmla="*/ 82550 h 187325"/>
                <a:gd name="connsiteX0" fmla="*/ 289741 w 581025"/>
                <a:gd name="connsiteY0" fmla="*/ 91494 h 196269"/>
                <a:gd name="connsiteX1" fmla="*/ 581025 w 581025"/>
                <a:gd name="connsiteY1" fmla="*/ 85144 h 196269"/>
                <a:gd name="connsiteX2" fmla="*/ 577850 w 581025"/>
                <a:gd name="connsiteY2" fmla="*/ 183569 h 196269"/>
                <a:gd name="connsiteX3" fmla="*/ 0 w 581025"/>
                <a:gd name="connsiteY3" fmla="*/ 196269 h 196269"/>
                <a:gd name="connsiteX4" fmla="*/ 295072 w 581025"/>
                <a:gd name="connsiteY4" fmla="*/ 0 h 196269"/>
                <a:gd name="connsiteX5" fmla="*/ 289741 w 581025"/>
                <a:gd name="connsiteY5" fmla="*/ 91494 h 1962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81025" h="196269">
                  <a:moveTo>
                    <a:pt x="289741" y="91494"/>
                  </a:moveTo>
                  <a:lnTo>
                    <a:pt x="581025" y="85144"/>
                  </a:lnTo>
                  <a:lnTo>
                    <a:pt x="577850" y="183569"/>
                  </a:lnTo>
                  <a:lnTo>
                    <a:pt x="0" y="196269"/>
                  </a:lnTo>
                  <a:lnTo>
                    <a:pt x="295072" y="0"/>
                  </a:lnTo>
                  <a:lnTo>
                    <a:pt x="289741" y="91494"/>
                  </a:lnTo>
                  <a:close/>
                </a:path>
              </a:pathLst>
            </a:custGeom>
            <a:solidFill>
              <a:srgbClr val="92D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233" name="Conector recto 232"/>
            <p:cNvCxnSpPr/>
            <p:nvPr/>
          </p:nvCxnSpPr>
          <p:spPr>
            <a:xfrm rot="-60000">
              <a:off x="4079020" y="6879809"/>
              <a:ext cx="252000" cy="8255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34" name="Imagen 23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77" t="16601" r="40948" b="25066"/>
          <a:stretch/>
        </p:blipFill>
        <p:spPr>
          <a:xfrm>
            <a:off x="7186610" y="3547174"/>
            <a:ext cx="91418" cy="88266"/>
          </a:xfrm>
          <a:prstGeom prst="rect">
            <a:avLst/>
          </a:prstGeom>
        </p:spPr>
      </p:pic>
      <p:pic>
        <p:nvPicPr>
          <p:cNvPr id="235" name="Imagen 23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31" t="16963" r="41175" b="24703"/>
          <a:stretch/>
        </p:blipFill>
        <p:spPr>
          <a:xfrm>
            <a:off x="7715281" y="3542088"/>
            <a:ext cx="90629" cy="88265"/>
          </a:xfrm>
          <a:prstGeom prst="rect">
            <a:avLst/>
          </a:prstGeom>
        </p:spPr>
      </p:pic>
      <p:grpSp>
        <p:nvGrpSpPr>
          <p:cNvPr id="236" name="Grupo 235"/>
          <p:cNvGrpSpPr/>
          <p:nvPr/>
        </p:nvGrpSpPr>
        <p:grpSpPr>
          <a:xfrm flipH="1" flipV="1">
            <a:off x="7305440" y="4679631"/>
            <a:ext cx="189000" cy="130469"/>
            <a:chOff x="4079020" y="6879809"/>
            <a:chExt cx="252000" cy="173958"/>
          </a:xfrm>
        </p:grpSpPr>
        <p:sp>
          <p:nvSpPr>
            <p:cNvPr id="237" name="Forma libre 236"/>
            <p:cNvSpPr/>
            <p:nvPr/>
          </p:nvSpPr>
          <p:spPr>
            <a:xfrm rot="21480000" flipV="1">
              <a:off x="4080439" y="6908435"/>
              <a:ext cx="249698" cy="145332"/>
            </a:xfrm>
            <a:custGeom>
              <a:avLst/>
              <a:gdLst>
                <a:gd name="connsiteX0" fmla="*/ 101600 w 485775"/>
                <a:gd name="connsiteY0" fmla="*/ 79375 h 177800"/>
                <a:gd name="connsiteX1" fmla="*/ 485775 w 485775"/>
                <a:gd name="connsiteY1" fmla="*/ 76200 h 177800"/>
                <a:gd name="connsiteX2" fmla="*/ 482600 w 485775"/>
                <a:gd name="connsiteY2" fmla="*/ 174625 h 177800"/>
                <a:gd name="connsiteX3" fmla="*/ 0 w 485775"/>
                <a:gd name="connsiteY3" fmla="*/ 177800 h 177800"/>
                <a:gd name="connsiteX4" fmla="*/ 82550 w 485775"/>
                <a:gd name="connsiteY4" fmla="*/ 0 h 177800"/>
                <a:gd name="connsiteX5" fmla="*/ 101600 w 485775"/>
                <a:gd name="connsiteY5" fmla="*/ 79375 h 177800"/>
                <a:gd name="connsiteX0" fmla="*/ 196850 w 581025"/>
                <a:gd name="connsiteY0" fmla="*/ 79375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96850 w 581025"/>
                <a:gd name="connsiteY5" fmla="*/ 79375 h 187325"/>
                <a:gd name="connsiteX0" fmla="*/ 177800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77800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263089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63089 w 581025"/>
                <a:gd name="connsiteY5" fmla="*/ 82550 h 187325"/>
                <a:gd name="connsiteX0" fmla="*/ 289741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89741 w 581025"/>
                <a:gd name="connsiteY5" fmla="*/ 82550 h 187325"/>
                <a:gd name="connsiteX0" fmla="*/ 289741 w 581025"/>
                <a:gd name="connsiteY0" fmla="*/ 91494 h 196269"/>
                <a:gd name="connsiteX1" fmla="*/ 581025 w 581025"/>
                <a:gd name="connsiteY1" fmla="*/ 85144 h 196269"/>
                <a:gd name="connsiteX2" fmla="*/ 577850 w 581025"/>
                <a:gd name="connsiteY2" fmla="*/ 183569 h 196269"/>
                <a:gd name="connsiteX3" fmla="*/ 0 w 581025"/>
                <a:gd name="connsiteY3" fmla="*/ 196269 h 196269"/>
                <a:gd name="connsiteX4" fmla="*/ 295072 w 581025"/>
                <a:gd name="connsiteY4" fmla="*/ 0 h 196269"/>
                <a:gd name="connsiteX5" fmla="*/ 289741 w 581025"/>
                <a:gd name="connsiteY5" fmla="*/ 91494 h 1962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81025" h="196269">
                  <a:moveTo>
                    <a:pt x="289741" y="91494"/>
                  </a:moveTo>
                  <a:lnTo>
                    <a:pt x="581025" y="85144"/>
                  </a:lnTo>
                  <a:lnTo>
                    <a:pt x="577850" y="183569"/>
                  </a:lnTo>
                  <a:lnTo>
                    <a:pt x="0" y="196269"/>
                  </a:lnTo>
                  <a:lnTo>
                    <a:pt x="295072" y="0"/>
                  </a:lnTo>
                  <a:lnTo>
                    <a:pt x="289741" y="91494"/>
                  </a:lnTo>
                  <a:close/>
                </a:path>
              </a:pathLst>
            </a:custGeom>
            <a:solidFill>
              <a:srgbClr val="92D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238" name="Conector recto 237"/>
            <p:cNvCxnSpPr/>
            <p:nvPr/>
          </p:nvCxnSpPr>
          <p:spPr>
            <a:xfrm rot="-60000">
              <a:off x="4079020" y="6879809"/>
              <a:ext cx="252000" cy="8255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8" name="Grupo 247"/>
          <p:cNvGrpSpPr/>
          <p:nvPr/>
        </p:nvGrpSpPr>
        <p:grpSpPr>
          <a:xfrm rot="21540000" flipH="1" flipV="1">
            <a:off x="7330673" y="3758220"/>
            <a:ext cx="62100" cy="106542"/>
            <a:chOff x="4953375" y="7221921"/>
            <a:chExt cx="82800" cy="142056"/>
          </a:xfrm>
        </p:grpSpPr>
        <p:sp>
          <p:nvSpPr>
            <p:cNvPr id="249" name="Rectángulo 248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250" name="Conector recto 249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54" name="Imagen 25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77" t="16601" r="40948" b="25066"/>
          <a:stretch/>
        </p:blipFill>
        <p:spPr>
          <a:xfrm rot="10800000">
            <a:off x="7751065" y="4935284"/>
            <a:ext cx="91418" cy="88266"/>
          </a:xfrm>
          <a:prstGeom prst="rect">
            <a:avLst/>
          </a:prstGeom>
        </p:spPr>
      </p:pic>
      <p:pic>
        <p:nvPicPr>
          <p:cNvPr id="255" name="Imagen 25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31" t="16963" r="41175" b="24703"/>
          <a:stretch/>
        </p:blipFill>
        <p:spPr>
          <a:xfrm rot="10800000">
            <a:off x="7218109" y="4936093"/>
            <a:ext cx="90629" cy="88265"/>
          </a:xfrm>
          <a:prstGeom prst="rect">
            <a:avLst/>
          </a:prstGeom>
        </p:spPr>
      </p:pic>
      <p:sp>
        <p:nvSpPr>
          <p:cNvPr id="259" name="Circular 131"/>
          <p:cNvSpPr/>
          <p:nvPr/>
        </p:nvSpPr>
        <p:spPr>
          <a:xfrm rot="20482430" flipH="1">
            <a:off x="7175780" y="3733131"/>
            <a:ext cx="175841" cy="136200"/>
          </a:xfrm>
          <a:custGeom>
            <a:avLst/>
            <a:gdLst>
              <a:gd name="connsiteX0" fmla="*/ 606921 w 606921"/>
              <a:gd name="connsiteY0" fmla="*/ 194734 h 389467"/>
              <a:gd name="connsiteX1" fmla="*/ 339796 w 606921"/>
              <a:gd name="connsiteY1" fmla="*/ 388067 h 389467"/>
              <a:gd name="connsiteX2" fmla="*/ 44073 w 606921"/>
              <a:gd name="connsiteY2" fmla="*/ 295805 h 389467"/>
              <a:gd name="connsiteX3" fmla="*/ 190773 w 606921"/>
              <a:gd name="connsiteY3" fmla="*/ 13924 h 389467"/>
              <a:gd name="connsiteX4" fmla="*/ 477220 w 606921"/>
              <a:gd name="connsiteY4" fmla="*/ 35083 h 389467"/>
              <a:gd name="connsiteX5" fmla="*/ 303461 w 606921"/>
              <a:gd name="connsiteY5" fmla="*/ 194734 h 389467"/>
              <a:gd name="connsiteX6" fmla="*/ 606921 w 606921"/>
              <a:gd name="connsiteY6" fmla="*/ 194734 h 389467"/>
              <a:gd name="connsiteX0" fmla="*/ 563462 w 563462"/>
              <a:gd name="connsiteY0" fmla="*/ 194735 h 404997"/>
              <a:gd name="connsiteX1" fmla="*/ 296337 w 563462"/>
              <a:gd name="connsiteY1" fmla="*/ 388068 h 404997"/>
              <a:gd name="connsiteX2" fmla="*/ 103087 w 563462"/>
              <a:gd name="connsiteY2" fmla="*/ 384706 h 404997"/>
              <a:gd name="connsiteX3" fmla="*/ 614 w 563462"/>
              <a:gd name="connsiteY3" fmla="*/ 295806 h 404997"/>
              <a:gd name="connsiteX4" fmla="*/ 147314 w 563462"/>
              <a:gd name="connsiteY4" fmla="*/ 13925 h 404997"/>
              <a:gd name="connsiteX5" fmla="*/ 433761 w 563462"/>
              <a:gd name="connsiteY5" fmla="*/ 35084 h 404997"/>
              <a:gd name="connsiteX6" fmla="*/ 260002 w 563462"/>
              <a:gd name="connsiteY6" fmla="*/ 194735 h 404997"/>
              <a:gd name="connsiteX7" fmla="*/ 563462 w 563462"/>
              <a:gd name="connsiteY7" fmla="*/ 194735 h 404997"/>
              <a:gd name="connsiteX0" fmla="*/ 519012 w 519012"/>
              <a:gd name="connsiteY0" fmla="*/ 189972 h 405342"/>
              <a:gd name="connsiteX1" fmla="*/ 296337 w 519012"/>
              <a:gd name="connsiteY1" fmla="*/ 388068 h 405342"/>
              <a:gd name="connsiteX2" fmla="*/ 103087 w 519012"/>
              <a:gd name="connsiteY2" fmla="*/ 384706 h 405342"/>
              <a:gd name="connsiteX3" fmla="*/ 614 w 519012"/>
              <a:gd name="connsiteY3" fmla="*/ 295806 h 405342"/>
              <a:gd name="connsiteX4" fmla="*/ 147314 w 519012"/>
              <a:gd name="connsiteY4" fmla="*/ 13925 h 405342"/>
              <a:gd name="connsiteX5" fmla="*/ 433761 w 519012"/>
              <a:gd name="connsiteY5" fmla="*/ 35084 h 405342"/>
              <a:gd name="connsiteX6" fmla="*/ 260002 w 519012"/>
              <a:gd name="connsiteY6" fmla="*/ 194735 h 405342"/>
              <a:gd name="connsiteX7" fmla="*/ 519012 w 519012"/>
              <a:gd name="connsiteY7" fmla="*/ 189972 h 405342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830 w 519830"/>
              <a:gd name="connsiteY0" fmla="*/ 186190 h 401560"/>
              <a:gd name="connsiteX1" fmla="*/ 297155 w 519830"/>
              <a:gd name="connsiteY1" fmla="*/ 384286 h 401560"/>
              <a:gd name="connsiteX2" fmla="*/ 103905 w 519830"/>
              <a:gd name="connsiteY2" fmla="*/ 380924 h 401560"/>
              <a:gd name="connsiteX3" fmla="*/ 1432 w 519830"/>
              <a:gd name="connsiteY3" fmla="*/ 292024 h 401560"/>
              <a:gd name="connsiteX4" fmla="*/ 57867 w 519830"/>
              <a:gd name="connsiteY4" fmla="*/ 125335 h 401560"/>
              <a:gd name="connsiteX5" fmla="*/ 148132 w 519830"/>
              <a:gd name="connsiteY5" fmla="*/ 10143 h 401560"/>
              <a:gd name="connsiteX6" fmla="*/ 434579 w 519830"/>
              <a:gd name="connsiteY6" fmla="*/ 31302 h 401560"/>
              <a:gd name="connsiteX7" fmla="*/ 260820 w 519830"/>
              <a:gd name="connsiteY7" fmla="*/ 190953 h 401560"/>
              <a:gd name="connsiteX8" fmla="*/ 519830 w 519830"/>
              <a:gd name="connsiteY8" fmla="*/ 186190 h 401560"/>
              <a:gd name="connsiteX0" fmla="*/ 519240 w 519240"/>
              <a:gd name="connsiteY0" fmla="*/ 186647 h 402017"/>
              <a:gd name="connsiteX1" fmla="*/ 296565 w 519240"/>
              <a:gd name="connsiteY1" fmla="*/ 384743 h 402017"/>
              <a:gd name="connsiteX2" fmla="*/ 103315 w 519240"/>
              <a:gd name="connsiteY2" fmla="*/ 381381 h 402017"/>
              <a:gd name="connsiteX3" fmla="*/ 842 w 519240"/>
              <a:gd name="connsiteY3" fmla="*/ 292481 h 402017"/>
              <a:gd name="connsiteX4" fmla="*/ 65215 w 519240"/>
              <a:gd name="connsiteY4" fmla="*/ 132142 h 402017"/>
              <a:gd name="connsiteX5" fmla="*/ 147542 w 519240"/>
              <a:gd name="connsiteY5" fmla="*/ 10600 h 402017"/>
              <a:gd name="connsiteX6" fmla="*/ 433989 w 519240"/>
              <a:gd name="connsiteY6" fmla="*/ 31759 h 402017"/>
              <a:gd name="connsiteX7" fmla="*/ 260230 w 519240"/>
              <a:gd name="connsiteY7" fmla="*/ 191410 h 402017"/>
              <a:gd name="connsiteX8" fmla="*/ 519240 w 519240"/>
              <a:gd name="connsiteY8" fmla="*/ 186647 h 40201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9318 w 519318"/>
              <a:gd name="connsiteY0" fmla="*/ 186877 h 402247"/>
              <a:gd name="connsiteX1" fmla="*/ 296643 w 519318"/>
              <a:gd name="connsiteY1" fmla="*/ 384973 h 402247"/>
              <a:gd name="connsiteX2" fmla="*/ 103393 w 519318"/>
              <a:gd name="connsiteY2" fmla="*/ 381611 h 402247"/>
              <a:gd name="connsiteX3" fmla="*/ 920 w 519318"/>
              <a:gd name="connsiteY3" fmla="*/ 292711 h 402247"/>
              <a:gd name="connsiteX4" fmla="*/ 82756 w 519318"/>
              <a:gd name="connsiteY4" fmla="*/ 135547 h 402247"/>
              <a:gd name="connsiteX5" fmla="*/ 147620 w 519318"/>
              <a:gd name="connsiteY5" fmla="*/ 10830 h 402247"/>
              <a:gd name="connsiteX6" fmla="*/ 434067 w 519318"/>
              <a:gd name="connsiteY6" fmla="*/ 31989 h 402247"/>
              <a:gd name="connsiteX7" fmla="*/ 260308 w 519318"/>
              <a:gd name="connsiteY7" fmla="*/ 191640 h 402247"/>
              <a:gd name="connsiteX8" fmla="*/ 519318 w 519318"/>
              <a:gd name="connsiteY8" fmla="*/ 186877 h 40224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519318" h="402247">
                <a:moveTo>
                  <a:pt x="519318" y="186877"/>
                </a:moveTo>
                <a:cubicBezTo>
                  <a:pt x="519318" y="285407"/>
                  <a:pt x="365964" y="352517"/>
                  <a:pt x="296643" y="384973"/>
                </a:cubicBezTo>
                <a:cubicBezTo>
                  <a:pt x="227322" y="417429"/>
                  <a:pt x="152680" y="396988"/>
                  <a:pt x="103393" y="381611"/>
                </a:cubicBezTo>
                <a:cubicBezTo>
                  <a:pt x="54106" y="366234"/>
                  <a:pt x="4360" y="333722"/>
                  <a:pt x="920" y="292711"/>
                </a:cubicBezTo>
                <a:cubicBezTo>
                  <a:pt x="-2520" y="251700"/>
                  <a:pt x="-432" y="206339"/>
                  <a:pt x="82756" y="135547"/>
                </a:cubicBezTo>
                <a:cubicBezTo>
                  <a:pt x="54818" y="40942"/>
                  <a:pt x="89068" y="28090"/>
                  <a:pt x="147620" y="10830"/>
                </a:cubicBezTo>
                <a:cubicBezTo>
                  <a:pt x="206172" y="-6430"/>
                  <a:pt x="350237" y="-5582"/>
                  <a:pt x="434067" y="31989"/>
                </a:cubicBezTo>
                <a:lnTo>
                  <a:pt x="260308" y="191640"/>
                </a:lnTo>
                <a:lnTo>
                  <a:pt x="519318" y="186877"/>
                </a:lnTo>
                <a:close/>
              </a:path>
            </a:pathLst>
          </a:cu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>
              <a:solidFill>
                <a:schemeClr val="tx1"/>
              </a:solidFill>
            </a:endParaRPr>
          </a:p>
        </p:txBody>
      </p:sp>
      <p:grpSp>
        <p:nvGrpSpPr>
          <p:cNvPr id="264" name="Grupo 263"/>
          <p:cNvGrpSpPr/>
          <p:nvPr/>
        </p:nvGrpSpPr>
        <p:grpSpPr>
          <a:xfrm rot="60000" flipV="1">
            <a:off x="7407422" y="3758090"/>
            <a:ext cx="62100" cy="106542"/>
            <a:chOff x="4953375" y="7221921"/>
            <a:chExt cx="82800" cy="142056"/>
          </a:xfrm>
        </p:grpSpPr>
        <p:sp>
          <p:nvSpPr>
            <p:cNvPr id="265" name="Rectángulo 264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266" name="Conector recto 265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90" name="Circular 131"/>
          <p:cNvSpPr/>
          <p:nvPr/>
        </p:nvSpPr>
        <p:spPr>
          <a:xfrm rot="20482430" flipH="1">
            <a:off x="7175780" y="3733130"/>
            <a:ext cx="175841" cy="136200"/>
          </a:xfrm>
          <a:custGeom>
            <a:avLst/>
            <a:gdLst>
              <a:gd name="connsiteX0" fmla="*/ 606921 w 606921"/>
              <a:gd name="connsiteY0" fmla="*/ 194734 h 389467"/>
              <a:gd name="connsiteX1" fmla="*/ 339796 w 606921"/>
              <a:gd name="connsiteY1" fmla="*/ 388067 h 389467"/>
              <a:gd name="connsiteX2" fmla="*/ 44073 w 606921"/>
              <a:gd name="connsiteY2" fmla="*/ 295805 h 389467"/>
              <a:gd name="connsiteX3" fmla="*/ 190773 w 606921"/>
              <a:gd name="connsiteY3" fmla="*/ 13924 h 389467"/>
              <a:gd name="connsiteX4" fmla="*/ 477220 w 606921"/>
              <a:gd name="connsiteY4" fmla="*/ 35083 h 389467"/>
              <a:gd name="connsiteX5" fmla="*/ 303461 w 606921"/>
              <a:gd name="connsiteY5" fmla="*/ 194734 h 389467"/>
              <a:gd name="connsiteX6" fmla="*/ 606921 w 606921"/>
              <a:gd name="connsiteY6" fmla="*/ 194734 h 389467"/>
              <a:gd name="connsiteX0" fmla="*/ 563462 w 563462"/>
              <a:gd name="connsiteY0" fmla="*/ 194735 h 404997"/>
              <a:gd name="connsiteX1" fmla="*/ 296337 w 563462"/>
              <a:gd name="connsiteY1" fmla="*/ 388068 h 404997"/>
              <a:gd name="connsiteX2" fmla="*/ 103087 w 563462"/>
              <a:gd name="connsiteY2" fmla="*/ 384706 h 404997"/>
              <a:gd name="connsiteX3" fmla="*/ 614 w 563462"/>
              <a:gd name="connsiteY3" fmla="*/ 295806 h 404997"/>
              <a:gd name="connsiteX4" fmla="*/ 147314 w 563462"/>
              <a:gd name="connsiteY4" fmla="*/ 13925 h 404997"/>
              <a:gd name="connsiteX5" fmla="*/ 433761 w 563462"/>
              <a:gd name="connsiteY5" fmla="*/ 35084 h 404997"/>
              <a:gd name="connsiteX6" fmla="*/ 260002 w 563462"/>
              <a:gd name="connsiteY6" fmla="*/ 194735 h 404997"/>
              <a:gd name="connsiteX7" fmla="*/ 563462 w 563462"/>
              <a:gd name="connsiteY7" fmla="*/ 194735 h 404997"/>
              <a:gd name="connsiteX0" fmla="*/ 519012 w 519012"/>
              <a:gd name="connsiteY0" fmla="*/ 189972 h 405342"/>
              <a:gd name="connsiteX1" fmla="*/ 296337 w 519012"/>
              <a:gd name="connsiteY1" fmla="*/ 388068 h 405342"/>
              <a:gd name="connsiteX2" fmla="*/ 103087 w 519012"/>
              <a:gd name="connsiteY2" fmla="*/ 384706 h 405342"/>
              <a:gd name="connsiteX3" fmla="*/ 614 w 519012"/>
              <a:gd name="connsiteY3" fmla="*/ 295806 h 405342"/>
              <a:gd name="connsiteX4" fmla="*/ 147314 w 519012"/>
              <a:gd name="connsiteY4" fmla="*/ 13925 h 405342"/>
              <a:gd name="connsiteX5" fmla="*/ 433761 w 519012"/>
              <a:gd name="connsiteY5" fmla="*/ 35084 h 405342"/>
              <a:gd name="connsiteX6" fmla="*/ 260002 w 519012"/>
              <a:gd name="connsiteY6" fmla="*/ 194735 h 405342"/>
              <a:gd name="connsiteX7" fmla="*/ 519012 w 519012"/>
              <a:gd name="connsiteY7" fmla="*/ 189972 h 405342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830 w 519830"/>
              <a:gd name="connsiteY0" fmla="*/ 186190 h 401560"/>
              <a:gd name="connsiteX1" fmla="*/ 297155 w 519830"/>
              <a:gd name="connsiteY1" fmla="*/ 384286 h 401560"/>
              <a:gd name="connsiteX2" fmla="*/ 103905 w 519830"/>
              <a:gd name="connsiteY2" fmla="*/ 380924 h 401560"/>
              <a:gd name="connsiteX3" fmla="*/ 1432 w 519830"/>
              <a:gd name="connsiteY3" fmla="*/ 292024 h 401560"/>
              <a:gd name="connsiteX4" fmla="*/ 57867 w 519830"/>
              <a:gd name="connsiteY4" fmla="*/ 125335 h 401560"/>
              <a:gd name="connsiteX5" fmla="*/ 148132 w 519830"/>
              <a:gd name="connsiteY5" fmla="*/ 10143 h 401560"/>
              <a:gd name="connsiteX6" fmla="*/ 434579 w 519830"/>
              <a:gd name="connsiteY6" fmla="*/ 31302 h 401560"/>
              <a:gd name="connsiteX7" fmla="*/ 260820 w 519830"/>
              <a:gd name="connsiteY7" fmla="*/ 190953 h 401560"/>
              <a:gd name="connsiteX8" fmla="*/ 519830 w 519830"/>
              <a:gd name="connsiteY8" fmla="*/ 186190 h 401560"/>
              <a:gd name="connsiteX0" fmla="*/ 519240 w 519240"/>
              <a:gd name="connsiteY0" fmla="*/ 186647 h 402017"/>
              <a:gd name="connsiteX1" fmla="*/ 296565 w 519240"/>
              <a:gd name="connsiteY1" fmla="*/ 384743 h 402017"/>
              <a:gd name="connsiteX2" fmla="*/ 103315 w 519240"/>
              <a:gd name="connsiteY2" fmla="*/ 381381 h 402017"/>
              <a:gd name="connsiteX3" fmla="*/ 842 w 519240"/>
              <a:gd name="connsiteY3" fmla="*/ 292481 h 402017"/>
              <a:gd name="connsiteX4" fmla="*/ 65215 w 519240"/>
              <a:gd name="connsiteY4" fmla="*/ 132142 h 402017"/>
              <a:gd name="connsiteX5" fmla="*/ 147542 w 519240"/>
              <a:gd name="connsiteY5" fmla="*/ 10600 h 402017"/>
              <a:gd name="connsiteX6" fmla="*/ 433989 w 519240"/>
              <a:gd name="connsiteY6" fmla="*/ 31759 h 402017"/>
              <a:gd name="connsiteX7" fmla="*/ 260230 w 519240"/>
              <a:gd name="connsiteY7" fmla="*/ 191410 h 402017"/>
              <a:gd name="connsiteX8" fmla="*/ 519240 w 519240"/>
              <a:gd name="connsiteY8" fmla="*/ 186647 h 40201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9318 w 519318"/>
              <a:gd name="connsiteY0" fmla="*/ 186877 h 402247"/>
              <a:gd name="connsiteX1" fmla="*/ 296643 w 519318"/>
              <a:gd name="connsiteY1" fmla="*/ 384973 h 402247"/>
              <a:gd name="connsiteX2" fmla="*/ 103393 w 519318"/>
              <a:gd name="connsiteY2" fmla="*/ 381611 h 402247"/>
              <a:gd name="connsiteX3" fmla="*/ 920 w 519318"/>
              <a:gd name="connsiteY3" fmla="*/ 292711 h 402247"/>
              <a:gd name="connsiteX4" fmla="*/ 82756 w 519318"/>
              <a:gd name="connsiteY4" fmla="*/ 135547 h 402247"/>
              <a:gd name="connsiteX5" fmla="*/ 147620 w 519318"/>
              <a:gd name="connsiteY5" fmla="*/ 10830 h 402247"/>
              <a:gd name="connsiteX6" fmla="*/ 434067 w 519318"/>
              <a:gd name="connsiteY6" fmla="*/ 31989 h 402247"/>
              <a:gd name="connsiteX7" fmla="*/ 260308 w 519318"/>
              <a:gd name="connsiteY7" fmla="*/ 191640 h 402247"/>
              <a:gd name="connsiteX8" fmla="*/ 519318 w 519318"/>
              <a:gd name="connsiteY8" fmla="*/ 186877 h 40224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519318" h="402247">
                <a:moveTo>
                  <a:pt x="519318" y="186877"/>
                </a:moveTo>
                <a:cubicBezTo>
                  <a:pt x="519318" y="285407"/>
                  <a:pt x="365964" y="352517"/>
                  <a:pt x="296643" y="384973"/>
                </a:cubicBezTo>
                <a:cubicBezTo>
                  <a:pt x="227322" y="417429"/>
                  <a:pt x="152680" y="396988"/>
                  <a:pt x="103393" y="381611"/>
                </a:cubicBezTo>
                <a:cubicBezTo>
                  <a:pt x="54106" y="366234"/>
                  <a:pt x="4360" y="333722"/>
                  <a:pt x="920" y="292711"/>
                </a:cubicBezTo>
                <a:cubicBezTo>
                  <a:pt x="-2520" y="251700"/>
                  <a:pt x="-432" y="206339"/>
                  <a:pt x="82756" y="135547"/>
                </a:cubicBezTo>
                <a:cubicBezTo>
                  <a:pt x="54818" y="40942"/>
                  <a:pt x="89068" y="28090"/>
                  <a:pt x="147620" y="10830"/>
                </a:cubicBezTo>
                <a:cubicBezTo>
                  <a:pt x="206172" y="-6430"/>
                  <a:pt x="350237" y="-5582"/>
                  <a:pt x="434067" y="31989"/>
                </a:cubicBezTo>
                <a:lnTo>
                  <a:pt x="260308" y="191640"/>
                </a:lnTo>
                <a:lnTo>
                  <a:pt x="519318" y="186877"/>
                </a:lnTo>
                <a:close/>
              </a:path>
            </a:pathLst>
          </a:cu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>
              <a:solidFill>
                <a:schemeClr val="tx1"/>
              </a:solidFill>
            </a:endParaRPr>
          </a:p>
        </p:txBody>
      </p:sp>
      <p:grpSp>
        <p:nvGrpSpPr>
          <p:cNvPr id="291" name="Grupo 290"/>
          <p:cNvGrpSpPr/>
          <p:nvPr/>
        </p:nvGrpSpPr>
        <p:grpSpPr>
          <a:xfrm rot="60000" flipV="1">
            <a:off x="7402657" y="3758144"/>
            <a:ext cx="68400" cy="106542"/>
            <a:chOff x="4953375" y="7221921"/>
            <a:chExt cx="82800" cy="142056"/>
          </a:xfrm>
        </p:grpSpPr>
        <p:sp>
          <p:nvSpPr>
            <p:cNvPr id="292" name="Rectángulo 291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293" name="Conector recto 292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94" name="Grupo 293"/>
          <p:cNvGrpSpPr/>
          <p:nvPr/>
        </p:nvGrpSpPr>
        <p:grpSpPr>
          <a:xfrm rot="21540000" flipH="1" flipV="1">
            <a:off x="7484411" y="3758497"/>
            <a:ext cx="62100" cy="106542"/>
            <a:chOff x="4953375" y="7221921"/>
            <a:chExt cx="82800" cy="142056"/>
          </a:xfrm>
        </p:grpSpPr>
        <p:sp>
          <p:nvSpPr>
            <p:cNvPr id="295" name="Rectángulo 294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296" name="Conector recto 295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97" name="Grupo 296"/>
          <p:cNvGrpSpPr/>
          <p:nvPr/>
        </p:nvGrpSpPr>
        <p:grpSpPr>
          <a:xfrm rot="21540000">
            <a:off x="7495405" y="4699274"/>
            <a:ext cx="62100" cy="106542"/>
            <a:chOff x="4953375" y="7221921"/>
            <a:chExt cx="82800" cy="142056"/>
          </a:xfrm>
        </p:grpSpPr>
        <p:sp>
          <p:nvSpPr>
            <p:cNvPr id="298" name="Rectángulo 297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299" name="Conector recto 298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01" name="Grupo 300"/>
          <p:cNvGrpSpPr/>
          <p:nvPr/>
        </p:nvGrpSpPr>
        <p:grpSpPr>
          <a:xfrm rot="60000" flipH="1">
            <a:off x="7568978" y="4699144"/>
            <a:ext cx="62100" cy="106542"/>
            <a:chOff x="4953375" y="7221921"/>
            <a:chExt cx="82800" cy="142056"/>
          </a:xfrm>
        </p:grpSpPr>
        <p:sp>
          <p:nvSpPr>
            <p:cNvPr id="302" name="Rectángulo 301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303" name="Conector recto 302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04" name="Grupo 303"/>
          <p:cNvGrpSpPr/>
          <p:nvPr/>
        </p:nvGrpSpPr>
        <p:grpSpPr>
          <a:xfrm rot="21540000">
            <a:off x="7640183" y="4698462"/>
            <a:ext cx="62100" cy="106542"/>
            <a:chOff x="4953375" y="7221921"/>
            <a:chExt cx="82800" cy="142056"/>
          </a:xfrm>
        </p:grpSpPr>
        <p:sp>
          <p:nvSpPr>
            <p:cNvPr id="305" name="Rectángulo 304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306" name="Conector recto 305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00" name="Circular 131"/>
          <p:cNvSpPr/>
          <p:nvPr/>
        </p:nvSpPr>
        <p:spPr>
          <a:xfrm rot="1117570">
            <a:off x="7693188" y="4684662"/>
            <a:ext cx="175841" cy="136200"/>
          </a:xfrm>
          <a:custGeom>
            <a:avLst/>
            <a:gdLst>
              <a:gd name="connsiteX0" fmla="*/ 606921 w 606921"/>
              <a:gd name="connsiteY0" fmla="*/ 194734 h 389467"/>
              <a:gd name="connsiteX1" fmla="*/ 339796 w 606921"/>
              <a:gd name="connsiteY1" fmla="*/ 388067 h 389467"/>
              <a:gd name="connsiteX2" fmla="*/ 44073 w 606921"/>
              <a:gd name="connsiteY2" fmla="*/ 295805 h 389467"/>
              <a:gd name="connsiteX3" fmla="*/ 190773 w 606921"/>
              <a:gd name="connsiteY3" fmla="*/ 13924 h 389467"/>
              <a:gd name="connsiteX4" fmla="*/ 477220 w 606921"/>
              <a:gd name="connsiteY4" fmla="*/ 35083 h 389467"/>
              <a:gd name="connsiteX5" fmla="*/ 303461 w 606921"/>
              <a:gd name="connsiteY5" fmla="*/ 194734 h 389467"/>
              <a:gd name="connsiteX6" fmla="*/ 606921 w 606921"/>
              <a:gd name="connsiteY6" fmla="*/ 194734 h 389467"/>
              <a:gd name="connsiteX0" fmla="*/ 563462 w 563462"/>
              <a:gd name="connsiteY0" fmla="*/ 194735 h 404997"/>
              <a:gd name="connsiteX1" fmla="*/ 296337 w 563462"/>
              <a:gd name="connsiteY1" fmla="*/ 388068 h 404997"/>
              <a:gd name="connsiteX2" fmla="*/ 103087 w 563462"/>
              <a:gd name="connsiteY2" fmla="*/ 384706 h 404997"/>
              <a:gd name="connsiteX3" fmla="*/ 614 w 563462"/>
              <a:gd name="connsiteY3" fmla="*/ 295806 h 404997"/>
              <a:gd name="connsiteX4" fmla="*/ 147314 w 563462"/>
              <a:gd name="connsiteY4" fmla="*/ 13925 h 404997"/>
              <a:gd name="connsiteX5" fmla="*/ 433761 w 563462"/>
              <a:gd name="connsiteY5" fmla="*/ 35084 h 404997"/>
              <a:gd name="connsiteX6" fmla="*/ 260002 w 563462"/>
              <a:gd name="connsiteY6" fmla="*/ 194735 h 404997"/>
              <a:gd name="connsiteX7" fmla="*/ 563462 w 563462"/>
              <a:gd name="connsiteY7" fmla="*/ 194735 h 404997"/>
              <a:gd name="connsiteX0" fmla="*/ 519012 w 519012"/>
              <a:gd name="connsiteY0" fmla="*/ 189972 h 405342"/>
              <a:gd name="connsiteX1" fmla="*/ 296337 w 519012"/>
              <a:gd name="connsiteY1" fmla="*/ 388068 h 405342"/>
              <a:gd name="connsiteX2" fmla="*/ 103087 w 519012"/>
              <a:gd name="connsiteY2" fmla="*/ 384706 h 405342"/>
              <a:gd name="connsiteX3" fmla="*/ 614 w 519012"/>
              <a:gd name="connsiteY3" fmla="*/ 295806 h 405342"/>
              <a:gd name="connsiteX4" fmla="*/ 147314 w 519012"/>
              <a:gd name="connsiteY4" fmla="*/ 13925 h 405342"/>
              <a:gd name="connsiteX5" fmla="*/ 433761 w 519012"/>
              <a:gd name="connsiteY5" fmla="*/ 35084 h 405342"/>
              <a:gd name="connsiteX6" fmla="*/ 260002 w 519012"/>
              <a:gd name="connsiteY6" fmla="*/ 194735 h 405342"/>
              <a:gd name="connsiteX7" fmla="*/ 519012 w 519012"/>
              <a:gd name="connsiteY7" fmla="*/ 189972 h 405342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830 w 519830"/>
              <a:gd name="connsiteY0" fmla="*/ 186190 h 401560"/>
              <a:gd name="connsiteX1" fmla="*/ 297155 w 519830"/>
              <a:gd name="connsiteY1" fmla="*/ 384286 h 401560"/>
              <a:gd name="connsiteX2" fmla="*/ 103905 w 519830"/>
              <a:gd name="connsiteY2" fmla="*/ 380924 h 401560"/>
              <a:gd name="connsiteX3" fmla="*/ 1432 w 519830"/>
              <a:gd name="connsiteY3" fmla="*/ 292024 h 401560"/>
              <a:gd name="connsiteX4" fmla="*/ 57867 w 519830"/>
              <a:gd name="connsiteY4" fmla="*/ 125335 h 401560"/>
              <a:gd name="connsiteX5" fmla="*/ 148132 w 519830"/>
              <a:gd name="connsiteY5" fmla="*/ 10143 h 401560"/>
              <a:gd name="connsiteX6" fmla="*/ 434579 w 519830"/>
              <a:gd name="connsiteY6" fmla="*/ 31302 h 401560"/>
              <a:gd name="connsiteX7" fmla="*/ 260820 w 519830"/>
              <a:gd name="connsiteY7" fmla="*/ 190953 h 401560"/>
              <a:gd name="connsiteX8" fmla="*/ 519830 w 519830"/>
              <a:gd name="connsiteY8" fmla="*/ 186190 h 401560"/>
              <a:gd name="connsiteX0" fmla="*/ 519240 w 519240"/>
              <a:gd name="connsiteY0" fmla="*/ 186647 h 402017"/>
              <a:gd name="connsiteX1" fmla="*/ 296565 w 519240"/>
              <a:gd name="connsiteY1" fmla="*/ 384743 h 402017"/>
              <a:gd name="connsiteX2" fmla="*/ 103315 w 519240"/>
              <a:gd name="connsiteY2" fmla="*/ 381381 h 402017"/>
              <a:gd name="connsiteX3" fmla="*/ 842 w 519240"/>
              <a:gd name="connsiteY3" fmla="*/ 292481 h 402017"/>
              <a:gd name="connsiteX4" fmla="*/ 65215 w 519240"/>
              <a:gd name="connsiteY4" fmla="*/ 132142 h 402017"/>
              <a:gd name="connsiteX5" fmla="*/ 147542 w 519240"/>
              <a:gd name="connsiteY5" fmla="*/ 10600 h 402017"/>
              <a:gd name="connsiteX6" fmla="*/ 433989 w 519240"/>
              <a:gd name="connsiteY6" fmla="*/ 31759 h 402017"/>
              <a:gd name="connsiteX7" fmla="*/ 260230 w 519240"/>
              <a:gd name="connsiteY7" fmla="*/ 191410 h 402017"/>
              <a:gd name="connsiteX8" fmla="*/ 519240 w 519240"/>
              <a:gd name="connsiteY8" fmla="*/ 186647 h 40201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9318 w 519318"/>
              <a:gd name="connsiteY0" fmla="*/ 186877 h 402247"/>
              <a:gd name="connsiteX1" fmla="*/ 296643 w 519318"/>
              <a:gd name="connsiteY1" fmla="*/ 384973 h 402247"/>
              <a:gd name="connsiteX2" fmla="*/ 103393 w 519318"/>
              <a:gd name="connsiteY2" fmla="*/ 381611 h 402247"/>
              <a:gd name="connsiteX3" fmla="*/ 920 w 519318"/>
              <a:gd name="connsiteY3" fmla="*/ 292711 h 402247"/>
              <a:gd name="connsiteX4" fmla="*/ 82756 w 519318"/>
              <a:gd name="connsiteY4" fmla="*/ 135547 h 402247"/>
              <a:gd name="connsiteX5" fmla="*/ 147620 w 519318"/>
              <a:gd name="connsiteY5" fmla="*/ 10830 h 402247"/>
              <a:gd name="connsiteX6" fmla="*/ 434067 w 519318"/>
              <a:gd name="connsiteY6" fmla="*/ 31989 h 402247"/>
              <a:gd name="connsiteX7" fmla="*/ 260308 w 519318"/>
              <a:gd name="connsiteY7" fmla="*/ 191640 h 402247"/>
              <a:gd name="connsiteX8" fmla="*/ 519318 w 519318"/>
              <a:gd name="connsiteY8" fmla="*/ 186877 h 40224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519318" h="402247">
                <a:moveTo>
                  <a:pt x="519318" y="186877"/>
                </a:moveTo>
                <a:cubicBezTo>
                  <a:pt x="519318" y="285407"/>
                  <a:pt x="365964" y="352517"/>
                  <a:pt x="296643" y="384973"/>
                </a:cubicBezTo>
                <a:cubicBezTo>
                  <a:pt x="227322" y="417429"/>
                  <a:pt x="152680" y="396988"/>
                  <a:pt x="103393" y="381611"/>
                </a:cubicBezTo>
                <a:cubicBezTo>
                  <a:pt x="54106" y="366234"/>
                  <a:pt x="4360" y="333722"/>
                  <a:pt x="920" y="292711"/>
                </a:cubicBezTo>
                <a:cubicBezTo>
                  <a:pt x="-2520" y="251700"/>
                  <a:pt x="-432" y="206339"/>
                  <a:pt x="82756" y="135547"/>
                </a:cubicBezTo>
                <a:cubicBezTo>
                  <a:pt x="54818" y="40942"/>
                  <a:pt x="89068" y="28090"/>
                  <a:pt x="147620" y="10830"/>
                </a:cubicBezTo>
                <a:cubicBezTo>
                  <a:pt x="206172" y="-6430"/>
                  <a:pt x="350237" y="-5582"/>
                  <a:pt x="434067" y="31989"/>
                </a:cubicBezTo>
                <a:lnTo>
                  <a:pt x="260308" y="191640"/>
                </a:lnTo>
                <a:lnTo>
                  <a:pt x="519318" y="186877"/>
                </a:lnTo>
                <a:close/>
              </a:path>
            </a:pathLst>
          </a:cu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>
              <a:solidFill>
                <a:schemeClr val="tx1"/>
              </a:solidFill>
            </a:endParaRPr>
          </a:p>
        </p:txBody>
      </p:sp>
      <p:grpSp>
        <p:nvGrpSpPr>
          <p:cNvPr id="307" name="Grupo 306"/>
          <p:cNvGrpSpPr/>
          <p:nvPr/>
        </p:nvGrpSpPr>
        <p:grpSpPr>
          <a:xfrm rot="17520000">
            <a:off x="7601371" y="3922287"/>
            <a:ext cx="62100" cy="106542"/>
            <a:chOff x="4953375" y="7221921"/>
            <a:chExt cx="82800" cy="142056"/>
          </a:xfrm>
        </p:grpSpPr>
        <p:sp>
          <p:nvSpPr>
            <p:cNvPr id="308" name="Rectángulo 307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309" name="Conector recto 308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10" name="Grupo 309"/>
          <p:cNvGrpSpPr/>
          <p:nvPr/>
        </p:nvGrpSpPr>
        <p:grpSpPr>
          <a:xfrm rot="17520000">
            <a:off x="7723438" y="4407344"/>
            <a:ext cx="62100" cy="106542"/>
            <a:chOff x="4953375" y="7221921"/>
            <a:chExt cx="82800" cy="142056"/>
          </a:xfrm>
        </p:grpSpPr>
        <p:sp>
          <p:nvSpPr>
            <p:cNvPr id="311" name="Rectángulo 310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312" name="Conector recto 311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13" name="Grupo 312"/>
          <p:cNvGrpSpPr/>
          <p:nvPr/>
        </p:nvGrpSpPr>
        <p:grpSpPr>
          <a:xfrm rot="11640000">
            <a:off x="7293676" y="4082979"/>
            <a:ext cx="62100" cy="106542"/>
            <a:chOff x="4953375" y="7221921"/>
            <a:chExt cx="82800" cy="142056"/>
          </a:xfrm>
        </p:grpSpPr>
        <p:sp>
          <p:nvSpPr>
            <p:cNvPr id="314" name="Rectángulo 313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315" name="Conector recto 314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16" name="Grupo 315"/>
          <p:cNvGrpSpPr/>
          <p:nvPr/>
        </p:nvGrpSpPr>
        <p:grpSpPr>
          <a:xfrm rot="14880000" flipH="1">
            <a:off x="7380602" y="3893304"/>
            <a:ext cx="62100" cy="106542"/>
            <a:chOff x="4953375" y="7221921"/>
            <a:chExt cx="82800" cy="142056"/>
          </a:xfrm>
        </p:grpSpPr>
        <p:sp>
          <p:nvSpPr>
            <p:cNvPr id="317" name="Rectángulo 316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318" name="Conector recto 317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19" name="Grupo 318"/>
          <p:cNvGrpSpPr/>
          <p:nvPr/>
        </p:nvGrpSpPr>
        <p:grpSpPr>
          <a:xfrm rot="14880000" flipH="1">
            <a:off x="7370303" y="4404448"/>
            <a:ext cx="62100" cy="106542"/>
            <a:chOff x="4953375" y="7221921"/>
            <a:chExt cx="82800" cy="142056"/>
          </a:xfrm>
        </p:grpSpPr>
        <p:sp>
          <p:nvSpPr>
            <p:cNvPr id="320" name="Rectángulo 319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321" name="Conector recto 320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28" name="Grupo 327"/>
          <p:cNvGrpSpPr/>
          <p:nvPr/>
        </p:nvGrpSpPr>
        <p:grpSpPr>
          <a:xfrm rot="17760000">
            <a:off x="7385701" y="4533499"/>
            <a:ext cx="62100" cy="106542"/>
            <a:chOff x="4953375" y="7221921"/>
            <a:chExt cx="82800" cy="142056"/>
          </a:xfrm>
        </p:grpSpPr>
        <p:sp>
          <p:nvSpPr>
            <p:cNvPr id="329" name="Rectángulo 328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330" name="Conector recto 329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31" name="Grupo 330"/>
          <p:cNvGrpSpPr/>
          <p:nvPr/>
        </p:nvGrpSpPr>
        <p:grpSpPr>
          <a:xfrm rot="20760000" flipV="1">
            <a:off x="7528516" y="4458938"/>
            <a:ext cx="62100" cy="106542"/>
            <a:chOff x="4953375" y="7221921"/>
            <a:chExt cx="82800" cy="142056"/>
          </a:xfrm>
        </p:grpSpPr>
        <p:sp>
          <p:nvSpPr>
            <p:cNvPr id="332" name="Rectángulo 331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333" name="Conector recto 332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" name="CuadroTexto 4"/>
          <p:cNvSpPr txBox="1"/>
          <p:nvPr/>
        </p:nvSpPr>
        <p:spPr>
          <a:xfrm>
            <a:off x="4043363" y="3997079"/>
            <a:ext cx="520916" cy="2975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750"/>
              </a:lnSpc>
            </a:pPr>
            <a:r>
              <a:rPr lang="es-CO" sz="675" dirty="0" err="1">
                <a:latin typeface="Arial" panose="020B0604020202020204" pitchFamily="34" charset="0"/>
                <a:cs typeface="Arial" panose="020B0604020202020204" pitchFamily="34" charset="0"/>
              </a:rPr>
              <a:t>Hydrogen</a:t>
            </a:r>
            <a:r>
              <a:rPr lang="es-CO" sz="67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CO" sz="675" dirty="0" err="1">
                <a:latin typeface="Arial" panose="020B0604020202020204" pitchFamily="34" charset="0"/>
                <a:cs typeface="Arial" panose="020B0604020202020204" pitchFamily="34" charset="0"/>
              </a:rPr>
              <a:t>bonds</a:t>
            </a:r>
            <a:endParaRPr 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Conector recto de flecha 6"/>
          <p:cNvCxnSpPr/>
          <p:nvPr/>
        </p:nvCxnSpPr>
        <p:spPr>
          <a:xfrm>
            <a:off x="4426989" y="4213211"/>
            <a:ext cx="168042" cy="6502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4" name="CuadroTexto 333"/>
          <p:cNvSpPr txBox="1"/>
          <p:nvPr/>
        </p:nvSpPr>
        <p:spPr>
          <a:xfrm rot="1338155">
            <a:off x="4804474" y="3571862"/>
            <a:ext cx="590696" cy="2975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750"/>
              </a:lnSpc>
            </a:pPr>
            <a:r>
              <a:rPr lang="es-CO" sz="675" dirty="0">
                <a:latin typeface="Arial" panose="020B0604020202020204" pitchFamily="34" charset="0"/>
                <a:cs typeface="Arial" panose="020B0604020202020204" pitchFamily="34" charset="0"/>
              </a:rPr>
              <a:t>Reverse primer</a:t>
            </a:r>
            <a:endParaRPr 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5" name="CuadroTexto 334"/>
          <p:cNvSpPr txBox="1"/>
          <p:nvPr/>
        </p:nvSpPr>
        <p:spPr>
          <a:xfrm rot="20150731">
            <a:off x="4166290" y="4811490"/>
            <a:ext cx="590696" cy="2975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750"/>
              </a:lnSpc>
            </a:pPr>
            <a:r>
              <a:rPr lang="es-CO" sz="675" dirty="0">
                <a:latin typeface="Arial" panose="020B0604020202020204" pitchFamily="34" charset="0"/>
                <a:cs typeface="Arial" panose="020B0604020202020204" pitchFamily="34" charset="0"/>
              </a:rPr>
              <a:t>Forward primer</a:t>
            </a:r>
            <a:endParaRPr 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6" name="CuadroTexto 335"/>
          <p:cNvSpPr txBox="1"/>
          <p:nvPr/>
        </p:nvSpPr>
        <p:spPr>
          <a:xfrm>
            <a:off x="4730290" y="4578766"/>
            <a:ext cx="590696" cy="2975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750"/>
              </a:lnSpc>
            </a:pPr>
            <a:r>
              <a:rPr lang="es-CO" sz="675" dirty="0" err="1">
                <a:latin typeface="Arial" panose="020B0604020202020204" pitchFamily="34" charset="0"/>
                <a:cs typeface="Arial" panose="020B0604020202020204" pitchFamily="34" charset="0"/>
              </a:rPr>
              <a:t>Nucleotides</a:t>
            </a:r>
            <a:endParaRPr 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37" name="Grupo 336"/>
          <p:cNvGrpSpPr/>
          <p:nvPr/>
        </p:nvGrpSpPr>
        <p:grpSpPr>
          <a:xfrm rot="20040000" flipH="1" flipV="1">
            <a:off x="5019536" y="4508596"/>
            <a:ext cx="62100" cy="106542"/>
            <a:chOff x="4953375" y="7221921"/>
            <a:chExt cx="82800" cy="142056"/>
          </a:xfrm>
        </p:grpSpPr>
        <p:sp>
          <p:nvSpPr>
            <p:cNvPr id="338" name="Rectángulo 337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339" name="Conector recto 338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340" name="Imagen 33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77" t="16601" r="40948" b="25066"/>
          <a:stretch/>
        </p:blipFill>
        <p:spPr>
          <a:xfrm>
            <a:off x="5500678" y="3849850"/>
            <a:ext cx="91418" cy="88266"/>
          </a:xfrm>
          <a:prstGeom prst="rect">
            <a:avLst/>
          </a:prstGeom>
        </p:spPr>
      </p:pic>
      <p:pic>
        <p:nvPicPr>
          <p:cNvPr id="341" name="Imagen 340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31" t="16963" r="41175" b="24703"/>
          <a:stretch/>
        </p:blipFill>
        <p:spPr>
          <a:xfrm>
            <a:off x="6035698" y="3838414"/>
            <a:ext cx="90629" cy="88265"/>
          </a:xfrm>
          <a:prstGeom prst="rect">
            <a:avLst/>
          </a:prstGeom>
        </p:spPr>
      </p:pic>
      <p:pic>
        <p:nvPicPr>
          <p:cNvPr id="342" name="Imagen 34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77" t="16601" r="40948" b="25066"/>
          <a:stretch/>
        </p:blipFill>
        <p:spPr>
          <a:xfrm rot="10800000">
            <a:off x="6035359" y="4662235"/>
            <a:ext cx="91418" cy="88266"/>
          </a:xfrm>
          <a:prstGeom prst="rect">
            <a:avLst/>
          </a:prstGeom>
        </p:spPr>
      </p:pic>
      <p:pic>
        <p:nvPicPr>
          <p:cNvPr id="343" name="Imagen 34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31" t="16963" r="41175" b="24703"/>
          <a:stretch/>
        </p:blipFill>
        <p:spPr>
          <a:xfrm rot="10800000">
            <a:off x="5502403" y="4659868"/>
            <a:ext cx="90629" cy="88265"/>
          </a:xfrm>
          <a:prstGeom prst="rect">
            <a:avLst/>
          </a:prstGeom>
        </p:spPr>
      </p:pic>
      <p:grpSp>
        <p:nvGrpSpPr>
          <p:cNvPr id="344" name="Grupo 343"/>
          <p:cNvGrpSpPr/>
          <p:nvPr/>
        </p:nvGrpSpPr>
        <p:grpSpPr>
          <a:xfrm rot="1320000">
            <a:off x="6659711" y="4663563"/>
            <a:ext cx="62100" cy="106542"/>
            <a:chOff x="4953375" y="7221921"/>
            <a:chExt cx="82800" cy="142056"/>
          </a:xfrm>
        </p:grpSpPr>
        <p:sp>
          <p:nvSpPr>
            <p:cNvPr id="345" name="Rectángulo 344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346" name="Conector recto 345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47" name="Grupo 346"/>
          <p:cNvGrpSpPr/>
          <p:nvPr/>
        </p:nvGrpSpPr>
        <p:grpSpPr>
          <a:xfrm rot="20280000" flipH="1" flipV="1">
            <a:off x="7257358" y="3922073"/>
            <a:ext cx="62100" cy="106542"/>
            <a:chOff x="4953375" y="7221921"/>
            <a:chExt cx="82800" cy="142056"/>
          </a:xfrm>
        </p:grpSpPr>
        <p:sp>
          <p:nvSpPr>
            <p:cNvPr id="348" name="Rectángulo 347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349" name="Conector recto 348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56" name="Grupo 355"/>
          <p:cNvGrpSpPr/>
          <p:nvPr/>
        </p:nvGrpSpPr>
        <p:grpSpPr>
          <a:xfrm rot="1320000">
            <a:off x="7669153" y="4540185"/>
            <a:ext cx="62100" cy="106542"/>
            <a:chOff x="4953375" y="7221921"/>
            <a:chExt cx="82800" cy="142056"/>
          </a:xfrm>
        </p:grpSpPr>
        <p:sp>
          <p:nvSpPr>
            <p:cNvPr id="357" name="Rectángulo 356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358" name="Conector recto 357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62" name="CuadroTexto 361"/>
          <p:cNvSpPr txBox="1"/>
          <p:nvPr/>
        </p:nvSpPr>
        <p:spPr>
          <a:xfrm>
            <a:off x="4394453" y="4655608"/>
            <a:ext cx="471223" cy="2975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750"/>
              </a:lnSpc>
            </a:pPr>
            <a:r>
              <a:rPr lang="es-CO" sz="675" dirty="0" err="1">
                <a:latin typeface="Arial" panose="020B0604020202020204" pitchFamily="34" charset="0"/>
                <a:cs typeface="Arial" panose="020B0604020202020204" pitchFamily="34" charset="0"/>
              </a:rPr>
              <a:t>Taq</a:t>
            </a:r>
            <a:r>
              <a:rPr lang="es-CO" sz="675" dirty="0">
                <a:latin typeface="Arial" panose="020B0604020202020204" pitchFamily="34" charset="0"/>
                <a:cs typeface="Arial" panose="020B0604020202020204" pitchFamily="34" charset="0"/>
              </a:rPr>
              <a:t> Pol</a:t>
            </a:r>
            <a:endParaRPr 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Abrir llave 10"/>
          <p:cNvSpPr/>
          <p:nvPr/>
        </p:nvSpPr>
        <p:spPr>
          <a:xfrm rot="16200000">
            <a:off x="4689339" y="4751722"/>
            <a:ext cx="78917" cy="945818"/>
          </a:xfrm>
          <a:prstGeom prst="leftBrace">
            <a:avLst>
              <a:gd name="adj1" fmla="val 17921"/>
              <a:gd name="adj2" fmla="val 50000"/>
            </a:avLst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350"/>
          </a:p>
        </p:txBody>
      </p:sp>
      <p:sp>
        <p:nvSpPr>
          <p:cNvPr id="363" name="CuadroTexto 362"/>
          <p:cNvSpPr txBox="1"/>
          <p:nvPr/>
        </p:nvSpPr>
        <p:spPr>
          <a:xfrm>
            <a:off x="5426023" y="3348716"/>
            <a:ext cx="2537929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750"/>
              </a:lnSpc>
            </a:pPr>
            <a:r>
              <a:rPr lang="es-CO" sz="675" b="1" dirty="0" err="1">
                <a:latin typeface="Arial" panose="020B0604020202020204" pitchFamily="34" charset="0"/>
                <a:cs typeface="Arial" panose="020B0604020202020204" pitchFamily="34" charset="0"/>
              </a:rPr>
              <a:t>Denaturation</a:t>
            </a:r>
            <a:r>
              <a:rPr lang="es-CO" sz="675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  <a:r>
              <a:rPr lang="es-CO" sz="675" b="1" dirty="0" err="1">
                <a:latin typeface="Arial" panose="020B0604020202020204" pitchFamily="34" charset="0"/>
                <a:cs typeface="Arial" panose="020B0604020202020204" pitchFamily="34" charset="0"/>
              </a:rPr>
              <a:t>Annealing</a:t>
            </a:r>
            <a:r>
              <a:rPr lang="es-CO" sz="675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</a:t>
            </a:r>
            <a:r>
              <a:rPr lang="es-CO" sz="675" b="1" dirty="0" err="1">
                <a:latin typeface="Arial" panose="020B0604020202020204" pitchFamily="34" charset="0"/>
                <a:cs typeface="Arial" panose="020B0604020202020204" pitchFamily="34" charset="0"/>
              </a:rPr>
              <a:t>Extension</a:t>
            </a:r>
            <a:endParaRPr lang="en-US" sz="67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66" name="Grupo 365"/>
          <p:cNvGrpSpPr/>
          <p:nvPr/>
        </p:nvGrpSpPr>
        <p:grpSpPr>
          <a:xfrm rot="17760000">
            <a:off x="7438576" y="4042786"/>
            <a:ext cx="62100" cy="106542"/>
            <a:chOff x="4953375" y="7221921"/>
            <a:chExt cx="82800" cy="142056"/>
          </a:xfrm>
        </p:grpSpPr>
        <p:sp>
          <p:nvSpPr>
            <p:cNvPr id="367" name="Rectángulo 366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368" name="Conector recto 367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" name="Abrir corchete 13"/>
          <p:cNvSpPr/>
          <p:nvPr/>
        </p:nvSpPr>
        <p:spPr>
          <a:xfrm rot="16200000">
            <a:off x="6637017" y="4175633"/>
            <a:ext cx="64554" cy="2193130"/>
          </a:xfrm>
          <a:prstGeom prst="leftBracket">
            <a:avLst>
              <a:gd name="adj" fmla="val 58134"/>
            </a:avLst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350"/>
          </a:p>
        </p:txBody>
      </p:sp>
      <p:sp>
        <p:nvSpPr>
          <p:cNvPr id="369" name="CuadroTexto 368"/>
          <p:cNvSpPr txBox="1"/>
          <p:nvPr/>
        </p:nvSpPr>
        <p:spPr>
          <a:xfrm>
            <a:off x="6363495" y="5214411"/>
            <a:ext cx="612667" cy="19492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>
              <a:lnSpc>
                <a:spcPts val="750"/>
              </a:lnSpc>
            </a:pPr>
            <a:r>
              <a:rPr lang="es-CO" sz="675" b="1" dirty="0" err="1">
                <a:latin typeface="Arial" panose="020B0604020202020204" pitchFamily="34" charset="0"/>
                <a:cs typeface="Arial" panose="020B0604020202020204" pitchFamily="34" charset="0"/>
              </a:rPr>
              <a:t>One</a:t>
            </a:r>
            <a:r>
              <a:rPr lang="es-CO" sz="675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CO" sz="675" b="1" dirty="0" err="1">
                <a:latin typeface="Arial" panose="020B0604020202020204" pitchFamily="34" charset="0"/>
                <a:cs typeface="Arial" panose="020B0604020202020204" pitchFamily="34" charset="0"/>
              </a:rPr>
              <a:t>Cycle</a:t>
            </a:r>
            <a:endParaRPr lang="en-US" sz="67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70" name="Grupo 369"/>
          <p:cNvGrpSpPr/>
          <p:nvPr/>
        </p:nvGrpSpPr>
        <p:grpSpPr>
          <a:xfrm rot="1560000">
            <a:off x="5762529" y="4114567"/>
            <a:ext cx="62100" cy="106542"/>
            <a:chOff x="4953375" y="7221921"/>
            <a:chExt cx="82800" cy="142056"/>
          </a:xfrm>
        </p:grpSpPr>
        <p:sp>
          <p:nvSpPr>
            <p:cNvPr id="371" name="Rectángulo 370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372" name="Conector recto 371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76" name="Grupo 375"/>
          <p:cNvGrpSpPr/>
          <p:nvPr/>
        </p:nvGrpSpPr>
        <p:grpSpPr>
          <a:xfrm rot="1560000" flipV="1">
            <a:off x="5430576" y="3977882"/>
            <a:ext cx="62100" cy="106542"/>
            <a:chOff x="4953375" y="7221921"/>
            <a:chExt cx="82800" cy="142056"/>
          </a:xfrm>
        </p:grpSpPr>
        <p:sp>
          <p:nvSpPr>
            <p:cNvPr id="377" name="Rectángulo 376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378" name="Conector recto 377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79" name="Grupo 378"/>
          <p:cNvGrpSpPr/>
          <p:nvPr/>
        </p:nvGrpSpPr>
        <p:grpSpPr>
          <a:xfrm rot="60000" flipH="1">
            <a:off x="6036766" y="4338329"/>
            <a:ext cx="62100" cy="106542"/>
            <a:chOff x="4953375" y="7221921"/>
            <a:chExt cx="82800" cy="142056"/>
          </a:xfrm>
        </p:grpSpPr>
        <p:sp>
          <p:nvSpPr>
            <p:cNvPr id="380" name="Rectángulo 379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381" name="Conector recto 380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82" name="Grupo 381"/>
          <p:cNvGrpSpPr/>
          <p:nvPr/>
        </p:nvGrpSpPr>
        <p:grpSpPr>
          <a:xfrm rot="20040000" flipH="1" flipV="1">
            <a:off x="5471464" y="4361329"/>
            <a:ext cx="62100" cy="106542"/>
            <a:chOff x="4953375" y="7221921"/>
            <a:chExt cx="82800" cy="142056"/>
          </a:xfrm>
        </p:grpSpPr>
        <p:sp>
          <p:nvSpPr>
            <p:cNvPr id="383" name="Rectángulo 382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384" name="Conector recto 383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85" name="Grupo 384"/>
          <p:cNvGrpSpPr/>
          <p:nvPr/>
        </p:nvGrpSpPr>
        <p:grpSpPr>
          <a:xfrm rot="20040000" flipH="1" flipV="1">
            <a:off x="5887773" y="4379405"/>
            <a:ext cx="62100" cy="106542"/>
            <a:chOff x="4953375" y="7221921"/>
            <a:chExt cx="82800" cy="142056"/>
          </a:xfrm>
        </p:grpSpPr>
        <p:sp>
          <p:nvSpPr>
            <p:cNvPr id="386" name="Rectángulo 385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387" name="Conector recto 386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88" name="Circular 131"/>
          <p:cNvSpPr/>
          <p:nvPr/>
        </p:nvSpPr>
        <p:spPr>
          <a:xfrm rot="9187987">
            <a:off x="5841649" y="3634105"/>
            <a:ext cx="193512" cy="163870"/>
          </a:xfrm>
          <a:custGeom>
            <a:avLst/>
            <a:gdLst>
              <a:gd name="connsiteX0" fmla="*/ 606921 w 606921"/>
              <a:gd name="connsiteY0" fmla="*/ 194734 h 389467"/>
              <a:gd name="connsiteX1" fmla="*/ 339796 w 606921"/>
              <a:gd name="connsiteY1" fmla="*/ 388067 h 389467"/>
              <a:gd name="connsiteX2" fmla="*/ 44073 w 606921"/>
              <a:gd name="connsiteY2" fmla="*/ 295805 h 389467"/>
              <a:gd name="connsiteX3" fmla="*/ 190773 w 606921"/>
              <a:gd name="connsiteY3" fmla="*/ 13924 h 389467"/>
              <a:gd name="connsiteX4" fmla="*/ 477220 w 606921"/>
              <a:gd name="connsiteY4" fmla="*/ 35083 h 389467"/>
              <a:gd name="connsiteX5" fmla="*/ 303461 w 606921"/>
              <a:gd name="connsiteY5" fmla="*/ 194734 h 389467"/>
              <a:gd name="connsiteX6" fmla="*/ 606921 w 606921"/>
              <a:gd name="connsiteY6" fmla="*/ 194734 h 389467"/>
              <a:gd name="connsiteX0" fmla="*/ 563462 w 563462"/>
              <a:gd name="connsiteY0" fmla="*/ 194735 h 404997"/>
              <a:gd name="connsiteX1" fmla="*/ 296337 w 563462"/>
              <a:gd name="connsiteY1" fmla="*/ 388068 h 404997"/>
              <a:gd name="connsiteX2" fmla="*/ 103087 w 563462"/>
              <a:gd name="connsiteY2" fmla="*/ 384706 h 404997"/>
              <a:gd name="connsiteX3" fmla="*/ 614 w 563462"/>
              <a:gd name="connsiteY3" fmla="*/ 295806 h 404997"/>
              <a:gd name="connsiteX4" fmla="*/ 147314 w 563462"/>
              <a:gd name="connsiteY4" fmla="*/ 13925 h 404997"/>
              <a:gd name="connsiteX5" fmla="*/ 433761 w 563462"/>
              <a:gd name="connsiteY5" fmla="*/ 35084 h 404997"/>
              <a:gd name="connsiteX6" fmla="*/ 260002 w 563462"/>
              <a:gd name="connsiteY6" fmla="*/ 194735 h 404997"/>
              <a:gd name="connsiteX7" fmla="*/ 563462 w 563462"/>
              <a:gd name="connsiteY7" fmla="*/ 194735 h 404997"/>
              <a:gd name="connsiteX0" fmla="*/ 519012 w 519012"/>
              <a:gd name="connsiteY0" fmla="*/ 189972 h 405342"/>
              <a:gd name="connsiteX1" fmla="*/ 296337 w 519012"/>
              <a:gd name="connsiteY1" fmla="*/ 388068 h 405342"/>
              <a:gd name="connsiteX2" fmla="*/ 103087 w 519012"/>
              <a:gd name="connsiteY2" fmla="*/ 384706 h 405342"/>
              <a:gd name="connsiteX3" fmla="*/ 614 w 519012"/>
              <a:gd name="connsiteY3" fmla="*/ 295806 h 405342"/>
              <a:gd name="connsiteX4" fmla="*/ 147314 w 519012"/>
              <a:gd name="connsiteY4" fmla="*/ 13925 h 405342"/>
              <a:gd name="connsiteX5" fmla="*/ 433761 w 519012"/>
              <a:gd name="connsiteY5" fmla="*/ 35084 h 405342"/>
              <a:gd name="connsiteX6" fmla="*/ 260002 w 519012"/>
              <a:gd name="connsiteY6" fmla="*/ 194735 h 405342"/>
              <a:gd name="connsiteX7" fmla="*/ 519012 w 519012"/>
              <a:gd name="connsiteY7" fmla="*/ 189972 h 405342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830 w 519830"/>
              <a:gd name="connsiteY0" fmla="*/ 186190 h 401560"/>
              <a:gd name="connsiteX1" fmla="*/ 297155 w 519830"/>
              <a:gd name="connsiteY1" fmla="*/ 384286 h 401560"/>
              <a:gd name="connsiteX2" fmla="*/ 103905 w 519830"/>
              <a:gd name="connsiteY2" fmla="*/ 380924 h 401560"/>
              <a:gd name="connsiteX3" fmla="*/ 1432 w 519830"/>
              <a:gd name="connsiteY3" fmla="*/ 292024 h 401560"/>
              <a:gd name="connsiteX4" fmla="*/ 57867 w 519830"/>
              <a:gd name="connsiteY4" fmla="*/ 125335 h 401560"/>
              <a:gd name="connsiteX5" fmla="*/ 148132 w 519830"/>
              <a:gd name="connsiteY5" fmla="*/ 10143 h 401560"/>
              <a:gd name="connsiteX6" fmla="*/ 434579 w 519830"/>
              <a:gd name="connsiteY6" fmla="*/ 31302 h 401560"/>
              <a:gd name="connsiteX7" fmla="*/ 260820 w 519830"/>
              <a:gd name="connsiteY7" fmla="*/ 190953 h 401560"/>
              <a:gd name="connsiteX8" fmla="*/ 519830 w 519830"/>
              <a:gd name="connsiteY8" fmla="*/ 186190 h 401560"/>
              <a:gd name="connsiteX0" fmla="*/ 519240 w 519240"/>
              <a:gd name="connsiteY0" fmla="*/ 186647 h 402017"/>
              <a:gd name="connsiteX1" fmla="*/ 296565 w 519240"/>
              <a:gd name="connsiteY1" fmla="*/ 384743 h 402017"/>
              <a:gd name="connsiteX2" fmla="*/ 103315 w 519240"/>
              <a:gd name="connsiteY2" fmla="*/ 381381 h 402017"/>
              <a:gd name="connsiteX3" fmla="*/ 842 w 519240"/>
              <a:gd name="connsiteY3" fmla="*/ 292481 h 402017"/>
              <a:gd name="connsiteX4" fmla="*/ 65215 w 519240"/>
              <a:gd name="connsiteY4" fmla="*/ 132142 h 402017"/>
              <a:gd name="connsiteX5" fmla="*/ 147542 w 519240"/>
              <a:gd name="connsiteY5" fmla="*/ 10600 h 402017"/>
              <a:gd name="connsiteX6" fmla="*/ 433989 w 519240"/>
              <a:gd name="connsiteY6" fmla="*/ 31759 h 402017"/>
              <a:gd name="connsiteX7" fmla="*/ 260230 w 519240"/>
              <a:gd name="connsiteY7" fmla="*/ 191410 h 402017"/>
              <a:gd name="connsiteX8" fmla="*/ 519240 w 519240"/>
              <a:gd name="connsiteY8" fmla="*/ 186647 h 40201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9318 w 519318"/>
              <a:gd name="connsiteY0" fmla="*/ 186877 h 402247"/>
              <a:gd name="connsiteX1" fmla="*/ 296643 w 519318"/>
              <a:gd name="connsiteY1" fmla="*/ 384973 h 402247"/>
              <a:gd name="connsiteX2" fmla="*/ 103393 w 519318"/>
              <a:gd name="connsiteY2" fmla="*/ 381611 h 402247"/>
              <a:gd name="connsiteX3" fmla="*/ 920 w 519318"/>
              <a:gd name="connsiteY3" fmla="*/ 292711 h 402247"/>
              <a:gd name="connsiteX4" fmla="*/ 82756 w 519318"/>
              <a:gd name="connsiteY4" fmla="*/ 135547 h 402247"/>
              <a:gd name="connsiteX5" fmla="*/ 147620 w 519318"/>
              <a:gd name="connsiteY5" fmla="*/ 10830 h 402247"/>
              <a:gd name="connsiteX6" fmla="*/ 434067 w 519318"/>
              <a:gd name="connsiteY6" fmla="*/ 31989 h 402247"/>
              <a:gd name="connsiteX7" fmla="*/ 260308 w 519318"/>
              <a:gd name="connsiteY7" fmla="*/ 191640 h 402247"/>
              <a:gd name="connsiteX8" fmla="*/ 519318 w 519318"/>
              <a:gd name="connsiteY8" fmla="*/ 186877 h 40224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519318" h="402247">
                <a:moveTo>
                  <a:pt x="519318" y="186877"/>
                </a:moveTo>
                <a:cubicBezTo>
                  <a:pt x="519318" y="285407"/>
                  <a:pt x="365964" y="352517"/>
                  <a:pt x="296643" y="384973"/>
                </a:cubicBezTo>
                <a:cubicBezTo>
                  <a:pt x="227322" y="417429"/>
                  <a:pt x="152680" y="396988"/>
                  <a:pt x="103393" y="381611"/>
                </a:cubicBezTo>
                <a:cubicBezTo>
                  <a:pt x="54106" y="366234"/>
                  <a:pt x="4360" y="333722"/>
                  <a:pt x="920" y="292711"/>
                </a:cubicBezTo>
                <a:cubicBezTo>
                  <a:pt x="-2520" y="251700"/>
                  <a:pt x="-432" y="206339"/>
                  <a:pt x="82756" y="135547"/>
                </a:cubicBezTo>
                <a:cubicBezTo>
                  <a:pt x="54818" y="40942"/>
                  <a:pt x="89068" y="28090"/>
                  <a:pt x="147620" y="10830"/>
                </a:cubicBezTo>
                <a:cubicBezTo>
                  <a:pt x="206172" y="-6430"/>
                  <a:pt x="350237" y="-5582"/>
                  <a:pt x="434067" y="31989"/>
                </a:cubicBezTo>
                <a:lnTo>
                  <a:pt x="260308" y="191640"/>
                </a:lnTo>
                <a:lnTo>
                  <a:pt x="519318" y="186877"/>
                </a:lnTo>
                <a:close/>
              </a:path>
            </a:pathLst>
          </a:cu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>
              <a:solidFill>
                <a:schemeClr val="tx1"/>
              </a:solidFill>
            </a:endParaRPr>
          </a:p>
        </p:txBody>
      </p:sp>
      <p:sp>
        <p:nvSpPr>
          <p:cNvPr id="389" name="Circular 131"/>
          <p:cNvSpPr/>
          <p:nvPr/>
        </p:nvSpPr>
        <p:spPr>
          <a:xfrm rot="2227260">
            <a:off x="5488936" y="4189010"/>
            <a:ext cx="175841" cy="136200"/>
          </a:xfrm>
          <a:custGeom>
            <a:avLst/>
            <a:gdLst>
              <a:gd name="connsiteX0" fmla="*/ 606921 w 606921"/>
              <a:gd name="connsiteY0" fmla="*/ 194734 h 389467"/>
              <a:gd name="connsiteX1" fmla="*/ 339796 w 606921"/>
              <a:gd name="connsiteY1" fmla="*/ 388067 h 389467"/>
              <a:gd name="connsiteX2" fmla="*/ 44073 w 606921"/>
              <a:gd name="connsiteY2" fmla="*/ 295805 h 389467"/>
              <a:gd name="connsiteX3" fmla="*/ 190773 w 606921"/>
              <a:gd name="connsiteY3" fmla="*/ 13924 h 389467"/>
              <a:gd name="connsiteX4" fmla="*/ 477220 w 606921"/>
              <a:gd name="connsiteY4" fmla="*/ 35083 h 389467"/>
              <a:gd name="connsiteX5" fmla="*/ 303461 w 606921"/>
              <a:gd name="connsiteY5" fmla="*/ 194734 h 389467"/>
              <a:gd name="connsiteX6" fmla="*/ 606921 w 606921"/>
              <a:gd name="connsiteY6" fmla="*/ 194734 h 389467"/>
              <a:gd name="connsiteX0" fmla="*/ 563462 w 563462"/>
              <a:gd name="connsiteY0" fmla="*/ 194735 h 404997"/>
              <a:gd name="connsiteX1" fmla="*/ 296337 w 563462"/>
              <a:gd name="connsiteY1" fmla="*/ 388068 h 404997"/>
              <a:gd name="connsiteX2" fmla="*/ 103087 w 563462"/>
              <a:gd name="connsiteY2" fmla="*/ 384706 h 404997"/>
              <a:gd name="connsiteX3" fmla="*/ 614 w 563462"/>
              <a:gd name="connsiteY3" fmla="*/ 295806 h 404997"/>
              <a:gd name="connsiteX4" fmla="*/ 147314 w 563462"/>
              <a:gd name="connsiteY4" fmla="*/ 13925 h 404997"/>
              <a:gd name="connsiteX5" fmla="*/ 433761 w 563462"/>
              <a:gd name="connsiteY5" fmla="*/ 35084 h 404997"/>
              <a:gd name="connsiteX6" fmla="*/ 260002 w 563462"/>
              <a:gd name="connsiteY6" fmla="*/ 194735 h 404997"/>
              <a:gd name="connsiteX7" fmla="*/ 563462 w 563462"/>
              <a:gd name="connsiteY7" fmla="*/ 194735 h 404997"/>
              <a:gd name="connsiteX0" fmla="*/ 519012 w 519012"/>
              <a:gd name="connsiteY0" fmla="*/ 189972 h 405342"/>
              <a:gd name="connsiteX1" fmla="*/ 296337 w 519012"/>
              <a:gd name="connsiteY1" fmla="*/ 388068 h 405342"/>
              <a:gd name="connsiteX2" fmla="*/ 103087 w 519012"/>
              <a:gd name="connsiteY2" fmla="*/ 384706 h 405342"/>
              <a:gd name="connsiteX3" fmla="*/ 614 w 519012"/>
              <a:gd name="connsiteY3" fmla="*/ 295806 h 405342"/>
              <a:gd name="connsiteX4" fmla="*/ 147314 w 519012"/>
              <a:gd name="connsiteY4" fmla="*/ 13925 h 405342"/>
              <a:gd name="connsiteX5" fmla="*/ 433761 w 519012"/>
              <a:gd name="connsiteY5" fmla="*/ 35084 h 405342"/>
              <a:gd name="connsiteX6" fmla="*/ 260002 w 519012"/>
              <a:gd name="connsiteY6" fmla="*/ 194735 h 405342"/>
              <a:gd name="connsiteX7" fmla="*/ 519012 w 519012"/>
              <a:gd name="connsiteY7" fmla="*/ 189972 h 405342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367 w 519367"/>
              <a:gd name="connsiteY0" fmla="*/ 186190 h 401560"/>
              <a:gd name="connsiteX1" fmla="*/ 296692 w 519367"/>
              <a:gd name="connsiteY1" fmla="*/ 384286 h 401560"/>
              <a:gd name="connsiteX2" fmla="*/ 103442 w 519367"/>
              <a:gd name="connsiteY2" fmla="*/ 380924 h 401560"/>
              <a:gd name="connsiteX3" fmla="*/ 969 w 519367"/>
              <a:gd name="connsiteY3" fmla="*/ 292024 h 401560"/>
              <a:gd name="connsiteX4" fmla="*/ 57404 w 519367"/>
              <a:gd name="connsiteY4" fmla="*/ 125335 h 401560"/>
              <a:gd name="connsiteX5" fmla="*/ 147669 w 519367"/>
              <a:gd name="connsiteY5" fmla="*/ 10143 h 401560"/>
              <a:gd name="connsiteX6" fmla="*/ 434116 w 519367"/>
              <a:gd name="connsiteY6" fmla="*/ 31302 h 401560"/>
              <a:gd name="connsiteX7" fmla="*/ 260357 w 519367"/>
              <a:gd name="connsiteY7" fmla="*/ 190953 h 401560"/>
              <a:gd name="connsiteX8" fmla="*/ 519367 w 519367"/>
              <a:gd name="connsiteY8" fmla="*/ 186190 h 401560"/>
              <a:gd name="connsiteX0" fmla="*/ 519830 w 519830"/>
              <a:gd name="connsiteY0" fmla="*/ 186190 h 401560"/>
              <a:gd name="connsiteX1" fmla="*/ 297155 w 519830"/>
              <a:gd name="connsiteY1" fmla="*/ 384286 h 401560"/>
              <a:gd name="connsiteX2" fmla="*/ 103905 w 519830"/>
              <a:gd name="connsiteY2" fmla="*/ 380924 h 401560"/>
              <a:gd name="connsiteX3" fmla="*/ 1432 w 519830"/>
              <a:gd name="connsiteY3" fmla="*/ 292024 h 401560"/>
              <a:gd name="connsiteX4" fmla="*/ 57867 w 519830"/>
              <a:gd name="connsiteY4" fmla="*/ 125335 h 401560"/>
              <a:gd name="connsiteX5" fmla="*/ 148132 w 519830"/>
              <a:gd name="connsiteY5" fmla="*/ 10143 h 401560"/>
              <a:gd name="connsiteX6" fmla="*/ 434579 w 519830"/>
              <a:gd name="connsiteY6" fmla="*/ 31302 h 401560"/>
              <a:gd name="connsiteX7" fmla="*/ 260820 w 519830"/>
              <a:gd name="connsiteY7" fmla="*/ 190953 h 401560"/>
              <a:gd name="connsiteX8" fmla="*/ 519830 w 519830"/>
              <a:gd name="connsiteY8" fmla="*/ 186190 h 401560"/>
              <a:gd name="connsiteX0" fmla="*/ 519240 w 519240"/>
              <a:gd name="connsiteY0" fmla="*/ 186647 h 402017"/>
              <a:gd name="connsiteX1" fmla="*/ 296565 w 519240"/>
              <a:gd name="connsiteY1" fmla="*/ 384743 h 402017"/>
              <a:gd name="connsiteX2" fmla="*/ 103315 w 519240"/>
              <a:gd name="connsiteY2" fmla="*/ 381381 h 402017"/>
              <a:gd name="connsiteX3" fmla="*/ 842 w 519240"/>
              <a:gd name="connsiteY3" fmla="*/ 292481 h 402017"/>
              <a:gd name="connsiteX4" fmla="*/ 65215 w 519240"/>
              <a:gd name="connsiteY4" fmla="*/ 132142 h 402017"/>
              <a:gd name="connsiteX5" fmla="*/ 147542 w 519240"/>
              <a:gd name="connsiteY5" fmla="*/ 10600 h 402017"/>
              <a:gd name="connsiteX6" fmla="*/ 433989 w 519240"/>
              <a:gd name="connsiteY6" fmla="*/ 31759 h 402017"/>
              <a:gd name="connsiteX7" fmla="*/ 260230 w 519240"/>
              <a:gd name="connsiteY7" fmla="*/ 191410 h 402017"/>
              <a:gd name="connsiteX8" fmla="*/ 519240 w 519240"/>
              <a:gd name="connsiteY8" fmla="*/ 186647 h 40201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8584 w 518584"/>
              <a:gd name="connsiteY0" fmla="*/ 186877 h 402247"/>
              <a:gd name="connsiteX1" fmla="*/ 295909 w 518584"/>
              <a:gd name="connsiteY1" fmla="*/ 384973 h 402247"/>
              <a:gd name="connsiteX2" fmla="*/ 102659 w 518584"/>
              <a:gd name="connsiteY2" fmla="*/ 381611 h 402247"/>
              <a:gd name="connsiteX3" fmla="*/ 186 w 518584"/>
              <a:gd name="connsiteY3" fmla="*/ 292711 h 402247"/>
              <a:gd name="connsiteX4" fmla="*/ 82022 w 518584"/>
              <a:gd name="connsiteY4" fmla="*/ 135547 h 402247"/>
              <a:gd name="connsiteX5" fmla="*/ 146886 w 518584"/>
              <a:gd name="connsiteY5" fmla="*/ 10830 h 402247"/>
              <a:gd name="connsiteX6" fmla="*/ 433333 w 518584"/>
              <a:gd name="connsiteY6" fmla="*/ 31989 h 402247"/>
              <a:gd name="connsiteX7" fmla="*/ 259574 w 518584"/>
              <a:gd name="connsiteY7" fmla="*/ 191640 h 402247"/>
              <a:gd name="connsiteX8" fmla="*/ 518584 w 518584"/>
              <a:gd name="connsiteY8" fmla="*/ 186877 h 402247"/>
              <a:gd name="connsiteX0" fmla="*/ 519318 w 519318"/>
              <a:gd name="connsiteY0" fmla="*/ 186877 h 402247"/>
              <a:gd name="connsiteX1" fmla="*/ 296643 w 519318"/>
              <a:gd name="connsiteY1" fmla="*/ 384973 h 402247"/>
              <a:gd name="connsiteX2" fmla="*/ 103393 w 519318"/>
              <a:gd name="connsiteY2" fmla="*/ 381611 h 402247"/>
              <a:gd name="connsiteX3" fmla="*/ 920 w 519318"/>
              <a:gd name="connsiteY3" fmla="*/ 292711 h 402247"/>
              <a:gd name="connsiteX4" fmla="*/ 82756 w 519318"/>
              <a:gd name="connsiteY4" fmla="*/ 135547 h 402247"/>
              <a:gd name="connsiteX5" fmla="*/ 147620 w 519318"/>
              <a:gd name="connsiteY5" fmla="*/ 10830 h 402247"/>
              <a:gd name="connsiteX6" fmla="*/ 434067 w 519318"/>
              <a:gd name="connsiteY6" fmla="*/ 31989 h 402247"/>
              <a:gd name="connsiteX7" fmla="*/ 260308 w 519318"/>
              <a:gd name="connsiteY7" fmla="*/ 191640 h 402247"/>
              <a:gd name="connsiteX8" fmla="*/ 519318 w 519318"/>
              <a:gd name="connsiteY8" fmla="*/ 186877 h 40224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519318" h="402247">
                <a:moveTo>
                  <a:pt x="519318" y="186877"/>
                </a:moveTo>
                <a:cubicBezTo>
                  <a:pt x="519318" y="285407"/>
                  <a:pt x="365964" y="352517"/>
                  <a:pt x="296643" y="384973"/>
                </a:cubicBezTo>
                <a:cubicBezTo>
                  <a:pt x="227322" y="417429"/>
                  <a:pt x="152680" y="396988"/>
                  <a:pt x="103393" y="381611"/>
                </a:cubicBezTo>
                <a:cubicBezTo>
                  <a:pt x="54106" y="366234"/>
                  <a:pt x="4360" y="333722"/>
                  <a:pt x="920" y="292711"/>
                </a:cubicBezTo>
                <a:cubicBezTo>
                  <a:pt x="-2520" y="251700"/>
                  <a:pt x="-432" y="206339"/>
                  <a:pt x="82756" y="135547"/>
                </a:cubicBezTo>
                <a:cubicBezTo>
                  <a:pt x="54818" y="40942"/>
                  <a:pt x="89068" y="28090"/>
                  <a:pt x="147620" y="10830"/>
                </a:cubicBezTo>
                <a:cubicBezTo>
                  <a:pt x="206172" y="-6430"/>
                  <a:pt x="350237" y="-5582"/>
                  <a:pt x="434067" y="31989"/>
                </a:cubicBezTo>
                <a:lnTo>
                  <a:pt x="260308" y="191640"/>
                </a:lnTo>
                <a:lnTo>
                  <a:pt x="519318" y="186877"/>
                </a:lnTo>
                <a:close/>
              </a:path>
            </a:pathLst>
          </a:cu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>
              <a:solidFill>
                <a:schemeClr val="tx1"/>
              </a:solidFill>
            </a:endParaRPr>
          </a:p>
        </p:txBody>
      </p:sp>
      <p:grpSp>
        <p:nvGrpSpPr>
          <p:cNvPr id="390" name="Grupo 389"/>
          <p:cNvGrpSpPr/>
          <p:nvPr/>
        </p:nvGrpSpPr>
        <p:grpSpPr>
          <a:xfrm rot="20040000" flipH="1" flipV="1">
            <a:off x="5990961" y="4134559"/>
            <a:ext cx="62100" cy="106542"/>
            <a:chOff x="4953375" y="7221921"/>
            <a:chExt cx="82800" cy="142056"/>
          </a:xfrm>
        </p:grpSpPr>
        <p:sp>
          <p:nvSpPr>
            <p:cNvPr id="391" name="Rectángulo 390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392" name="Conector recto 391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93" name="Grupo 392"/>
          <p:cNvGrpSpPr/>
          <p:nvPr/>
        </p:nvGrpSpPr>
        <p:grpSpPr>
          <a:xfrm rot="20400000" flipH="1">
            <a:off x="5725762" y="4783605"/>
            <a:ext cx="189000" cy="130469"/>
            <a:chOff x="4079020" y="6879809"/>
            <a:chExt cx="252000" cy="173958"/>
          </a:xfrm>
        </p:grpSpPr>
        <p:sp>
          <p:nvSpPr>
            <p:cNvPr id="394" name="Forma libre 393"/>
            <p:cNvSpPr/>
            <p:nvPr/>
          </p:nvSpPr>
          <p:spPr>
            <a:xfrm rot="21480000" flipV="1">
              <a:off x="4080439" y="6908435"/>
              <a:ext cx="249698" cy="145332"/>
            </a:xfrm>
            <a:custGeom>
              <a:avLst/>
              <a:gdLst>
                <a:gd name="connsiteX0" fmla="*/ 101600 w 485775"/>
                <a:gd name="connsiteY0" fmla="*/ 79375 h 177800"/>
                <a:gd name="connsiteX1" fmla="*/ 485775 w 485775"/>
                <a:gd name="connsiteY1" fmla="*/ 76200 h 177800"/>
                <a:gd name="connsiteX2" fmla="*/ 482600 w 485775"/>
                <a:gd name="connsiteY2" fmla="*/ 174625 h 177800"/>
                <a:gd name="connsiteX3" fmla="*/ 0 w 485775"/>
                <a:gd name="connsiteY3" fmla="*/ 177800 h 177800"/>
                <a:gd name="connsiteX4" fmla="*/ 82550 w 485775"/>
                <a:gd name="connsiteY4" fmla="*/ 0 h 177800"/>
                <a:gd name="connsiteX5" fmla="*/ 101600 w 485775"/>
                <a:gd name="connsiteY5" fmla="*/ 79375 h 177800"/>
                <a:gd name="connsiteX0" fmla="*/ 196850 w 581025"/>
                <a:gd name="connsiteY0" fmla="*/ 79375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96850 w 581025"/>
                <a:gd name="connsiteY5" fmla="*/ 79375 h 187325"/>
                <a:gd name="connsiteX0" fmla="*/ 177800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77800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263089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63089 w 581025"/>
                <a:gd name="connsiteY5" fmla="*/ 82550 h 187325"/>
                <a:gd name="connsiteX0" fmla="*/ 289741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89741 w 581025"/>
                <a:gd name="connsiteY5" fmla="*/ 82550 h 187325"/>
                <a:gd name="connsiteX0" fmla="*/ 289741 w 581025"/>
                <a:gd name="connsiteY0" fmla="*/ 91494 h 196269"/>
                <a:gd name="connsiteX1" fmla="*/ 581025 w 581025"/>
                <a:gd name="connsiteY1" fmla="*/ 85144 h 196269"/>
                <a:gd name="connsiteX2" fmla="*/ 577850 w 581025"/>
                <a:gd name="connsiteY2" fmla="*/ 183569 h 196269"/>
                <a:gd name="connsiteX3" fmla="*/ 0 w 581025"/>
                <a:gd name="connsiteY3" fmla="*/ 196269 h 196269"/>
                <a:gd name="connsiteX4" fmla="*/ 295072 w 581025"/>
                <a:gd name="connsiteY4" fmla="*/ 0 h 196269"/>
                <a:gd name="connsiteX5" fmla="*/ 289741 w 581025"/>
                <a:gd name="connsiteY5" fmla="*/ 91494 h 1962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81025" h="196269">
                  <a:moveTo>
                    <a:pt x="289741" y="91494"/>
                  </a:moveTo>
                  <a:lnTo>
                    <a:pt x="581025" y="85144"/>
                  </a:lnTo>
                  <a:lnTo>
                    <a:pt x="577850" y="183569"/>
                  </a:lnTo>
                  <a:lnTo>
                    <a:pt x="0" y="196269"/>
                  </a:lnTo>
                  <a:lnTo>
                    <a:pt x="295072" y="0"/>
                  </a:lnTo>
                  <a:lnTo>
                    <a:pt x="289741" y="91494"/>
                  </a:lnTo>
                  <a:close/>
                </a:path>
              </a:pathLst>
            </a:custGeom>
            <a:solidFill>
              <a:srgbClr val="92D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395" name="Conector recto 394"/>
            <p:cNvCxnSpPr/>
            <p:nvPr/>
          </p:nvCxnSpPr>
          <p:spPr>
            <a:xfrm rot="-60000">
              <a:off x="4079020" y="6879809"/>
              <a:ext cx="252000" cy="8255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96" name="Grupo 395"/>
          <p:cNvGrpSpPr/>
          <p:nvPr/>
        </p:nvGrpSpPr>
        <p:grpSpPr>
          <a:xfrm rot="1140000">
            <a:off x="5629849" y="4385119"/>
            <a:ext cx="189000" cy="130469"/>
            <a:chOff x="4079020" y="6879809"/>
            <a:chExt cx="252000" cy="173958"/>
          </a:xfrm>
        </p:grpSpPr>
        <p:sp>
          <p:nvSpPr>
            <p:cNvPr id="397" name="Forma libre 396"/>
            <p:cNvSpPr/>
            <p:nvPr/>
          </p:nvSpPr>
          <p:spPr>
            <a:xfrm rot="21480000" flipV="1">
              <a:off x="4080439" y="6908435"/>
              <a:ext cx="249698" cy="145332"/>
            </a:xfrm>
            <a:custGeom>
              <a:avLst/>
              <a:gdLst>
                <a:gd name="connsiteX0" fmla="*/ 101600 w 485775"/>
                <a:gd name="connsiteY0" fmla="*/ 79375 h 177800"/>
                <a:gd name="connsiteX1" fmla="*/ 485775 w 485775"/>
                <a:gd name="connsiteY1" fmla="*/ 76200 h 177800"/>
                <a:gd name="connsiteX2" fmla="*/ 482600 w 485775"/>
                <a:gd name="connsiteY2" fmla="*/ 174625 h 177800"/>
                <a:gd name="connsiteX3" fmla="*/ 0 w 485775"/>
                <a:gd name="connsiteY3" fmla="*/ 177800 h 177800"/>
                <a:gd name="connsiteX4" fmla="*/ 82550 w 485775"/>
                <a:gd name="connsiteY4" fmla="*/ 0 h 177800"/>
                <a:gd name="connsiteX5" fmla="*/ 101600 w 485775"/>
                <a:gd name="connsiteY5" fmla="*/ 79375 h 177800"/>
                <a:gd name="connsiteX0" fmla="*/ 196850 w 581025"/>
                <a:gd name="connsiteY0" fmla="*/ 79375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96850 w 581025"/>
                <a:gd name="connsiteY5" fmla="*/ 79375 h 187325"/>
                <a:gd name="connsiteX0" fmla="*/ 177800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177800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177800 w 581025"/>
                <a:gd name="connsiteY4" fmla="*/ 0 h 187325"/>
                <a:gd name="connsiteX5" fmla="*/ 263089 w 581025"/>
                <a:gd name="connsiteY5" fmla="*/ 82550 h 187325"/>
                <a:gd name="connsiteX0" fmla="*/ 263089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63089 w 581025"/>
                <a:gd name="connsiteY5" fmla="*/ 82550 h 187325"/>
                <a:gd name="connsiteX0" fmla="*/ 289741 w 581025"/>
                <a:gd name="connsiteY0" fmla="*/ 82550 h 187325"/>
                <a:gd name="connsiteX1" fmla="*/ 581025 w 581025"/>
                <a:gd name="connsiteY1" fmla="*/ 76200 h 187325"/>
                <a:gd name="connsiteX2" fmla="*/ 577850 w 581025"/>
                <a:gd name="connsiteY2" fmla="*/ 174625 h 187325"/>
                <a:gd name="connsiteX3" fmla="*/ 0 w 581025"/>
                <a:gd name="connsiteY3" fmla="*/ 187325 h 187325"/>
                <a:gd name="connsiteX4" fmla="*/ 241767 w 581025"/>
                <a:gd name="connsiteY4" fmla="*/ 0 h 187325"/>
                <a:gd name="connsiteX5" fmla="*/ 289741 w 581025"/>
                <a:gd name="connsiteY5" fmla="*/ 82550 h 187325"/>
                <a:gd name="connsiteX0" fmla="*/ 289741 w 581025"/>
                <a:gd name="connsiteY0" fmla="*/ 91494 h 196269"/>
                <a:gd name="connsiteX1" fmla="*/ 581025 w 581025"/>
                <a:gd name="connsiteY1" fmla="*/ 85144 h 196269"/>
                <a:gd name="connsiteX2" fmla="*/ 577850 w 581025"/>
                <a:gd name="connsiteY2" fmla="*/ 183569 h 196269"/>
                <a:gd name="connsiteX3" fmla="*/ 0 w 581025"/>
                <a:gd name="connsiteY3" fmla="*/ 196269 h 196269"/>
                <a:gd name="connsiteX4" fmla="*/ 295072 w 581025"/>
                <a:gd name="connsiteY4" fmla="*/ 0 h 196269"/>
                <a:gd name="connsiteX5" fmla="*/ 289741 w 581025"/>
                <a:gd name="connsiteY5" fmla="*/ 91494 h 1962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81025" h="196269">
                  <a:moveTo>
                    <a:pt x="289741" y="91494"/>
                  </a:moveTo>
                  <a:lnTo>
                    <a:pt x="581025" y="85144"/>
                  </a:lnTo>
                  <a:lnTo>
                    <a:pt x="577850" y="183569"/>
                  </a:lnTo>
                  <a:lnTo>
                    <a:pt x="0" y="196269"/>
                  </a:lnTo>
                  <a:lnTo>
                    <a:pt x="295072" y="0"/>
                  </a:lnTo>
                  <a:lnTo>
                    <a:pt x="289741" y="91494"/>
                  </a:lnTo>
                  <a:close/>
                </a:path>
              </a:pathLst>
            </a:custGeom>
            <a:solidFill>
              <a:srgbClr val="92D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398" name="Conector recto 397"/>
            <p:cNvCxnSpPr/>
            <p:nvPr/>
          </p:nvCxnSpPr>
          <p:spPr>
            <a:xfrm rot="-60000">
              <a:off x="4079020" y="6879809"/>
              <a:ext cx="252000" cy="8255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99" name="Grupo 398"/>
          <p:cNvGrpSpPr/>
          <p:nvPr/>
        </p:nvGrpSpPr>
        <p:grpSpPr>
          <a:xfrm rot="20040000">
            <a:off x="5658712" y="3668557"/>
            <a:ext cx="62100" cy="106542"/>
            <a:chOff x="4953375" y="7221921"/>
            <a:chExt cx="82800" cy="142056"/>
          </a:xfrm>
        </p:grpSpPr>
        <p:sp>
          <p:nvSpPr>
            <p:cNvPr id="400" name="Rectángulo 399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401" name="Conector recto 400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02" name="Grupo 401"/>
          <p:cNvGrpSpPr/>
          <p:nvPr/>
        </p:nvGrpSpPr>
        <p:grpSpPr>
          <a:xfrm rot="1560000" flipV="1">
            <a:off x="5555350" y="4818214"/>
            <a:ext cx="62100" cy="106542"/>
            <a:chOff x="4953375" y="7221921"/>
            <a:chExt cx="82800" cy="142056"/>
          </a:xfrm>
        </p:grpSpPr>
        <p:sp>
          <p:nvSpPr>
            <p:cNvPr id="403" name="Rectángulo 402"/>
            <p:cNvSpPr/>
            <p:nvPr/>
          </p:nvSpPr>
          <p:spPr>
            <a:xfrm>
              <a:off x="4960250" y="7221921"/>
              <a:ext cx="72000" cy="107819"/>
            </a:xfrm>
            <a:prstGeom prst="rect">
              <a:avLst/>
            </a:prstGeom>
            <a:solidFill>
              <a:srgbClr val="800080"/>
            </a:solidFill>
            <a:ln>
              <a:solidFill>
                <a:srgbClr val="800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404" name="Conector recto 403"/>
            <p:cNvCxnSpPr/>
            <p:nvPr/>
          </p:nvCxnSpPr>
          <p:spPr>
            <a:xfrm flipV="1">
              <a:off x="4953375" y="7358897"/>
              <a:ext cx="82800" cy="5080"/>
            </a:xfrm>
            <a:prstGeom prst="line">
              <a:avLst/>
            </a:prstGeom>
            <a:ln w="57150">
              <a:solidFill>
                <a:srgbClr val="00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7" name="Conector recto de flecha 16"/>
          <p:cNvCxnSpPr/>
          <p:nvPr/>
        </p:nvCxnSpPr>
        <p:spPr>
          <a:xfrm flipH="1">
            <a:off x="7080024" y="3724440"/>
            <a:ext cx="126200" cy="3810"/>
          </a:xfrm>
          <a:prstGeom prst="straightConnector1">
            <a:avLst/>
          </a:prstGeom>
          <a:ln w="28575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5" name="Conector recto de flecha 404"/>
          <p:cNvCxnSpPr/>
          <p:nvPr/>
        </p:nvCxnSpPr>
        <p:spPr>
          <a:xfrm>
            <a:off x="7850287" y="4816768"/>
            <a:ext cx="126200" cy="3810"/>
          </a:xfrm>
          <a:prstGeom prst="straightConnector1">
            <a:avLst/>
          </a:prstGeom>
          <a:ln w="28575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6" name="CuadroTexto 405"/>
          <p:cNvSpPr txBox="1"/>
          <p:nvPr/>
        </p:nvSpPr>
        <p:spPr>
          <a:xfrm>
            <a:off x="4557294" y="5150032"/>
            <a:ext cx="396330" cy="19492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>
              <a:lnSpc>
                <a:spcPts val="750"/>
              </a:lnSpc>
            </a:pPr>
            <a:r>
              <a:rPr lang="es-CO" sz="675" b="1" dirty="0" err="1">
                <a:latin typeface="Arial" panose="020B0604020202020204" pitchFamily="34" charset="0"/>
                <a:cs typeface="Arial" panose="020B0604020202020204" pitchFamily="34" charset="0"/>
              </a:rPr>
              <a:t>Start</a:t>
            </a:r>
            <a:endParaRPr lang="en-US" sz="67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tángulo 5"/>
          <p:cNvSpPr/>
          <p:nvPr/>
        </p:nvSpPr>
        <p:spPr>
          <a:xfrm>
            <a:off x="2751009" y="845917"/>
            <a:ext cx="69179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400"/>
              </a:spcAft>
            </a:pPr>
            <a:r>
              <a:rPr lang="en-US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Figure S1. PCR process</a:t>
            </a:r>
            <a:r>
              <a:rPr lang="en-US" b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r>
              <a:rPr lang="en-US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Scheme 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of the amplification processes</a:t>
            </a:r>
          </a:p>
        </p:txBody>
      </p:sp>
    </p:spTree>
    <p:extLst>
      <p:ext uri="{BB962C8B-B14F-4D97-AF65-F5344CB8AC3E}">
        <p14:creationId xmlns:p14="http://schemas.microsoft.com/office/powerpoint/2010/main" val="11201022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50</Words>
  <Application>Microsoft Office PowerPoint</Application>
  <PresentationFormat>Panorámica</PresentationFormat>
  <Paragraphs>18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aime E. Castellanos</dc:creator>
  <cp:lastModifiedBy>Jaime E. Castellanos</cp:lastModifiedBy>
  <cp:revision>4</cp:revision>
  <dcterms:created xsi:type="dcterms:W3CDTF">2023-12-24T00:47:39Z</dcterms:created>
  <dcterms:modified xsi:type="dcterms:W3CDTF">2024-01-11T22:30:26Z</dcterms:modified>
</cp:coreProperties>
</file>